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theme/theme2.xml" ContentType="application/vnd.openxmlformats-officedocument.theme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9144000" cy="6400800"/>
  <p:notesSz cx="6400800" cy="9144000"/>
  <p:defaultTextStyle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4610"/>
  </p:normalViewPr>
  <p:slideViewPr>
    <p:cSldViewPr snapToGrid="0" snapToObjects="1">
      <p:cViewPr varScale="1">
        <p:scale>
          <a:sx n="88" d="100"/>
          <a:sy n="88" d="100"/>
        </p:scale>
        <p:origin x="130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ingsley Bentum" userId="8021297c-c9ca-4da8-8c05-dc032d301335" providerId="ADAL" clId="{0BBA22AF-9666-4C65-81B6-357BE92E7D77}"/>
    <pc:docChg chg="modSld">
      <pc:chgData name="Kingsley Bentum" userId="8021297c-c9ca-4da8-8c05-dc032d301335" providerId="ADAL" clId="{0BBA22AF-9666-4C65-81B6-357BE92E7D77}" dt="2026-02-10T03:44:03.037" v="21" actId="20577"/>
      <pc:docMkLst>
        <pc:docMk/>
      </pc:docMkLst>
      <pc:sldChg chg="modSp mod">
        <pc:chgData name="Kingsley Bentum" userId="8021297c-c9ca-4da8-8c05-dc032d301335" providerId="ADAL" clId="{0BBA22AF-9666-4C65-81B6-357BE92E7D77}" dt="2026-02-10T03:44:03.037" v="21" actId="20577"/>
        <pc:sldMkLst>
          <pc:docMk/>
          <pc:sldMk cId="0" sldId="256"/>
        </pc:sldMkLst>
        <pc:spChg chg="mod">
          <ac:chgData name="Kingsley Bentum" userId="8021297c-c9ca-4da8-8c05-dc032d301335" providerId="ADAL" clId="{0BBA22AF-9666-4C65-81B6-357BE92E7D77}" dt="2026-02-10T03:44:03.037" v="21" actId="20577"/>
          <ac:spMkLst>
            <pc:docMk/>
            <pc:sldMk cId="0" sldId="256"/>
            <ac:spMk id="56" creationId="{00000000-0000-0000-0000-000000000000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7528758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021451-1387-4CA6-816F-3879F97B5CBC}" type="slidenum">
              <a:rPr lang="en-US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0869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DEFAULT"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</p:sldLayoutIdLst>
  <p:hf sldNum="0"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tags" Target="../tags/tag13.xml"/><Relationship Id="rId18" Type="http://schemas.openxmlformats.org/officeDocument/2006/relationships/tags" Target="../tags/tag18.xml"/><Relationship Id="rId26" Type="http://schemas.openxmlformats.org/officeDocument/2006/relationships/tags" Target="../tags/tag26.xml"/><Relationship Id="rId39" Type="http://schemas.openxmlformats.org/officeDocument/2006/relationships/image" Target="../media/image1.png"/><Relationship Id="rId21" Type="http://schemas.openxmlformats.org/officeDocument/2006/relationships/tags" Target="../tags/tag21.xml"/><Relationship Id="rId34" Type="http://schemas.openxmlformats.org/officeDocument/2006/relationships/tags" Target="../tags/tag34.xml"/><Relationship Id="rId42" Type="http://schemas.openxmlformats.org/officeDocument/2006/relationships/image" Target="../media/image4.png"/><Relationship Id="rId7" Type="http://schemas.openxmlformats.org/officeDocument/2006/relationships/tags" Target="../tags/tag7.xml"/><Relationship Id="rId2" Type="http://schemas.openxmlformats.org/officeDocument/2006/relationships/tags" Target="../tags/tag2.xml"/><Relationship Id="rId16" Type="http://schemas.openxmlformats.org/officeDocument/2006/relationships/tags" Target="../tags/tag16.xml"/><Relationship Id="rId20" Type="http://schemas.openxmlformats.org/officeDocument/2006/relationships/tags" Target="../tags/tag20.xml"/><Relationship Id="rId29" Type="http://schemas.openxmlformats.org/officeDocument/2006/relationships/tags" Target="../tags/tag29.xml"/><Relationship Id="rId41" Type="http://schemas.openxmlformats.org/officeDocument/2006/relationships/image" Target="../media/image3.png"/><Relationship Id="rId1" Type="http://schemas.openxmlformats.org/officeDocument/2006/relationships/tags" Target="../tags/tag1.xml"/><Relationship Id="rId6" Type="http://schemas.openxmlformats.org/officeDocument/2006/relationships/tags" Target="../tags/tag6.xml"/><Relationship Id="rId11" Type="http://schemas.openxmlformats.org/officeDocument/2006/relationships/tags" Target="../tags/tag11.xml"/><Relationship Id="rId24" Type="http://schemas.openxmlformats.org/officeDocument/2006/relationships/tags" Target="../tags/tag24.xml"/><Relationship Id="rId32" Type="http://schemas.openxmlformats.org/officeDocument/2006/relationships/tags" Target="../tags/tag32.xml"/><Relationship Id="rId37" Type="http://schemas.openxmlformats.org/officeDocument/2006/relationships/slideLayout" Target="../slideLayouts/slideLayout1.xml"/><Relationship Id="rId40" Type="http://schemas.openxmlformats.org/officeDocument/2006/relationships/image" Target="../media/image2.png"/><Relationship Id="rId5" Type="http://schemas.openxmlformats.org/officeDocument/2006/relationships/tags" Target="../tags/tag5.xml"/><Relationship Id="rId15" Type="http://schemas.openxmlformats.org/officeDocument/2006/relationships/tags" Target="../tags/tag15.xml"/><Relationship Id="rId23" Type="http://schemas.openxmlformats.org/officeDocument/2006/relationships/tags" Target="../tags/tag23.xml"/><Relationship Id="rId28" Type="http://schemas.openxmlformats.org/officeDocument/2006/relationships/tags" Target="../tags/tag28.xml"/><Relationship Id="rId36" Type="http://schemas.openxmlformats.org/officeDocument/2006/relationships/tags" Target="../tags/tag36.xml"/><Relationship Id="rId10" Type="http://schemas.openxmlformats.org/officeDocument/2006/relationships/tags" Target="../tags/tag10.xml"/><Relationship Id="rId19" Type="http://schemas.openxmlformats.org/officeDocument/2006/relationships/tags" Target="../tags/tag19.xml"/><Relationship Id="rId31" Type="http://schemas.openxmlformats.org/officeDocument/2006/relationships/tags" Target="../tags/tag31.xml"/><Relationship Id="rId4" Type="http://schemas.openxmlformats.org/officeDocument/2006/relationships/tags" Target="../tags/tag4.xml"/><Relationship Id="rId9" Type="http://schemas.openxmlformats.org/officeDocument/2006/relationships/tags" Target="../tags/tag9.xml"/><Relationship Id="rId14" Type="http://schemas.openxmlformats.org/officeDocument/2006/relationships/tags" Target="../tags/tag14.xml"/><Relationship Id="rId22" Type="http://schemas.openxmlformats.org/officeDocument/2006/relationships/tags" Target="../tags/tag22.xml"/><Relationship Id="rId27" Type="http://schemas.openxmlformats.org/officeDocument/2006/relationships/tags" Target="../tags/tag27.xml"/><Relationship Id="rId30" Type="http://schemas.openxmlformats.org/officeDocument/2006/relationships/tags" Target="../tags/tag30.xml"/><Relationship Id="rId35" Type="http://schemas.openxmlformats.org/officeDocument/2006/relationships/tags" Target="../tags/tag35.xml"/><Relationship Id="rId43" Type="http://schemas.openxmlformats.org/officeDocument/2006/relationships/image" Target="../media/image5.png"/><Relationship Id="rId8" Type="http://schemas.openxmlformats.org/officeDocument/2006/relationships/tags" Target="../tags/tag8.xml"/><Relationship Id="rId3" Type="http://schemas.openxmlformats.org/officeDocument/2006/relationships/tags" Target="../tags/tag3.xml"/><Relationship Id="rId12" Type="http://schemas.openxmlformats.org/officeDocument/2006/relationships/tags" Target="../tags/tag12.xml"/><Relationship Id="rId17" Type="http://schemas.openxmlformats.org/officeDocument/2006/relationships/tags" Target="../tags/tag17.xml"/><Relationship Id="rId25" Type="http://schemas.openxmlformats.org/officeDocument/2006/relationships/tags" Target="../tags/tag25.xml"/><Relationship Id="rId33" Type="http://schemas.openxmlformats.org/officeDocument/2006/relationships/tags" Target="../tags/tag33.xml"/><Relationship Id="rId38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 1"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0" descr="preencoded.png"/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39"/>
          <a:stretch>
            <a:fillRect/>
          </a:stretch>
        </p:blipFill>
        <p:spPr>
          <a:xfrm>
            <a:off x="268680" y="2395764"/>
            <a:ext cx="338328" cy="1511808"/>
          </a:xfrm>
          <a:prstGeom prst="rect">
            <a:avLst/>
          </a:prstGeom>
        </p:spPr>
      </p:pic>
      <p:pic>
        <p:nvPicPr>
          <p:cNvPr id="3" name="Image 1" descr="preencoded.png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39"/>
          <a:stretch>
            <a:fillRect/>
          </a:stretch>
        </p:blipFill>
        <p:spPr>
          <a:xfrm>
            <a:off x="818890" y="2395764"/>
            <a:ext cx="338328" cy="1511808"/>
          </a:xfrm>
          <a:prstGeom prst="rect">
            <a:avLst/>
          </a:prstGeom>
        </p:spPr>
      </p:pic>
      <p:pic>
        <p:nvPicPr>
          <p:cNvPr id="4" name="Image 2" descr="preencoded.png"/>
          <p:cNvPicPr>
            <a:picLocks noChangeAspect="1"/>
          </p:cNvPicPr>
          <p:nvPr>
            <p:custDataLst>
              <p:tags r:id="rId4"/>
            </p:custDataLst>
          </p:nvPr>
        </p:nvPicPr>
        <p:blipFill>
          <a:blip r:embed="rId40"/>
          <a:stretch>
            <a:fillRect/>
          </a:stretch>
        </p:blipFill>
        <p:spPr>
          <a:xfrm>
            <a:off x="1369100" y="2395764"/>
            <a:ext cx="338328" cy="1511808"/>
          </a:xfrm>
          <a:prstGeom prst="rect">
            <a:avLst/>
          </a:prstGeom>
        </p:spPr>
      </p:pic>
      <p:pic>
        <p:nvPicPr>
          <p:cNvPr id="5" name="Image 3" descr="preencoded.png"/>
          <p:cNvPicPr>
            <a:picLocks noChangeAspect="1"/>
          </p:cNvPicPr>
          <p:nvPr>
            <p:custDataLst>
              <p:tags r:id="rId5"/>
            </p:custDataLst>
          </p:nvPr>
        </p:nvPicPr>
        <p:blipFill>
          <a:blip r:embed="rId39"/>
          <a:stretch>
            <a:fillRect/>
          </a:stretch>
        </p:blipFill>
        <p:spPr>
          <a:xfrm>
            <a:off x="1919311" y="2395764"/>
            <a:ext cx="338328" cy="1511808"/>
          </a:xfrm>
          <a:prstGeom prst="rect">
            <a:avLst/>
          </a:prstGeom>
        </p:spPr>
      </p:pic>
      <p:pic>
        <p:nvPicPr>
          <p:cNvPr id="6" name="Image 4" descr="preencoded.png"/>
          <p:cNvPicPr>
            <a:picLocks noChangeAspect="1"/>
          </p:cNvPicPr>
          <p:nvPr>
            <p:custDataLst>
              <p:tags r:id="rId6"/>
            </p:custDataLst>
          </p:nvPr>
        </p:nvPicPr>
        <p:blipFill>
          <a:blip r:embed="rId39"/>
          <a:stretch>
            <a:fillRect/>
          </a:stretch>
        </p:blipFill>
        <p:spPr>
          <a:xfrm>
            <a:off x="2469521" y="2395764"/>
            <a:ext cx="338328" cy="1511808"/>
          </a:xfrm>
          <a:prstGeom prst="rect">
            <a:avLst/>
          </a:prstGeom>
        </p:spPr>
      </p:pic>
      <p:pic>
        <p:nvPicPr>
          <p:cNvPr id="7" name="Image 5" descr="preencoded.png"/>
          <p:cNvPicPr>
            <a:picLocks noChangeAspect="1"/>
          </p:cNvPicPr>
          <p:nvPr>
            <p:custDataLst>
              <p:tags r:id="rId7"/>
            </p:custDataLst>
          </p:nvPr>
        </p:nvPicPr>
        <p:blipFill>
          <a:blip r:embed="rId39"/>
          <a:stretch>
            <a:fillRect/>
          </a:stretch>
        </p:blipFill>
        <p:spPr>
          <a:xfrm>
            <a:off x="3019731" y="2395764"/>
            <a:ext cx="338328" cy="1511808"/>
          </a:xfrm>
          <a:prstGeom prst="rect">
            <a:avLst/>
          </a:prstGeom>
        </p:spPr>
      </p:pic>
      <p:pic>
        <p:nvPicPr>
          <p:cNvPr id="8" name="Image 6" descr="preencoded.png"/>
          <p:cNvPicPr>
            <a:picLocks noChangeAspect="1"/>
          </p:cNvPicPr>
          <p:nvPr>
            <p:custDataLst>
              <p:tags r:id="rId8"/>
            </p:custDataLst>
          </p:nvPr>
        </p:nvPicPr>
        <p:blipFill>
          <a:blip r:embed="rId41"/>
          <a:stretch>
            <a:fillRect/>
          </a:stretch>
        </p:blipFill>
        <p:spPr>
          <a:xfrm>
            <a:off x="3569941" y="2395764"/>
            <a:ext cx="338328" cy="1511808"/>
          </a:xfrm>
          <a:prstGeom prst="rect">
            <a:avLst/>
          </a:prstGeom>
        </p:spPr>
      </p:pic>
      <p:pic>
        <p:nvPicPr>
          <p:cNvPr id="9" name="Image 7" descr="preencoded.png"/>
          <p:cNvPicPr>
            <a:picLocks noChangeAspect="1"/>
          </p:cNvPicPr>
          <p:nvPr>
            <p:custDataLst>
              <p:tags r:id="rId9"/>
            </p:custDataLst>
          </p:nvPr>
        </p:nvPicPr>
        <p:blipFill>
          <a:blip r:embed="rId39"/>
          <a:stretch>
            <a:fillRect/>
          </a:stretch>
        </p:blipFill>
        <p:spPr>
          <a:xfrm>
            <a:off x="4120152" y="2395764"/>
            <a:ext cx="338328" cy="1511808"/>
          </a:xfrm>
          <a:prstGeom prst="rect">
            <a:avLst/>
          </a:prstGeom>
        </p:spPr>
      </p:pic>
      <p:pic>
        <p:nvPicPr>
          <p:cNvPr id="10" name="Image 8" descr="preencoded.png"/>
          <p:cNvPicPr>
            <a:picLocks noChangeAspect="1"/>
          </p:cNvPicPr>
          <p:nvPr>
            <p:custDataLst>
              <p:tags r:id="rId10"/>
            </p:custDataLst>
          </p:nvPr>
        </p:nvPicPr>
        <p:blipFill>
          <a:blip r:embed="rId39"/>
          <a:stretch>
            <a:fillRect/>
          </a:stretch>
        </p:blipFill>
        <p:spPr>
          <a:xfrm>
            <a:off x="4670362" y="2395764"/>
            <a:ext cx="338328" cy="1511808"/>
          </a:xfrm>
          <a:prstGeom prst="rect">
            <a:avLst/>
          </a:prstGeom>
        </p:spPr>
      </p:pic>
      <p:pic>
        <p:nvPicPr>
          <p:cNvPr id="11" name="Image 9" descr="preencoded.png"/>
          <p:cNvPicPr>
            <a:picLocks noChangeAspect="1"/>
          </p:cNvPicPr>
          <p:nvPr>
            <p:custDataLst>
              <p:tags r:id="rId11"/>
            </p:custDataLst>
          </p:nvPr>
        </p:nvPicPr>
        <p:blipFill>
          <a:blip r:embed="rId39"/>
          <a:stretch>
            <a:fillRect/>
          </a:stretch>
        </p:blipFill>
        <p:spPr>
          <a:xfrm>
            <a:off x="5220572" y="2395764"/>
            <a:ext cx="338328" cy="1511808"/>
          </a:xfrm>
          <a:prstGeom prst="rect">
            <a:avLst/>
          </a:prstGeom>
        </p:spPr>
      </p:pic>
      <p:pic>
        <p:nvPicPr>
          <p:cNvPr id="12" name="Image 10" descr="preencoded.png"/>
          <p:cNvPicPr>
            <a:picLocks noChangeAspect="1"/>
          </p:cNvPicPr>
          <p:nvPr>
            <p:custDataLst>
              <p:tags r:id="rId12"/>
            </p:custDataLst>
          </p:nvPr>
        </p:nvPicPr>
        <p:blipFill>
          <a:blip r:embed="rId39"/>
          <a:stretch>
            <a:fillRect/>
          </a:stretch>
        </p:blipFill>
        <p:spPr>
          <a:xfrm>
            <a:off x="5770783" y="2395764"/>
            <a:ext cx="338328" cy="1511808"/>
          </a:xfrm>
          <a:prstGeom prst="rect">
            <a:avLst/>
          </a:prstGeom>
        </p:spPr>
      </p:pic>
      <p:pic>
        <p:nvPicPr>
          <p:cNvPr id="13" name="Image 11" descr="preencoded.png"/>
          <p:cNvPicPr>
            <a:picLocks noChangeAspect="1"/>
          </p:cNvPicPr>
          <p:nvPr>
            <p:custDataLst>
              <p:tags r:id="rId13"/>
            </p:custDataLst>
          </p:nvPr>
        </p:nvPicPr>
        <p:blipFill>
          <a:blip r:embed="rId39"/>
          <a:stretch>
            <a:fillRect/>
          </a:stretch>
        </p:blipFill>
        <p:spPr>
          <a:xfrm>
            <a:off x="6320993" y="2395764"/>
            <a:ext cx="338328" cy="1511808"/>
          </a:xfrm>
          <a:prstGeom prst="rect">
            <a:avLst/>
          </a:prstGeom>
        </p:spPr>
      </p:pic>
      <p:pic>
        <p:nvPicPr>
          <p:cNvPr id="14" name="Image 12" descr="preencoded.png"/>
          <p:cNvPicPr>
            <a:picLocks noChangeAspect="1"/>
          </p:cNvPicPr>
          <p:nvPr>
            <p:custDataLst>
              <p:tags r:id="rId14"/>
            </p:custDataLst>
          </p:nvPr>
        </p:nvPicPr>
        <p:blipFill>
          <a:blip r:embed="rId39"/>
          <a:stretch>
            <a:fillRect/>
          </a:stretch>
        </p:blipFill>
        <p:spPr>
          <a:xfrm>
            <a:off x="6871203" y="2395764"/>
            <a:ext cx="338328" cy="1511808"/>
          </a:xfrm>
          <a:prstGeom prst="rect">
            <a:avLst/>
          </a:prstGeom>
        </p:spPr>
      </p:pic>
      <p:pic>
        <p:nvPicPr>
          <p:cNvPr id="15" name="Image 13" descr="preencoded.png"/>
          <p:cNvPicPr>
            <a:picLocks noChangeAspect="1"/>
          </p:cNvPicPr>
          <p:nvPr>
            <p:custDataLst>
              <p:tags r:id="rId15"/>
            </p:custDataLst>
          </p:nvPr>
        </p:nvPicPr>
        <p:blipFill>
          <a:blip r:embed="rId39"/>
          <a:stretch>
            <a:fillRect/>
          </a:stretch>
        </p:blipFill>
        <p:spPr>
          <a:xfrm>
            <a:off x="7421413" y="2395764"/>
            <a:ext cx="338328" cy="1511808"/>
          </a:xfrm>
          <a:prstGeom prst="rect">
            <a:avLst/>
          </a:prstGeom>
        </p:spPr>
      </p:pic>
      <p:pic>
        <p:nvPicPr>
          <p:cNvPr id="16" name="Image 14" descr="preencoded.png"/>
          <p:cNvPicPr>
            <a:picLocks noChangeAspect="1"/>
          </p:cNvPicPr>
          <p:nvPr>
            <p:custDataLst>
              <p:tags r:id="rId16"/>
            </p:custDataLst>
          </p:nvPr>
        </p:nvPicPr>
        <p:blipFill>
          <a:blip r:embed="rId39"/>
          <a:stretch>
            <a:fillRect/>
          </a:stretch>
        </p:blipFill>
        <p:spPr>
          <a:xfrm>
            <a:off x="7971624" y="2395764"/>
            <a:ext cx="338328" cy="1511808"/>
          </a:xfrm>
          <a:prstGeom prst="rect">
            <a:avLst/>
          </a:prstGeom>
        </p:spPr>
      </p:pic>
      <p:pic>
        <p:nvPicPr>
          <p:cNvPr id="17" name="Image 15" descr="preencoded.png"/>
          <p:cNvPicPr>
            <a:picLocks noChangeAspect="1"/>
          </p:cNvPicPr>
          <p:nvPr>
            <p:custDataLst>
              <p:tags r:id="rId17"/>
            </p:custDataLst>
          </p:nvPr>
        </p:nvPicPr>
        <p:blipFill>
          <a:blip r:embed="rId39"/>
          <a:stretch>
            <a:fillRect/>
          </a:stretch>
        </p:blipFill>
        <p:spPr>
          <a:xfrm>
            <a:off x="8521834" y="2395764"/>
            <a:ext cx="338328" cy="1511808"/>
          </a:xfrm>
          <a:prstGeom prst="rect">
            <a:avLst/>
          </a:prstGeom>
        </p:spPr>
      </p:pic>
      <p:sp>
        <p:nvSpPr>
          <p:cNvPr id="18" name="Text 0"/>
          <p:cNvSpPr/>
          <p:nvPr/>
        </p:nvSpPr>
        <p:spPr>
          <a:xfrm>
            <a:off x="255889" y="4033461"/>
            <a:ext cx="450384" cy="208881"/>
          </a:xfrm>
          <a:prstGeom prst="rect">
            <a:avLst/>
          </a:prstGeom>
          <a:noFill/>
          <a:ln/>
        </p:spPr>
        <p:txBody>
          <a:bodyPr wrap="square" lIns="0" tIns="0" rIns="0" bIns="0" rtlCol="0" anchor="t"/>
          <a:lstStyle/>
          <a:p>
            <a:pPr marL="0" indent="0" algn="l">
              <a:lnSpc>
                <a:spcPct val="97750"/>
              </a:lnSpc>
              <a:buNone/>
            </a:pPr>
            <a:r>
              <a:rPr lang="en-US" sz="693" b="1" dirty="0">
                <a:solidFill>
                  <a:srgbClr val="000000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250ug/ul</a:t>
            </a:r>
            <a:endParaRPr lang="en-US" sz="693" dirty="0"/>
          </a:p>
        </p:txBody>
      </p:sp>
      <p:sp>
        <p:nvSpPr>
          <p:cNvPr id="19" name="Text 1"/>
          <p:cNvSpPr/>
          <p:nvPr/>
        </p:nvSpPr>
        <p:spPr>
          <a:xfrm>
            <a:off x="818581" y="4033461"/>
            <a:ext cx="450384" cy="208881"/>
          </a:xfrm>
          <a:prstGeom prst="rect">
            <a:avLst/>
          </a:prstGeom>
          <a:noFill/>
          <a:ln/>
        </p:spPr>
        <p:txBody>
          <a:bodyPr wrap="square" lIns="0" tIns="0" rIns="0" bIns="0" rtlCol="0" anchor="t"/>
          <a:lstStyle/>
          <a:p>
            <a:pPr marL="0" indent="0" algn="l">
              <a:lnSpc>
                <a:spcPct val="97750"/>
              </a:lnSpc>
              <a:buNone/>
            </a:pPr>
            <a:r>
              <a:rPr lang="en-US" sz="693" b="1" dirty="0">
                <a:solidFill>
                  <a:srgbClr val="000000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125ug/ul</a:t>
            </a:r>
            <a:endParaRPr lang="en-US" sz="693" dirty="0"/>
          </a:p>
        </p:txBody>
      </p:sp>
      <p:sp>
        <p:nvSpPr>
          <p:cNvPr id="20" name="Text 2"/>
          <p:cNvSpPr/>
          <p:nvPr/>
        </p:nvSpPr>
        <p:spPr>
          <a:xfrm>
            <a:off x="1368784" y="4033461"/>
            <a:ext cx="450384" cy="208881"/>
          </a:xfrm>
          <a:prstGeom prst="rect">
            <a:avLst/>
          </a:prstGeom>
          <a:noFill/>
          <a:ln/>
        </p:spPr>
        <p:txBody>
          <a:bodyPr wrap="square" lIns="0" tIns="0" rIns="0" bIns="0" rtlCol="0" anchor="t"/>
          <a:lstStyle/>
          <a:p>
            <a:pPr marL="0" indent="0" algn="l">
              <a:lnSpc>
                <a:spcPct val="97750"/>
              </a:lnSpc>
              <a:buNone/>
            </a:pPr>
            <a:r>
              <a:rPr lang="en-US" sz="693" b="1" dirty="0">
                <a:solidFill>
                  <a:srgbClr val="000000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62.5ug/ul</a:t>
            </a:r>
            <a:endParaRPr lang="en-US" sz="693" dirty="0"/>
          </a:p>
        </p:txBody>
      </p:sp>
      <p:sp>
        <p:nvSpPr>
          <p:cNvPr id="21" name="Text 3"/>
          <p:cNvSpPr/>
          <p:nvPr/>
        </p:nvSpPr>
        <p:spPr>
          <a:xfrm>
            <a:off x="1918998" y="4033461"/>
            <a:ext cx="450384" cy="208881"/>
          </a:xfrm>
          <a:prstGeom prst="rect">
            <a:avLst/>
          </a:prstGeom>
          <a:noFill/>
          <a:ln/>
        </p:spPr>
        <p:txBody>
          <a:bodyPr wrap="square" lIns="0" tIns="0" rIns="0" bIns="0" rtlCol="0" anchor="t"/>
          <a:lstStyle/>
          <a:p>
            <a:pPr marL="0" indent="0" algn="l">
              <a:lnSpc>
                <a:spcPct val="97750"/>
              </a:lnSpc>
              <a:buNone/>
            </a:pPr>
            <a:r>
              <a:rPr lang="en-US" sz="693" b="1" dirty="0">
                <a:solidFill>
                  <a:srgbClr val="000000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31.25ug/ul</a:t>
            </a:r>
            <a:endParaRPr lang="en-US" sz="693" dirty="0"/>
          </a:p>
        </p:txBody>
      </p:sp>
      <p:sp>
        <p:nvSpPr>
          <p:cNvPr id="22" name="Text 4"/>
          <p:cNvSpPr/>
          <p:nvPr/>
        </p:nvSpPr>
        <p:spPr>
          <a:xfrm>
            <a:off x="2469212" y="4033461"/>
            <a:ext cx="450384" cy="208881"/>
          </a:xfrm>
          <a:prstGeom prst="rect">
            <a:avLst/>
          </a:prstGeom>
          <a:noFill/>
          <a:ln/>
        </p:spPr>
        <p:txBody>
          <a:bodyPr wrap="square" lIns="0" tIns="0" rIns="0" bIns="0" rtlCol="0" anchor="t"/>
          <a:lstStyle/>
          <a:p>
            <a:pPr marL="0" indent="0" algn="l">
              <a:lnSpc>
                <a:spcPct val="97750"/>
              </a:lnSpc>
              <a:buNone/>
            </a:pPr>
            <a:r>
              <a:rPr lang="en-US" sz="693" b="1" dirty="0">
                <a:solidFill>
                  <a:srgbClr val="000000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15.63ug/ul</a:t>
            </a:r>
            <a:endParaRPr lang="en-US" sz="693" dirty="0"/>
          </a:p>
        </p:txBody>
      </p:sp>
      <p:sp>
        <p:nvSpPr>
          <p:cNvPr id="23" name="Text 5"/>
          <p:cNvSpPr/>
          <p:nvPr/>
        </p:nvSpPr>
        <p:spPr>
          <a:xfrm>
            <a:off x="3019415" y="4033461"/>
            <a:ext cx="450384" cy="208881"/>
          </a:xfrm>
          <a:prstGeom prst="rect">
            <a:avLst/>
          </a:prstGeom>
          <a:noFill/>
          <a:ln/>
        </p:spPr>
        <p:txBody>
          <a:bodyPr wrap="square" lIns="0" tIns="0" rIns="0" bIns="0" rtlCol="0" anchor="t"/>
          <a:lstStyle/>
          <a:p>
            <a:pPr marL="0" indent="0" algn="l">
              <a:lnSpc>
                <a:spcPct val="97750"/>
              </a:lnSpc>
              <a:buNone/>
            </a:pPr>
            <a:r>
              <a:rPr lang="en-US" sz="693" b="1" dirty="0">
                <a:solidFill>
                  <a:srgbClr val="000000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7.81ug/ul</a:t>
            </a:r>
            <a:endParaRPr lang="en-US" sz="693" dirty="0"/>
          </a:p>
        </p:txBody>
      </p:sp>
      <p:sp>
        <p:nvSpPr>
          <p:cNvPr id="24" name="Text 6"/>
          <p:cNvSpPr/>
          <p:nvPr/>
        </p:nvSpPr>
        <p:spPr>
          <a:xfrm>
            <a:off x="3569629" y="4033461"/>
            <a:ext cx="450384" cy="208881"/>
          </a:xfrm>
          <a:prstGeom prst="rect">
            <a:avLst/>
          </a:prstGeom>
          <a:noFill/>
          <a:ln/>
        </p:spPr>
        <p:txBody>
          <a:bodyPr wrap="square" lIns="0" tIns="0" rIns="0" bIns="0" rtlCol="0" anchor="t"/>
          <a:lstStyle/>
          <a:p>
            <a:pPr marL="0" indent="0" algn="l">
              <a:lnSpc>
                <a:spcPct val="97750"/>
              </a:lnSpc>
              <a:buNone/>
            </a:pPr>
            <a:r>
              <a:rPr lang="en-US" sz="693" b="1" dirty="0">
                <a:solidFill>
                  <a:srgbClr val="000000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3.91ug/ul</a:t>
            </a:r>
            <a:endParaRPr lang="en-US" sz="693" dirty="0"/>
          </a:p>
        </p:txBody>
      </p:sp>
      <p:sp>
        <p:nvSpPr>
          <p:cNvPr id="25" name="Text 7"/>
          <p:cNvSpPr/>
          <p:nvPr/>
        </p:nvSpPr>
        <p:spPr>
          <a:xfrm>
            <a:off x="4119843" y="4033461"/>
            <a:ext cx="450384" cy="208881"/>
          </a:xfrm>
          <a:prstGeom prst="rect">
            <a:avLst/>
          </a:prstGeom>
          <a:noFill/>
          <a:ln/>
        </p:spPr>
        <p:txBody>
          <a:bodyPr wrap="square" lIns="0" tIns="0" rIns="0" bIns="0" rtlCol="0" anchor="t"/>
          <a:lstStyle/>
          <a:p>
            <a:pPr marL="0" indent="0" algn="l">
              <a:lnSpc>
                <a:spcPct val="97750"/>
              </a:lnSpc>
              <a:buNone/>
            </a:pPr>
            <a:r>
              <a:rPr lang="en-US" sz="693" b="1" dirty="0">
                <a:solidFill>
                  <a:srgbClr val="000000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1.95ug/ul</a:t>
            </a:r>
            <a:endParaRPr lang="en-US" sz="693" dirty="0"/>
          </a:p>
        </p:txBody>
      </p:sp>
      <p:sp>
        <p:nvSpPr>
          <p:cNvPr id="26" name="Text 8"/>
          <p:cNvSpPr/>
          <p:nvPr/>
        </p:nvSpPr>
        <p:spPr>
          <a:xfrm>
            <a:off x="4670046" y="4033461"/>
            <a:ext cx="450384" cy="208881"/>
          </a:xfrm>
          <a:prstGeom prst="rect">
            <a:avLst/>
          </a:prstGeom>
          <a:noFill/>
          <a:ln/>
        </p:spPr>
        <p:txBody>
          <a:bodyPr wrap="square" lIns="0" tIns="0" rIns="0" bIns="0" rtlCol="0" anchor="t"/>
          <a:lstStyle/>
          <a:p>
            <a:pPr marL="0" indent="0" algn="l">
              <a:lnSpc>
                <a:spcPct val="97750"/>
              </a:lnSpc>
              <a:buNone/>
            </a:pPr>
            <a:r>
              <a:rPr lang="en-US" sz="693" b="1" dirty="0">
                <a:solidFill>
                  <a:srgbClr val="000000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0.98ug/ul</a:t>
            </a:r>
            <a:endParaRPr lang="en-US" sz="693" dirty="0"/>
          </a:p>
        </p:txBody>
      </p:sp>
      <p:sp>
        <p:nvSpPr>
          <p:cNvPr id="27" name="Text 9"/>
          <p:cNvSpPr/>
          <p:nvPr/>
        </p:nvSpPr>
        <p:spPr>
          <a:xfrm>
            <a:off x="5220260" y="4033461"/>
            <a:ext cx="450384" cy="208881"/>
          </a:xfrm>
          <a:prstGeom prst="rect">
            <a:avLst/>
          </a:prstGeom>
          <a:noFill/>
          <a:ln/>
        </p:spPr>
        <p:txBody>
          <a:bodyPr wrap="square" lIns="0" tIns="0" rIns="0" bIns="0" rtlCol="0" anchor="t"/>
          <a:lstStyle/>
          <a:p>
            <a:pPr marL="0" indent="0" algn="l">
              <a:lnSpc>
                <a:spcPct val="97750"/>
              </a:lnSpc>
              <a:buNone/>
            </a:pPr>
            <a:r>
              <a:rPr lang="en-US" sz="693" b="1" dirty="0">
                <a:solidFill>
                  <a:srgbClr val="000000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0.49ug/ul</a:t>
            </a:r>
            <a:endParaRPr lang="en-US" sz="693" dirty="0"/>
          </a:p>
        </p:txBody>
      </p:sp>
      <p:sp>
        <p:nvSpPr>
          <p:cNvPr id="28" name="Text 10"/>
          <p:cNvSpPr/>
          <p:nvPr/>
        </p:nvSpPr>
        <p:spPr>
          <a:xfrm>
            <a:off x="5770474" y="4033461"/>
            <a:ext cx="450384" cy="208881"/>
          </a:xfrm>
          <a:prstGeom prst="rect">
            <a:avLst/>
          </a:prstGeom>
          <a:noFill/>
          <a:ln/>
        </p:spPr>
        <p:txBody>
          <a:bodyPr wrap="square" lIns="0" tIns="0" rIns="0" bIns="0" rtlCol="0" anchor="t"/>
          <a:lstStyle/>
          <a:p>
            <a:pPr marL="0" indent="0" algn="l">
              <a:lnSpc>
                <a:spcPct val="97750"/>
              </a:lnSpc>
              <a:buNone/>
            </a:pPr>
            <a:r>
              <a:rPr lang="en-US" sz="693" b="1" dirty="0">
                <a:solidFill>
                  <a:srgbClr val="000000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0.24ug/ul</a:t>
            </a:r>
            <a:endParaRPr lang="en-US" sz="693" dirty="0"/>
          </a:p>
        </p:txBody>
      </p:sp>
      <p:sp>
        <p:nvSpPr>
          <p:cNvPr id="29" name="Text 11"/>
          <p:cNvSpPr/>
          <p:nvPr/>
        </p:nvSpPr>
        <p:spPr>
          <a:xfrm>
            <a:off x="6320688" y="4033461"/>
            <a:ext cx="450384" cy="208881"/>
          </a:xfrm>
          <a:prstGeom prst="rect">
            <a:avLst/>
          </a:prstGeom>
          <a:noFill/>
          <a:ln/>
        </p:spPr>
        <p:txBody>
          <a:bodyPr wrap="square" lIns="0" tIns="0" rIns="0" bIns="0" rtlCol="0" anchor="t"/>
          <a:lstStyle/>
          <a:p>
            <a:pPr marL="0" indent="0" algn="l">
              <a:lnSpc>
                <a:spcPct val="97750"/>
              </a:lnSpc>
              <a:buNone/>
            </a:pPr>
            <a:r>
              <a:rPr lang="en-US" sz="693" b="1" dirty="0">
                <a:solidFill>
                  <a:srgbClr val="000000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0.12ug/ul</a:t>
            </a:r>
            <a:endParaRPr lang="en-US" sz="693" dirty="0"/>
          </a:p>
        </p:txBody>
      </p:sp>
      <p:sp>
        <p:nvSpPr>
          <p:cNvPr id="30" name="Text 12"/>
          <p:cNvSpPr/>
          <p:nvPr/>
        </p:nvSpPr>
        <p:spPr>
          <a:xfrm>
            <a:off x="6870902" y="4033461"/>
            <a:ext cx="450384" cy="208881"/>
          </a:xfrm>
          <a:prstGeom prst="rect">
            <a:avLst/>
          </a:prstGeom>
          <a:noFill/>
          <a:ln/>
        </p:spPr>
        <p:txBody>
          <a:bodyPr wrap="square" lIns="0" tIns="0" rIns="0" bIns="0" rtlCol="0" anchor="t"/>
          <a:lstStyle/>
          <a:p>
            <a:pPr marL="0" indent="0" algn="l">
              <a:lnSpc>
                <a:spcPct val="97750"/>
              </a:lnSpc>
              <a:buNone/>
            </a:pPr>
            <a:r>
              <a:rPr lang="en-US" sz="693" b="1" dirty="0">
                <a:solidFill>
                  <a:srgbClr val="000000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0.06ug/ul</a:t>
            </a:r>
            <a:endParaRPr lang="en-US" sz="693" dirty="0"/>
          </a:p>
        </p:txBody>
      </p:sp>
      <p:sp>
        <p:nvSpPr>
          <p:cNvPr id="31" name="Text 13"/>
          <p:cNvSpPr/>
          <p:nvPr/>
        </p:nvSpPr>
        <p:spPr>
          <a:xfrm>
            <a:off x="7421105" y="4033461"/>
            <a:ext cx="450384" cy="208881"/>
          </a:xfrm>
          <a:prstGeom prst="rect">
            <a:avLst/>
          </a:prstGeom>
          <a:noFill/>
          <a:ln/>
        </p:spPr>
        <p:txBody>
          <a:bodyPr wrap="square" lIns="0" tIns="0" rIns="0" bIns="0" rtlCol="0" anchor="t"/>
          <a:lstStyle/>
          <a:p>
            <a:pPr marL="0" indent="0" algn="l">
              <a:lnSpc>
                <a:spcPct val="97750"/>
              </a:lnSpc>
              <a:buNone/>
            </a:pPr>
            <a:r>
              <a:rPr lang="en-US" sz="693" b="1" dirty="0">
                <a:solidFill>
                  <a:srgbClr val="000000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0.03ug/ul</a:t>
            </a:r>
            <a:endParaRPr lang="en-US" sz="693" dirty="0"/>
          </a:p>
        </p:txBody>
      </p:sp>
      <p:sp>
        <p:nvSpPr>
          <p:cNvPr id="32" name="Text 14"/>
          <p:cNvSpPr/>
          <p:nvPr/>
        </p:nvSpPr>
        <p:spPr>
          <a:xfrm>
            <a:off x="7971319" y="4033461"/>
            <a:ext cx="450384" cy="208881"/>
          </a:xfrm>
          <a:prstGeom prst="rect">
            <a:avLst/>
          </a:prstGeom>
          <a:noFill/>
          <a:ln/>
        </p:spPr>
        <p:txBody>
          <a:bodyPr wrap="square" lIns="0" tIns="0" rIns="0" bIns="0" rtlCol="0" anchor="t"/>
          <a:lstStyle/>
          <a:p>
            <a:pPr marL="0" indent="0" algn="l">
              <a:lnSpc>
                <a:spcPct val="97750"/>
              </a:lnSpc>
              <a:buNone/>
            </a:pPr>
            <a:r>
              <a:rPr lang="en-US" sz="693" b="1" dirty="0">
                <a:solidFill>
                  <a:srgbClr val="000000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0.02ug/ul</a:t>
            </a:r>
            <a:endParaRPr lang="en-US" sz="693" dirty="0"/>
          </a:p>
        </p:txBody>
      </p:sp>
      <p:sp>
        <p:nvSpPr>
          <p:cNvPr id="33" name="Text 15"/>
          <p:cNvSpPr/>
          <p:nvPr/>
        </p:nvSpPr>
        <p:spPr>
          <a:xfrm>
            <a:off x="8521533" y="4033461"/>
            <a:ext cx="450384" cy="208881"/>
          </a:xfrm>
          <a:prstGeom prst="rect">
            <a:avLst/>
          </a:prstGeom>
          <a:noFill/>
          <a:ln/>
        </p:spPr>
        <p:txBody>
          <a:bodyPr wrap="square" lIns="0" tIns="0" rIns="0" bIns="0" rtlCol="0" anchor="t"/>
          <a:lstStyle/>
          <a:p>
            <a:pPr marL="0" indent="0" algn="l">
              <a:lnSpc>
                <a:spcPct val="97750"/>
              </a:lnSpc>
              <a:buNone/>
            </a:pPr>
            <a:r>
              <a:rPr lang="en-US" sz="693" b="1" dirty="0">
                <a:solidFill>
                  <a:srgbClr val="000000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0.01ug/ul</a:t>
            </a:r>
            <a:endParaRPr lang="en-US" sz="693" dirty="0"/>
          </a:p>
        </p:txBody>
      </p:sp>
      <p:pic>
        <p:nvPicPr>
          <p:cNvPr id="34" name="Image 16" descr="preencoded.png"/>
          <p:cNvPicPr>
            <a:picLocks noChangeAspect="1"/>
          </p:cNvPicPr>
          <p:nvPr>
            <p:custDataLst>
              <p:tags r:id="rId18"/>
            </p:custDataLst>
          </p:nvPr>
        </p:nvPicPr>
        <p:blipFill>
          <a:blip r:embed="rId42"/>
          <a:stretch>
            <a:fillRect/>
          </a:stretch>
        </p:blipFill>
        <p:spPr>
          <a:xfrm>
            <a:off x="358217" y="1864159"/>
            <a:ext cx="646176" cy="481584"/>
          </a:xfrm>
          <a:prstGeom prst="rect">
            <a:avLst/>
          </a:prstGeom>
        </p:spPr>
      </p:pic>
      <p:pic>
        <p:nvPicPr>
          <p:cNvPr id="35" name="Image 17" descr="preencoded.png"/>
          <p:cNvPicPr>
            <a:picLocks noChangeAspect="1"/>
          </p:cNvPicPr>
          <p:nvPr>
            <p:custDataLst>
              <p:tags r:id="rId19"/>
            </p:custDataLst>
          </p:nvPr>
        </p:nvPicPr>
        <p:blipFill>
          <a:blip r:embed="rId42"/>
          <a:stretch>
            <a:fillRect/>
          </a:stretch>
        </p:blipFill>
        <p:spPr>
          <a:xfrm>
            <a:off x="939714" y="1864162"/>
            <a:ext cx="646176" cy="481584"/>
          </a:xfrm>
          <a:prstGeom prst="rect">
            <a:avLst/>
          </a:prstGeom>
        </p:spPr>
      </p:pic>
      <p:pic>
        <p:nvPicPr>
          <p:cNvPr id="36" name="Image 18" descr="preencoded.png"/>
          <p:cNvPicPr>
            <a:picLocks noChangeAspect="1"/>
          </p:cNvPicPr>
          <p:nvPr>
            <p:custDataLst>
              <p:tags r:id="rId20"/>
            </p:custDataLst>
          </p:nvPr>
        </p:nvPicPr>
        <p:blipFill>
          <a:blip r:embed="rId42"/>
          <a:stretch>
            <a:fillRect/>
          </a:stretch>
        </p:blipFill>
        <p:spPr>
          <a:xfrm>
            <a:off x="1521213" y="1864161"/>
            <a:ext cx="646176" cy="481584"/>
          </a:xfrm>
          <a:prstGeom prst="rect">
            <a:avLst/>
          </a:prstGeom>
        </p:spPr>
      </p:pic>
      <p:pic>
        <p:nvPicPr>
          <p:cNvPr id="37" name="Image 19" descr="preencoded.png"/>
          <p:cNvPicPr>
            <a:picLocks noChangeAspect="1"/>
          </p:cNvPicPr>
          <p:nvPr>
            <p:custDataLst>
              <p:tags r:id="rId21"/>
            </p:custDataLst>
          </p:nvPr>
        </p:nvPicPr>
        <p:blipFill>
          <a:blip r:embed="rId42"/>
          <a:stretch>
            <a:fillRect/>
          </a:stretch>
        </p:blipFill>
        <p:spPr>
          <a:xfrm>
            <a:off x="2057922" y="1864160"/>
            <a:ext cx="646176" cy="481584"/>
          </a:xfrm>
          <a:prstGeom prst="rect">
            <a:avLst/>
          </a:prstGeom>
        </p:spPr>
      </p:pic>
      <p:pic>
        <p:nvPicPr>
          <p:cNvPr id="38" name="Image 20" descr="preencoded.png"/>
          <p:cNvPicPr>
            <a:picLocks noChangeAspect="1"/>
          </p:cNvPicPr>
          <p:nvPr>
            <p:custDataLst>
              <p:tags r:id="rId22"/>
            </p:custDataLst>
          </p:nvPr>
        </p:nvPicPr>
        <p:blipFill>
          <a:blip r:embed="rId42"/>
          <a:stretch>
            <a:fillRect/>
          </a:stretch>
        </p:blipFill>
        <p:spPr>
          <a:xfrm>
            <a:off x="2607429" y="1864158"/>
            <a:ext cx="646176" cy="481584"/>
          </a:xfrm>
          <a:prstGeom prst="rect">
            <a:avLst/>
          </a:prstGeom>
        </p:spPr>
      </p:pic>
      <p:pic>
        <p:nvPicPr>
          <p:cNvPr id="39" name="Image 21" descr="preencoded.png"/>
          <p:cNvPicPr>
            <a:picLocks noChangeAspect="1"/>
          </p:cNvPicPr>
          <p:nvPr>
            <p:custDataLst>
              <p:tags r:id="rId23"/>
            </p:custDataLst>
          </p:nvPr>
        </p:nvPicPr>
        <p:blipFill>
          <a:blip r:embed="rId42"/>
          <a:stretch>
            <a:fillRect/>
          </a:stretch>
        </p:blipFill>
        <p:spPr>
          <a:xfrm>
            <a:off x="3156933" y="1864156"/>
            <a:ext cx="646176" cy="481584"/>
          </a:xfrm>
          <a:prstGeom prst="rect">
            <a:avLst/>
          </a:prstGeom>
        </p:spPr>
      </p:pic>
      <p:pic>
        <p:nvPicPr>
          <p:cNvPr id="40" name="Image 22" descr="preencoded.png"/>
          <p:cNvPicPr>
            <a:picLocks noChangeAspect="1"/>
          </p:cNvPicPr>
          <p:nvPr>
            <p:custDataLst>
              <p:tags r:id="rId24"/>
            </p:custDataLst>
          </p:nvPr>
        </p:nvPicPr>
        <p:blipFill>
          <a:blip r:embed="rId42"/>
          <a:stretch>
            <a:fillRect/>
          </a:stretch>
        </p:blipFill>
        <p:spPr>
          <a:xfrm>
            <a:off x="3706442" y="1864164"/>
            <a:ext cx="646176" cy="481584"/>
          </a:xfrm>
          <a:prstGeom prst="rect">
            <a:avLst/>
          </a:prstGeom>
        </p:spPr>
      </p:pic>
      <p:pic>
        <p:nvPicPr>
          <p:cNvPr id="41" name="Image 23" descr="preencoded.png"/>
          <p:cNvPicPr>
            <a:picLocks noChangeAspect="1"/>
          </p:cNvPicPr>
          <p:nvPr>
            <p:custDataLst>
              <p:tags r:id="rId25"/>
            </p:custDataLst>
          </p:nvPr>
        </p:nvPicPr>
        <p:blipFill>
          <a:blip r:embed="rId42"/>
          <a:stretch>
            <a:fillRect/>
          </a:stretch>
        </p:blipFill>
        <p:spPr>
          <a:xfrm>
            <a:off x="4255943" y="1864167"/>
            <a:ext cx="646176" cy="481584"/>
          </a:xfrm>
          <a:prstGeom prst="rect">
            <a:avLst/>
          </a:prstGeom>
        </p:spPr>
      </p:pic>
      <p:pic>
        <p:nvPicPr>
          <p:cNvPr id="42" name="Image 24" descr="preencoded.png"/>
          <p:cNvPicPr>
            <a:picLocks noChangeAspect="1"/>
          </p:cNvPicPr>
          <p:nvPr>
            <p:custDataLst>
              <p:tags r:id="rId26"/>
            </p:custDataLst>
          </p:nvPr>
        </p:nvPicPr>
        <p:blipFill>
          <a:blip r:embed="rId42"/>
          <a:stretch>
            <a:fillRect/>
          </a:stretch>
        </p:blipFill>
        <p:spPr>
          <a:xfrm>
            <a:off x="4792657" y="1864159"/>
            <a:ext cx="646176" cy="481584"/>
          </a:xfrm>
          <a:prstGeom prst="rect">
            <a:avLst/>
          </a:prstGeom>
        </p:spPr>
      </p:pic>
      <p:pic>
        <p:nvPicPr>
          <p:cNvPr id="43" name="Image 25" descr="preencoded.png"/>
          <p:cNvPicPr>
            <a:picLocks noChangeAspect="1"/>
          </p:cNvPicPr>
          <p:nvPr>
            <p:custDataLst>
              <p:tags r:id="rId27"/>
            </p:custDataLst>
          </p:nvPr>
        </p:nvPicPr>
        <p:blipFill>
          <a:blip r:embed="rId42"/>
          <a:stretch>
            <a:fillRect/>
          </a:stretch>
        </p:blipFill>
        <p:spPr>
          <a:xfrm>
            <a:off x="5374156" y="1864164"/>
            <a:ext cx="646176" cy="481584"/>
          </a:xfrm>
          <a:prstGeom prst="rect">
            <a:avLst/>
          </a:prstGeom>
        </p:spPr>
      </p:pic>
      <p:pic>
        <p:nvPicPr>
          <p:cNvPr id="44" name="Image 26" descr="preencoded.png"/>
          <p:cNvPicPr>
            <a:picLocks noChangeAspect="1"/>
          </p:cNvPicPr>
          <p:nvPr>
            <p:custDataLst>
              <p:tags r:id="rId28"/>
            </p:custDataLst>
          </p:nvPr>
        </p:nvPicPr>
        <p:blipFill>
          <a:blip r:embed="rId42"/>
          <a:stretch>
            <a:fillRect/>
          </a:stretch>
        </p:blipFill>
        <p:spPr>
          <a:xfrm>
            <a:off x="5894671" y="1876958"/>
            <a:ext cx="646176" cy="481584"/>
          </a:xfrm>
          <a:prstGeom prst="rect">
            <a:avLst/>
          </a:prstGeom>
        </p:spPr>
      </p:pic>
      <p:pic>
        <p:nvPicPr>
          <p:cNvPr id="45" name="Image 27" descr="preencoded.png"/>
          <p:cNvPicPr>
            <a:picLocks noChangeAspect="1"/>
          </p:cNvPicPr>
          <p:nvPr>
            <p:custDataLst>
              <p:tags r:id="rId29"/>
            </p:custDataLst>
          </p:nvPr>
        </p:nvPicPr>
        <p:blipFill>
          <a:blip r:embed="rId42"/>
          <a:stretch>
            <a:fillRect/>
          </a:stretch>
        </p:blipFill>
        <p:spPr>
          <a:xfrm>
            <a:off x="6427990" y="1876957"/>
            <a:ext cx="646176" cy="481584"/>
          </a:xfrm>
          <a:prstGeom prst="rect">
            <a:avLst/>
          </a:prstGeom>
        </p:spPr>
      </p:pic>
      <p:pic>
        <p:nvPicPr>
          <p:cNvPr id="46" name="Image 28" descr="preencoded.png"/>
          <p:cNvPicPr>
            <a:picLocks noChangeAspect="1"/>
          </p:cNvPicPr>
          <p:nvPr>
            <p:custDataLst>
              <p:tags r:id="rId30"/>
            </p:custDataLst>
          </p:nvPr>
        </p:nvPicPr>
        <p:blipFill>
          <a:blip r:embed="rId42"/>
          <a:stretch>
            <a:fillRect/>
          </a:stretch>
        </p:blipFill>
        <p:spPr>
          <a:xfrm>
            <a:off x="6977891" y="1876965"/>
            <a:ext cx="646176" cy="481584"/>
          </a:xfrm>
          <a:prstGeom prst="rect">
            <a:avLst/>
          </a:prstGeom>
        </p:spPr>
      </p:pic>
      <p:pic>
        <p:nvPicPr>
          <p:cNvPr id="47" name="Image 29" descr="preencoded.png"/>
          <p:cNvPicPr>
            <a:picLocks noChangeAspect="1"/>
          </p:cNvPicPr>
          <p:nvPr>
            <p:custDataLst>
              <p:tags r:id="rId31"/>
            </p:custDataLst>
          </p:nvPr>
        </p:nvPicPr>
        <p:blipFill>
          <a:blip r:embed="rId42"/>
          <a:stretch>
            <a:fillRect/>
          </a:stretch>
        </p:blipFill>
        <p:spPr>
          <a:xfrm>
            <a:off x="7546592" y="1876961"/>
            <a:ext cx="646176" cy="481584"/>
          </a:xfrm>
          <a:prstGeom prst="rect">
            <a:avLst/>
          </a:prstGeom>
        </p:spPr>
      </p:pic>
      <p:pic>
        <p:nvPicPr>
          <p:cNvPr id="48" name="Image 30" descr="preencoded.png"/>
          <p:cNvPicPr>
            <a:picLocks noChangeAspect="1"/>
          </p:cNvPicPr>
          <p:nvPr>
            <p:custDataLst>
              <p:tags r:id="rId32"/>
            </p:custDataLst>
          </p:nvPr>
        </p:nvPicPr>
        <p:blipFill>
          <a:blip r:embed="rId42"/>
          <a:stretch>
            <a:fillRect/>
          </a:stretch>
        </p:blipFill>
        <p:spPr>
          <a:xfrm>
            <a:off x="8108891" y="1876962"/>
            <a:ext cx="646176" cy="481584"/>
          </a:xfrm>
          <a:prstGeom prst="rect">
            <a:avLst/>
          </a:prstGeom>
        </p:spPr>
      </p:pic>
      <p:pic>
        <p:nvPicPr>
          <p:cNvPr id="49" name="Image 31" descr="preencoded.png"/>
          <p:cNvPicPr>
            <a:picLocks noChangeAspect="1"/>
          </p:cNvPicPr>
          <p:nvPr>
            <p:custDataLst>
              <p:tags r:id="rId33"/>
            </p:custDataLst>
          </p:nvPr>
        </p:nvPicPr>
        <p:blipFill>
          <a:blip r:embed="rId43"/>
          <a:stretch>
            <a:fillRect/>
          </a:stretch>
        </p:blipFill>
        <p:spPr>
          <a:xfrm>
            <a:off x="4165470" y="1099334"/>
            <a:ext cx="243840" cy="813816"/>
          </a:xfrm>
          <a:prstGeom prst="rect">
            <a:avLst/>
          </a:prstGeom>
        </p:spPr>
      </p:pic>
      <p:pic>
        <p:nvPicPr>
          <p:cNvPr id="50" name="Image 32" descr="preencoded.png"/>
          <p:cNvPicPr>
            <a:picLocks noChangeAspect="1"/>
          </p:cNvPicPr>
          <p:nvPr>
            <p:custDataLst>
              <p:tags r:id="rId34"/>
            </p:custDataLst>
          </p:nvPr>
        </p:nvPicPr>
        <p:blipFill>
          <a:blip r:embed="rId43"/>
          <a:stretch>
            <a:fillRect/>
          </a:stretch>
        </p:blipFill>
        <p:spPr>
          <a:xfrm>
            <a:off x="5258318" y="1099333"/>
            <a:ext cx="243840" cy="813816"/>
          </a:xfrm>
          <a:prstGeom prst="rect">
            <a:avLst/>
          </a:prstGeom>
        </p:spPr>
      </p:pic>
      <p:pic>
        <p:nvPicPr>
          <p:cNvPr id="51" name="Image 33" descr="preencoded.png"/>
          <p:cNvPicPr>
            <a:picLocks noChangeAspect="1"/>
          </p:cNvPicPr>
          <p:nvPr>
            <p:custDataLst>
              <p:tags r:id="rId35"/>
            </p:custDataLst>
          </p:nvPr>
        </p:nvPicPr>
        <p:blipFill>
          <a:blip r:embed="rId43"/>
          <a:stretch>
            <a:fillRect/>
          </a:stretch>
        </p:blipFill>
        <p:spPr>
          <a:xfrm>
            <a:off x="7432972" y="1107235"/>
            <a:ext cx="243840" cy="813816"/>
          </a:xfrm>
          <a:prstGeom prst="rect">
            <a:avLst/>
          </a:prstGeom>
        </p:spPr>
      </p:pic>
      <p:pic>
        <p:nvPicPr>
          <p:cNvPr id="52" name="Image 34" descr="preencoded.png"/>
          <p:cNvPicPr>
            <a:picLocks noChangeAspect="1"/>
          </p:cNvPicPr>
          <p:nvPr>
            <p:custDataLst>
              <p:tags r:id="rId36"/>
            </p:custDataLst>
          </p:nvPr>
        </p:nvPicPr>
        <p:blipFill>
          <a:blip r:embed="rId43"/>
          <a:stretch>
            <a:fillRect/>
          </a:stretch>
        </p:blipFill>
        <p:spPr>
          <a:xfrm>
            <a:off x="8603408" y="1075680"/>
            <a:ext cx="243840" cy="813816"/>
          </a:xfrm>
          <a:prstGeom prst="rect">
            <a:avLst/>
          </a:prstGeom>
        </p:spPr>
      </p:pic>
      <p:sp>
        <p:nvSpPr>
          <p:cNvPr id="53" name="Text 16"/>
          <p:cNvSpPr/>
          <p:nvPr/>
        </p:nvSpPr>
        <p:spPr>
          <a:xfrm>
            <a:off x="3666886" y="904068"/>
            <a:ext cx="1159616" cy="247650"/>
          </a:xfrm>
          <a:prstGeom prst="rect">
            <a:avLst/>
          </a:prstGeom>
          <a:noFill/>
          <a:ln/>
        </p:spPr>
        <p:txBody>
          <a:bodyPr wrap="square" lIns="0" tIns="0" rIns="0" bIns="0" rtlCol="0" anchor="t"/>
          <a:lstStyle/>
          <a:p>
            <a:pPr marL="0" indent="0" algn="ctr">
              <a:lnSpc>
                <a:spcPct val="97750"/>
              </a:lnSpc>
              <a:buNone/>
            </a:pPr>
            <a:r>
              <a:rPr lang="en-US" sz="800" b="1" dirty="0">
                <a:solidFill>
                  <a:srgbClr val="000000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MIC for</a:t>
            </a:r>
            <a:endParaRPr lang="en-US" sz="800" dirty="0"/>
          </a:p>
          <a:p>
            <a:pPr marL="0" indent="0" algn="ctr">
              <a:lnSpc>
                <a:spcPct val="97750"/>
              </a:lnSpc>
              <a:buNone/>
            </a:pPr>
            <a:r>
              <a:rPr lang="en-US" sz="800" b="1" dirty="0">
                <a:solidFill>
                  <a:srgbClr val="000000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 Resistant Isolate</a:t>
            </a:r>
            <a:endParaRPr lang="en-US" sz="800" dirty="0"/>
          </a:p>
        </p:txBody>
      </p:sp>
      <p:sp>
        <p:nvSpPr>
          <p:cNvPr id="54" name="Text 17"/>
          <p:cNvSpPr/>
          <p:nvPr/>
        </p:nvSpPr>
        <p:spPr>
          <a:xfrm>
            <a:off x="4826498" y="780242"/>
            <a:ext cx="1159616" cy="371475"/>
          </a:xfrm>
          <a:prstGeom prst="rect">
            <a:avLst/>
          </a:prstGeom>
          <a:noFill/>
          <a:ln/>
        </p:spPr>
        <p:txBody>
          <a:bodyPr wrap="square" lIns="0" tIns="0" rIns="0" bIns="0" rtlCol="0" anchor="t"/>
          <a:lstStyle/>
          <a:p>
            <a:pPr marL="0" indent="0" algn="ctr">
              <a:lnSpc>
                <a:spcPct val="97750"/>
              </a:lnSpc>
              <a:buNone/>
            </a:pPr>
            <a:r>
              <a:rPr lang="en-US" sz="800" b="1" dirty="0">
                <a:solidFill>
                  <a:srgbClr val="000000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Challenge Concentration for </a:t>
            </a:r>
            <a:endParaRPr lang="en-US" sz="800" dirty="0"/>
          </a:p>
          <a:p>
            <a:pPr marL="0" indent="0" algn="ctr">
              <a:lnSpc>
                <a:spcPct val="97750"/>
              </a:lnSpc>
              <a:buNone/>
            </a:pPr>
            <a:r>
              <a:rPr lang="en-US" sz="800" b="1" dirty="0">
                <a:solidFill>
                  <a:srgbClr val="000000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Resistant Isolate</a:t>
            </a:r>
            <a:endParaRPr lang="en-US" sz="800" dirty="0"/>
          </a:p>
        </p:txBody>
      </p:sp>
      <p:sp>
        <p:nvSpPr>
          <p:cNvPr id="55" name="Text 18"/>
          <p:cNvSpPr/>
          <p:nvPr/>
        </p:nvSpPr>
        <p:spPr>
          <a:xfrm>
            <a:off x="7984380" y="780238"/>
            <a:ext cx="1159616" cy="371475"/>
          </a:xfrm>
          <a:prstGeom prst="rect">
            <a:avLst/>
          </a:prstGeom>
          <a:noFill/>
          <a:ln/>
        </p:spPr>
        <p:txBody>
          <a:bodyPr wrap="square" lIns="0" tIns="0" rIns="0" bIns="0" rtlCol="0" anchor="t"/>
          <a:lstStyle/>
          <a:p>
            <a:pPr marL="0" indent="0" algn="ctr">
              <a:lnSpc>
                <a:spcPct val="97750"/>
              </a:lnSpc>
              <a:buNone/>
            </a:pPr>
            <a:r>
              <a:rPr lang="en-US" sz="800" b="1" dirty="0">
                <a:solidFill>
                  <a:srgbClr val="000000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Challenge Concentration for </a:t>
            </a:r>
            <a:endParaRPr lang="en-US" sz="800" dirty="0"/>
          </a:p>
          <a:p>
            <a:pPr marL="0" indent="0" algn="ctr">
              <a:lnSpc>
                <a:spcPct val="97750"/>
              </a:lnSpc>
              <a:buNone/>
            </a:pPr>
            <a:r>
              <a:rPr lang="en-US" sz="800" b="1" dirty="0">
                <a:solidFill>
                  <a:srgbClr val="000000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Susceptible Isolate</a:t>
            </a:r>
            <a:endParaRPr lang="en-US" sz="800" dirty="0"/>
          </a:p>
        </p:txBody>
      </p:sp>
      <p:sp>
        <p:nvSpPr>
          <p:cNvPr id="56" name="Text 19"/>
          <p:cNvSpPr/>
          <p:nvPr/>
        </p:nvSpPr>
        <p:spPr>
          <a:xfrm>
            <a:off x="6870091" y="904066"/>
            <a:ext cx="1159616" cy="247650"/>
          </a:xfrm>
          <a:prstGeom prst="rect">
            <a:avLst/>
          </a:prstGeom>
          <a:noFill/>
          <a:ln/>
        </p:spPr>
        <p:txBody>
          <a:bodyPr wrap="square" lIns="0" tIns="0" rIns="0" bIns="0" rtlCol="0" anchor="t"/>
          <a:lstStyle/>
          <a:p>
            <a:pPr marL="0" indent="0" algn="ctr">
              <a:lnSpc>
                <a:spcPct val="97750"/>
              </a:lnSpc>
              <a:buNone/>
            </a:pPr>
            <a:r>
              <a:rPr lang="en-US" sz="800" b="1" dirty="0">
                <a:solidFill>
                  <a:srgbClr val="000000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MIC for</a:t>
            </a:r>
            <a:endParaRPr lang="en-US" sz="800" dirty="0"/>
          </a:p>
          <a:p>
            <a:pPr marL="0" indent="0" algn="ctr">
              <a:lnSpc>
                <a:spcPct val="97750"/>
              </a:lnSpc>
              <a:buNone/>
            </a:pPr>
            <a:r>
              <a:rPr lang="en-US" sz="800" b="1">
                <a:solidFill>
                  <a:srgbClr val="000000"/>
                </a:solidFill>
                <a:latin typeface="Roboto" pitchFamily="34" charset="0"/>
                <a:ea typeface="Roboto" pitchFamily="34" charset="-122"/>
                <a:cs typeface="Roboto" pitchFamily="34" charset="-120"/>
              </a:rPr>
              <a:t> Susceptible Isolate</a:t>
            </a:r>
            <a:endParaRPr lang="en-US" sz="800" dirty="0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63F6559D-0C2E-A1D5-7DCB-598FD90203BA}"/>
              </a:ext>
            </a:extLst>
          </p:cNvPr>
          <p:cNvSpPr txBox="1"/>
          <p:nvPr/>
        </p:nvSpPr>
        <p:spPr>
          <a:xfrm>
            <a:off x="25304" y="176439"/>
            <a:ext cx="29052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1</a:t>
            </a:r>
          </a:p>
        </p:txBody>
      </p:sp>
    </p:spTree>
    <p:custDataLst>
      <p:tags r:id="rId1"/>
    </p:custData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EXPORTMETHOD" val="pptx_export_from_biorender"/>
  <p:tag name="ILLUSTRATIONID" val="69695d10ed4b5880ee2c709d"/>
  <p:tag name="SLIDEID" val="82468011-4845-45d2-ae7e-533a19310ec4"/>
  <p:tag name="VERSION" val="1770643664268"/>
  <p:tag name="TITLE" val="Broth Dilution"/>
  <p:tag name="CREATORNAME" val="Woubit Abebe"/>
  <p:tag name="DATEINSERTED" val="1770643663814"/>
  <p:tag name="DPI" val="300"/>
  <p:tag name="BIOJSON" val="{&quot;id&quot;:&quot;37e2aa28-cd10-4bfd-92df-0a3c31376c99&quot;,&quot;objects&quot;:{&quot;82468011-4845-45d2-ae7e-533a19310ec4&quot;:{&quot;id&quot;:&quot;82468011-4845-45d2-ae7e-533a19310ec4&quot;,&quot;type&quot;:&quot;FIGURE_OBJECT&quot;,&quot;document&quot;:{&quot;type&quot;:&quot;FIGURE&quot;,&quot;canvasType&quot;:&quot;FIGURE&quot;,&quot;units&quot;:&quot;in&quot;},&quot;parent&quot;:{&quot;parentId&quot;:&quot;37e2aa28-cd10-4bfd-92df-0a3c31376c99&quot;,&quot;type&quot;:&quot;DOCUMENT&quot;,&quot;order&quot;:&quot;5&quot;}},&quot;da22de7d-2127-40ef-a8bc-ab7448d625fc&quot;:{&quot;id&quot;:&quot;da22de7d-2127-40ef-a8bc-ab7448d625fc&quot;,&quot;type&quot;:&quot;FIGURE_OBJECT&quot;,&quot;relativeTransform&quot;:{&quot;translate&quot;:{&quot;x&quot;:0,&quot;y&quot;:0},&quot;rotate&quot;:0,&quot;skewX&quot;:0,&quot;scale&quot;:{&quot;x&quot;:1,&quot;y&quot;:1}},&quot;path&quot;:{&quot;type&quot;:&quot;RECT&quot;,&quot;size&quot;:{&quot;x&quot;:960,&quot;y&quot;:672}},&quot;pathStyles&quot;:[{&quot;type&quot;:&quot;FILL&quot;,&quot;fillStyle&quot;:&quot;rgba(0,0,0,0)&quot;}],&quot;parent&quot;:{&quot;type&quot;:&quot;FRAME&quot;,&quot;parentId&quot;:&quot;82468011-4845-45d2-ae7e-533a19310ec4&quot;,&quot;order&quot;:&quot;5&quot;}},&quot;cf36c8c4-aa3e-43d0-a644-90a4694725cb&quot;:{&quot;id&quot;:&quot;cf36c8c4-aa3e-43d0-a644-90a4694725cb&quot;,&quot;name&quot;:&quot;Test tube (15 mL, 1/2 liquid)&quot;,&quot;displayName&quot;:&quot;&quot;,&quot;type&quot;:&quot;FIGURE_OBJECT&quot;,&quot;relativeTransform&quot;:{&quot;translate&quot;:{&quot;x&quot;:-434.03215895488313,&quot;y&quot;:-5.116172516627941},&quot;rotate&quot;:0,&quot;skewX&quot;:0,&quot;scale&quot;:{&quot;x&quot;:0.7117130970948358,&quot;y&quot;:0.7117130970948358}},&quot;image&quot;:{&quot;url&quot;:&quot;https://icons.cdn.biorender.com/biorender/5e56940cc45c7c0028ca1e8e/20200226201646/image/5e56940cc45c7c0028ca1e8e.png&quot;,&quot;isPremium&quot;:true,&quot;isOrgIcon&quot;:false,&quot;size&quot;:{&quot;x&quot;:50,&quot;y&quot;:222.80701754385964}},&quot;source&quot;:{&quot;id&quot;:&quot;5e56940cc45c7c0028ca1e8e&quot;,&quot;version&quot;:&quot;20200226201646&quot;,&quot;type&quot;:&quot;ASSETS&quot;},&quot;isPremium&quot;:true,&quot;parent&quot;:{&quot;type&quot;:&quot;CHILD&quot;,&quot;parentId&quot;:&quot;82468011-4845-45d2-ae7e-533a19310ec4&quot;,&quot;order&quot;:&quot;5&quot;}},&quot;78fa19c9-0fb4-4a8f-87f2-0a9175bf6932&quot;:{&quot;id&quot;:&quot;78fa19c9-0fb4-4a8f-87f2-0a9175bf6932&quot;,&quot;name&quot;:&quot;Test tube (15 mL, 1/2 liquid)&quot;,&quot;displayName&quot;:&quot;&quot;,&quot;type&quot;:&quot;FIGURE_OBJECT&quot;,&quot;relativeTransform&quot;:{&quot;translate&quot;:{&quot;x&quot;:-376.26729982016894,&quot;y&quot;:-5.116172516627941},&quot;rotate&quot;:0,&quot;skewX&quot;:0,&quot;scale&quot;:{&quot;x&quot;:0.7117130970948358,&quot;y&quot;:0.7117130970948358}},&quot;image&quot;:{&quot;url&quot;:&quot;https://icons.cdn.biorender.com/biorender/5e56940cc45c7c0028ca1e8e/20200226201646/image/5e56940cc45c7c0028ca1e8e.png&quot;,&quot;isPremium&quot;:true,&quot;isOrgIcon&quot;:false,&quot;size&quot;:{&quot;x&quot;:50,&quot;y&quot;:222.80701754385964}},&quot;source&quot;:{&quot;id&quot;:&quot;5e56940cc45c7c0028ca1e8e&quot;,&quot;version&quot;:&quot;20200226201646&quot;,&quot;type&quot;:&quot;ASSETS&quot;},&quot;isPremium&quot;:true,&quot;parent&quot;:{&quot;type&quot;:&quot;CHILD&quot;,&quot;parentId&quot;:&quot;82468011-4845-45d2-ae7e-533a19310ec4&quot;,&quot;order&quot;:&quot;7&quot;}},&quot;6a9335cd-e90e-4d88-922c-1cdf951865e1&quot;:{&quot;id&quot;:&quot;6a9335cd-e90e-4d88-922c-1cdf951865e1&quot;,&quot;name&quot;:&quot;Test tube (15 mL, 1/2 liquid)&quot;,&quot;displayName&quot;:&quot;&quot;,&quot;type&quot;:&quot;FIGURE_OBJECT&quot;,&quot;relativeTransform&quot;:{&quot;translate&quot;:{&quot;x&quot;:-318.5024406854547,&quot;y&quot;:-5.116172516627941},&quot;rotate&quot;:0,&quot;skewX&quot;:0,&quot;scale&quot;:{&quot;x&quot;:0.7117130970948358,&quot;y&quot;:0.7117130970948358}},&quot;image&quot;:{&quot;url&quot;:&quot;https://icons.cdn.biorender.com/biorender/5e56940cc45c7c0028ca1e8e/20200226201646/image/5e56940cc45c7c0028ca1e8e.png&quot;,&quot;isPremium&quot;:true,&quot;isOrgIcon&quot;:false,&quot;size&quot;:{&quot;x&quot;:50,&quot;y&quot;:222.80701754385964}},&quot;source&quot;:{&quot;id&quot;:&quot;5e56940cc45c7c0028ca1e8e&quot;,&quot;version&quot;:&quot;20200226201646&quot;,&quot;type&quot;:&quot;ASSETS&quot;},&quot;isPremium&quot;:true,&quot;parent&quot;:{&quot;type&quot;:&quot;CHILD&quot;,&quot;parentId&quot;:&quot;82468011-4845-45d2-ae7e-533a19310ec4&quot;,&quot;order&quot;:&quot;8&quot;}},&quot;0b37dd97-e04e-4356-aa32-b239824caa69&quot;:{&quot;id&quot;:&quot;0b37dd97-e04e-4356-aa32-b239824caa69&quot;,&quot;name&quot;:&quot;Test tube (15 mL, 1/2 liquid)&quot;,&quot;displayName&quot;:&quot;&quot;,&quot;type&quot;:&quot;FIGURE_OBJECT&quot;,&quot;relativeTransform&quot;:{&quot;translate&quot;:{&quot;x&quot;:-260.73758155074046,&quot;y&quot;:-5.116172516627941},&quot;rotate&quot;:0,&quot;skewX&quot;:0,&quot;scale&quot;:{&quot;x&quot;:0.7117130970948358,&quot;y&quot;:0.7117130970948358}},&quot;image&quot;:{&quot;url&quot;:&quot;https://icons.cdn.biorender.com/biorender/5e56940cc45c7c0028ca1e8e/20200226201646/image/5e56940cc45c7c0028ca1e8e.png&quot;,&quot;isPremium&quot;:true,&quot;isOrgIcon&quot;:false,&quot;size&quot;:{&quot;x&quot;:50,&quot;y&quot;:222.80701754385964}},&quot;source&quot;:{&quot;id&quot;:&quot;5e56940cc45c7c0028ca1e8e&quot;,&quot;version&quot;:&quot;20200226201646&quot;,&quot;type&quot;:&quot;ASSETS&quot;},&quot;isPremium&quot;:true,&quot;parent&quot;:{&quot;type&quot;:&quot;CHILD&quot;,&quot;parentId&quot;:&quot;82468011-4845-45d2-ae7e-533a19310ec4&quot;,&quot;order&quot;:&quot;9&quot;}},&quot;67b17e74-ab3d-4e8b-a984-fd36db41f6f8&quot;:{&quot;id&quot;:&quot;67b17e74-ab3d-4e8b-a984-fd36db41f6f8&quot;,&quot;name&quot;:&quot;Test tube (15 mL, 1/2 liquid)&quot;,&quot;displayName&quot;:&quot;&quot;,&quot;type&quot;:&quot;FIGURE_OBJECT&quot;,&quot;relativeTransform&quot;:{&quot;translate&quot;:{&quot;x&quot;:-202.97272241602622,&quot;y&quot;:-5.116172516627941},&quot;rotate&quot;:0,&quot;skewX&quot;:0,&quot;scale&quot;:{&quot;x&quot;:0.7117130970948358,&quot;y&quot;:0.7117130970948358}},&quot;image&quot;:{&quot;url&quot;:&quot;https://icons.cdn.biorender.com/biorender/5e56940cc45c7c0028ca1e8e/20200226201646/image/5e56940cc45c7c0028ca1e8e.png&quot;,&quot;isPremium&quot;:true,&quot;isOrgIcon&quot;:false,&quot;size&quot;:{&quot;x&quot;:50,&quot;y&quot;:222.80701754385964}},&quot;source&quot;:{&quot;id&quot;:&quot;5e56940cc45c7c0028ca1e8e&quot;,&quot;version&quot;:&quot;20200226201646&quot;,&quot;type&quot;:&quot;ASSETS&quot;},&quot;isPremium&quot;:true,&quot;parent&quot;:{&quot;type&quot;:&quot;CHILD&quot;,&quot;parentId&quot;:&quot;82468011-4845-45d2-ae7e-533a19310ec4&quot;,&quot;order&quot;:&quot;95&quot;}},&quot;39852c83-a520-4f03-9f46-4023d9eec63d&quot;:{&quot;id&quot;:&quot;39852c83-a520-4f03-9f46-4023d9eec63d&quot;,&quot;name&quot;:&quot;Test tube (15 mL, 1/2 liquid)&quot;,&quot;displayName&quot;:&quot;&quot;,&quot;type&quot;:&quot;FIGURE_OBJECT&quot;,&quot;relativeTransform&quot;:{&quot;translate&quot;:{&quot;x&quot;:-145.20786328131192,&quot;y&quot;:-5.116172516627941},&quot;rotate&quot;:0,&quot;skewX&quot;:0,&quot;scale&quot;:{&quot;x&quot;:0.7117130970948358,&quot;y&quot;:0.7117130970948358}},&quot;image&quot;:{&quot;url&quot;:&quot;https://icons.cdn.biorender.com/biorender/5e56940cc45c7c0028ca1e8e/20200226201646/image/5e56940cc45c7c0028ca1e8e.png&quot;,&quot;isPremium&quot;:true,&quot;isOrgIcon&quot;:false,&quot;size&quot;:{&quot;x&quot;:50,&quot;y&quot;:222.80701754385964}},&quot;source&quot;:{&quot;id&quot;:&quot;5e56940cc45c7c0028ca1e8e&quot;,&quot;version&quot;:&quot;20200226201646&quot;,&quot;type&quot;:&quot;ASSETS&quot;},&quot;isPremium&quot;:true,&quot;parent&quot;:{&quot;type&quot;:&quot;CHILD&quot;,&quot;parentId&quot;:&quot;82468011-4845-45d2-ae7e-533a19310ec4&quot;,&quot;order&quot;:&quot;97&quot;}},&quot;095d73bd-c1af-47a2-998d-d0076639d65e&quot;:{&quot;id&quot;:&quot;095d73bd-c1af-47a2-998d-d0076639d65e&quot;,&quot;name&quot;:&quot;Test tube (15 mL, 1/2 liquid)&quot;,&quot;displayName&quot;:&quot;&quot;,&quot;type&quot;:&quot;FIGURE_OBJECT&quot;,&quot;relativeTransform&quot;:{&quot;translate&quot;:{&quot;x&quot;:-87.44300414659763,&quot;y&quot;:-5.116172516627941},&quot;rotate&quot;:0,&quot;skewX&quot;:0,&quot;scale&quot;:{&quot;x&quot;:0.7117130970948358,&quot;y&quot;:0.7117130970948358}},&quot;image&quot;:{&quot;url&quot;:&quot;https://icons.cdn.biorender.com/biorender/5e56940cc45c7c0028ca1e8e/20200226201646/image/5e56940cc45c7c0028ca1e8e.png&quot;,&quot;isPremium&quot;:true,&quot;isOrgIcon&quot;:false,&quot;size&quot;:{&quot;x&quot;:50,&quot;y&quot;:222.80701754385964}},&quot;source&quot;:{&quot;id&quot;:&quot;5e56940cc45c7c0028ca1e8e&quot;,&quot;version&quot;:&quot;20200226201646&quot;,&quot;type&quot;:&quot;ASSETS&quot;},&quot;isPremium&quot;:true,&quot;parent&quot;:{&quot;type&quot;:&quot;CHILD&quot;,&quot;parentId&quot;:&quot;82468011-4845-45d2-ae7e-533a19310ec4&quot;,&quot;order&quot;:&quot;98&quot;}},&quot;ee0e74b2-7555-4a69-8667-0159acef5664&quot;:{&quot;id&quot;:&quot;ee0e74b2-7555-4a69-8667-0159acef5664&quot;,&quot;name&quot;:&quot;Test tube (15 mL, 1/2 liquid)&quot;,&quot;displayName&quot;:&quot;&quot;,&quot;type&quot;:&quot;FIGURE_OBJECT&quot;,&quot;relativeTransform&quot;:{&quot;translate&quot;:{&quot;x&quot;:-29.6781450118834,&quot;y&quot;:-5.116172516627941},&quot;rotate&quot;:0,&quot;skewX&quot;:0,&quot;scale&quot;:{&quot;x&quot;:0.7117130970948358,&quot;y&quot;:0.7117130970948358}},&quot;image&quot;:{&quot;url&quot;:&quot;https://icons.cdn.biorender.com/biorender/5e56940cc45c7c0028ca1e8e/20200226201646/image/5e56940cc45c7c0028ca1e8e.png&quot;,&quot;isPremium&quot;:true,&quot;isOrgIcon&quot;:false,&quot;size&quot;:{&quot;x&quot;:50,&quot;y&quot;:222.80701754385964}},&quot;source&quot;:{&quot;id&quot;:&quot;5e56940cc45c7c0028ca1e8e&quot;,&quot;version&quot;:&quot;20200226201646&quot;,&quot;type&quot;:&quot;ASSETS&quot;},&quot;isPremium&quot;:true,&quot;parent&quot;:{&quot;type&quot;:&quot;CHILD&quot;,&quot;parentId&quot;:&quot;82468011-4845-45d2-ae7e-533a19310ec4&quot;,&quot;order&quot;:&quot;99&quot;}},&quot;401e99b0-db7f-47f1-92e1-9a088688b26c&quot;:{&quot;id&quot;:&quot;401e99b0-db7f-47f1-92e1-9a088688b26c&quot;,&quot;name&quot;:&quot;Test tube (15 mL, 1/2 liquid)&quot;,&quot;displayName&quot;:&quot;&quot;,&quot;type&quot;:&quot;FIGURE_OBJECT&quot;,&quot;relativeTransform&quot;:{&quot;translate&quot;:{&quot;x&quot;:28.086714122830855,&quot;y&quot;:-5.116172516627941},&quot;rotate&quot;:0,&quot;skewX&quot;:0,&quot;scale&quot;:{&quot;x&quot;:0.7117130970948358,&quot;y&quot;:0.7117130970948358}},&quot;image&quot;:{&quot;url&quot;:&quot;https://icons.cdn.biorender.com/biorender/5e56940cc45c7c0028ca1e8e/20200226201646/image/5e56940cc45c7c0028ca1e8e.png&quot;,&quot;isPremium&quot;:true,&quot;isOrgIcon&quot;:false,&quot;size&quot;:{&quot;x&quot;:50,&quot;y&quot;:222.80701754385964}},&quot;source&quot;:{&quot;id&quot;:&quot;5e56940cc45c7c0028ca1e8e&quot;,&quot;version&quot;:&quot;20200226201646&quot;,&quot;type&quot;:&quot;ASSETS&quot;},&quot;isPremium&quot;:true,&quot;parent&quot;:{&quot;type&quot;:&quot;CHILD&quot;,&quot;parentId&quot;:&quot;82468011-4845-45d2-ae7e-533a19310ec4&quot;,&quot;order&quot;:&quot;995&quot;}},&quot;c5a4bf77-e8e0-4e41-8007-e2aa10b63c49&quot;:{&quot;id&quot;:&quot;c5a4bf77-e8e0-4e41-8007-e2aa10b63c49&quot;,&quot;name&quot;:&quot;Test tube (15 mL, 1/2 liquid)&quot;,&quot;displayName&quot;:&quot;&quot;,&quot;type&quot;:&quot;FIGURE_OBJECT&quot;,&quot;relativeTransform&quot;:{&quot;translate&quot;:{&quot;x&quot;:85.85157325754513,&quot;y&quot;:-5.116172516627941},&quot;rotate&quot;:0,&quot;skewX&quot;:0,&quot;scale&quot;:{&quot;x&quot;:0.7117130970948358,&quot;y&quot;:0.7117130970948358}},&quot;image&quot;:{&quot;url&quot;:&quot;https://icons.cdn.biorender.com/biorender/5e56940cc45c7c0028ca1e8e/20200226201646/image/5e56940cc45c7c0028ca1e8e.png&quot;,&quot;isPremium&quot;:true,&quot;isOrgIcon&quot;:false,&quot;size&quot;:{&quot;x&quot;:50,&quot;y&quot;:222.80701754385964}},&quot;source&quot;:{&quot;id&quot;:&quot;5e56940cc45c7c0028ca1e8e&quot;,&quot;version&quot;:&quot;20200226201646&quot;,&quot;type&quot;:&quot;ASSETS&quot;},&quot;isPremium&quot;:true,&quot;parent&quot;:{&quot;type&quot;:&quot;CHILD&quot;,&quot;parentId&quot;:&quot;82468011-4845-45d2-ae7e-533a19310ec4&quot;,&quot;order&quot;:&quot;997&quot;}},&quot;fe06d0bc-52a5-4cf2-b4f4-de62190afb85&quot;:{&quot;id&quot;:&quot;fe06d0bc-52a5-4cf2-b4f4-de62190afb85&quot;,&quot;name&quot;:&quot;Test tube (15 mL, 1/2 liquid)&quot;,&quot;displayName&quot;:&quot;&quot;,&quot;type&quot;:&quot;FIGURE_OBJECT&quot;,&quot;relativeTransform&quot;:{&quot;translate&quot;:{&quot;x&quot;:143.61643239225936,&quot;y&quot;:-5.116172516627941},&quot;rotate&quot;:0,&quot;skewX&quot;:0,&quot;scale&quot;:{&quot;x&quot;:0.7117130970948358,&quot;y&quot;:0.7117130970948358}},&quot;image&quot;:{&quot;url&quot;:&quot;https://icons.cdn.biorender.com/biorender/5e56940cc45c7c0028ca1e8e/20200226201646/image/5e56940cc45c7c0028ca1e8e.png&quot;,&quot;isPremium&quot;:true,&quot;isOrgIcon&quot;:false,&quot;size&quot;:{&quot;x&quot;:50,&quot;y&quot;:222.80701754385964}},&quot;source&quot;:{&quot;id&quot;:&quot;5e56940cc45c7c0028ca1e8e&quot;,&quot;version&quot;:&quot;20200226201646&quot;,&quot;type&quot;:&quot;ASSETS&quot;},&quot;isPremium&quot;:true,&quot;parent&quot;:{&quot;type&quot;:&quot;CHILD&quot;,&quot;parentId&quot;:&quot;82468011-4845-45d2-ae7e-533a19310ec4&quot;,&quot;order&quot;:&quot;998&quot;}},&quot;814d49dc-236e-416f-958d-838cc5adf3db&quot;:{&quot;id&quot;:&quot;814d49dc-236e-416f-958d-838cc5adf3db&quot;,&quot;name&quot;:&quot;Test tube (15 mL, 1/2 liquid)&quot;,&quot;displayName&quot;:&quot;&quot;,&quot;type&quot;:&quot;FIGURE_OBJECT&quot;,&quot;relativeTransform&quot;:{&quot;translate&quot;:{&quot;x&quot;:201.38129152697365,&quot;y&quot;:-5.116172516627941},&quot;rotate&quot;:0,&quot;skewX&quot;:0,&quot;scale&quot;:{&quot;x&quot;:0.7117130970948358,&quot;y&quot;:0.7117130970948358}},&quot;image&quot;:{&quot;url&quot;:&quot;https://icons.cdn.biorender.com/biorender/5e56940cc45c7c0028ca1e8e/20200226201646/image/5e56940cc45c7c0028ca1e8e.png&quot;,&quot;isPremium&quot;:true,&quot;isOrgIcon&quot;:false,&quot;size&quot;:{&quot;x&quot;:50,&quot;y&quot;:222.80701754385964}},&quot;source&quot;:{&quot;id&quot;:&quot;5e56940cc45c7c0028ca1e8e&quot;,&quot;version&quot;:&quot;20200226201646&quot;,&quot;type&quot;:&quot;ASSETS&quot;},&quot;isPremium&quot;:true,&quot;parent&quot;:{&quot;type&quot;:&quot;CHILD&quot;,&quot;parentId&quot;:&quot;82468011-4845-45d2-ae7e-533a19310ec4&quot;,&quot;order&quot;:&quot;999&quot;}},&quot;db077e4d-a26c-4d2b-a647-b477e5f45157&quot;:{&quot;id&quot;:&quot;db077e4d-a26c-4d2b-a647-b477e5f45157&quot;,&quot;name&quot;:&quot;Test tube (15 mL, 1/2 liquid)&quot;,&quot;displayName&quot;:&quot;&quot;,&quot;type&quot;:&quot;FIGURE_OBJECT&quot;,&quot;relativeTransform&quot;:{&quot;translate&quot;:{&quot;x&quot;:259.1461506616879,&quot;y&quot;:-5.116172516627941},&quot;rotate&quot;:0,&quot;skewX&quot;:0,&quot;scale&quot;:{&quot;x&quot;:0.7117130970948358,&quot;y&quot;:0.7117130970948358}},&quot;image&quot;:{&quot;url&quot;:&quot;https://icons.cdn.biorender.com/biorender/5e56940cc45c7c0028ca1e8e/20200226201646/image/5e56940cc45c7c0028ca1e8e.png&quot;,&quot;isPremium&quot;:true,&quot;isOrgIcon&quot;:false,&quot;size&quot;:{&quot;x&quot;:50,&quot;y&quot;:222.80701754385964}},&quot;source&quot;:{&quot;id&quot;:&quot;5e56940cc45c7c0028ca1e8e&quot;,&quot;version&quot;:&quot;20200226201646&quot;,&quot;type&quot;:&quot;ASSETS&quot;},&quot;isPremium&quot;:true,&quot;parent&quot;:{&quot;type&quot;:&quot;CHILD&quot;,&quot;parentId&quot;:&quot;82468011-4845-45d2-ae7e-533a19310ec4&quot;,&quot;order&quot;:&quot;9995&quot;}},&quot;d69a8487-0e56-4698-a021-c90245988433&quot;:{&quot;id&quot;:&quot;d69a8487-0e56-4698-a021-c90245988433&quot;,&quot;name&quot;:&quot;Test tube (15 mL, 1/2 liquid)&quot;,&quot;displayName&quot;:&quot;&quot;,&quot;type&quot;:&quot;FIGURE_OBJECT&quot;,&quot;relativeTransform&quot;:{&quot;translate&quot;:{&quot;x&quot;:316.91100979640214,&quot;y&quot;:-5.116172516627941},&quot;rotate&quot;:0,&quot;skewX&quot;:0,&quot;scale&quot;:{&quot;x&quot;:0.7117130970948358,&quot;y&quot;:0.7117130970948358}},&quot;image&quot;:{&quot;url&quot;:&quot;https://icons.cdn.biorender.com/biorender/5e56940cc45c7c0028ca1e8e/20200226201646/image/5e56940cc45c7c0028ca1e8e.png&quot;,&quot;isPremium&quot;:true,&quot;isOrgIcon&quot;:false,&quot;size&quot;:{&quot;x&quot;:50,&quot;y&quot;:222.80701754385964}},&quot;source&quot;:{&quot;id&quot;:&quot;5e56940cc45c7c0028ca1e8e&quot;,&quot;version&quot;:&quot;20200226201646&quot;,&quot;type&quot;:&quot;ASSETS&quot;},&quot;isPremium&quot;:true,&quot;parent&quot;:{&quot;type&quot;:&quot;CHILD&quot;,&quot;parentId&quot;:&quot;82468011-4845-45d2-ae7e-533a19310ec4&quot;,&quot;order&quot;:&quot;9997&quot;}},&quot;a5ff86f5-a462-4280-965a-b119be7f14b6&quot;:{&quot;id&quot;:&quot;a5ff86f5-a462-4280-965a-b119be7f14b6&quot;,&quot;name&quot;:&quot;Test tube (15 mL, 1/2 liquid)&quot;,&quot;displayName&quot;:&quot;&quot;,&quot;type&quot;:&quot;FIGURE_OBJECT&quot;,&quot;relativeTransform&quot;:{&quot;translate&quot;:{&quot;x&quot;:374.6758689311164,&quot;y&quot;:-5.116172516627941},&quot;rotate&quot;:0,&quot;skewX&quot;:0,&quot;scale&quot;:{&quot;x&quot;:0.7117130970948358,&quot;y&quot;:0.7117130970948358}},&quot;image&quot;:{&quot;url&quot;:&quot;https://icons.cdn.biorender.com/biorender/5e56940cc45c7c0028ca1e8e/20200226201646/image/5e56940cc45c7c0028ca1e8e.png&quot;,&quot;isPremium&quot;:true,&quot;isOrgIcon&quot;:false,&quot;size&quot;:{&quot;x&quot;:50,&quot;y&quot;:222.80701754385964}},&quot;source&quot;:{&quot;id&quot;:&quot;5e56940cc45c7c0028ca1e8e&quot;,&quot;version&quot;:&quot;20200226201646&quot;,&quot;type&quot;:&quot;ASSETS&quot;},&quot;isPremium&quot;:true,&quot;parent&quot;:{&quot;type&quot;:&quot;CHILD&quot;,&quot;parentId&quot;:&quot;82468011-4845-45d2-ae7e-533a19310ec4&quot;,&quot;order&quot;:&quot;9998&quot;}},&quot;4488bf75-7dc2-4237-8de6-24bdc3f4461f&quot;:{&quot;id&quot;:&quot;4488bf75-7dc2-4237-8de6-24bdc3f4461f&quot;,&quot;name&quot;:&quot;Test tube (15 mL, 1/2 liquid)&quot;,&quot;displayName&quot;:&quot;&quot;,&quot;type&quot;:&quot;FIGURE_OBJECT&quot;,&quot;relativeTransform&quot;:{&quot;translate&quot;:{&quot;x&quot;:432.4407280658307,&quot;y&quot;:-5.116172516627941},&quot;rotate&quot;:0,&quot;skewX&quot;:0,&quot;scale&quot;:{&quot;x&quot;:0.7117130970948358,&quot;y&quot;:0.7117130970948358}},&quot;image&quot;:{&quot;url&quot;:&quot;https://icons.cdn.biorender.com/biorender/5e56940cc45c7c0028ca1e8e/20200226201646/image/5e56940cc45c7c0028ca1e8e.png&quot;,&quot;isPremium&quot;:true,&quot;isOrgIcon&quot;:false,&quot;size&quot;:{&quot;x&quot;:50,&quot;y&quot;:222.80701754385964}},&quot;source&quot;:{&quot;id&quot;:&quot;5e56940cc45c7c0028ca1e8e&quot;,&quot;version&quot;:&quot;20200226201646&quot;,&quot;type&quot;:&quot;ASSETS&quot;},&quot;isPremium&quot;:true,&quot;parent&quot;:{&quot;type&quot;:&quot;CHILD&quot;,&quot;parentId&quot;:&quot;82468011-4845-45d2-ae7e-533a19310ec4&quot;,&quot;order&quot;:&quot;9999&quot;}},&quot;0028617d-a82a-49d7-970b-86fef4cd201d&quot;:{&quot;id&quot;:&quot;0028617d-a82a-49d7-970b-86fef4cd201d&quot;,&quot;type&quot;:&quot;FIGURE_OBJECT&quot;,&quot;relativeTransform&quot;:{&quot;translate&quot;:{&quot;x&quot;:-429.4928123867762,&quot;y&quot;:98.42534901658448},&quot;rotate&quot;:0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9.23357616032368,&quot;color&quot;:&quot;black&quot;,&quot;fontWeight&quot;:&quot;bold&quot;,&quot;fontStyle&quot;:&quot;normal&quot;,&quot;decoration&quot;:&quot;none&quot;},&quot;range&quot;:[0,7]}],&quot;text&quot;:&quot;250ug/ul&quot;}],&quot;_lastCaretLocation&quot;:{&quot;lineIndex&quot;:0,&quot;runIndex&quot;:-1,&quot;charIndex&quot;:-1,&quot;endOfLine&quot;:true}},&quot;format&quot;:&quot;BETTER_TEXT&quot;,&quot;size&quot;:{&quot;x&quot;:47.28437522644744,&quot;y&quot;:21.92974338076874},&quot;targetSize&quot;:{&quot;x&quot;:47.28437522644744,&quot;y&quot;:21.92974338076874}},&quot;parent&quot;:{&quot;type&quot;:&quot;CHILD&quot;,&quot;parentId&quot;:&quot;82468011-4845-45d2-ae7e-533a19310ec4&quot;,&quot;order&quot;:&quot;99998&quot;}},&quot;243de54f-6f6c-4bc5-8d15-3a3b1f5e26bd&quot;:{&quot;id&quot;:&quot;243de54f-6f6c-4bc5-8d15-3a3b1f5e26bd&quot;,&quot;type&quot;:&quot;FIGURE_OBJECT&quot;,&quot;relativeTransform&quot;:{&quot;translate&quot;:{&quot;x&quot;:-370.4175463100454,&quot;y&quot;:98.42534901658448},&quot;rotate&quot;:0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9.23357616032368,&quot;color&quot;:&quot;black&quot;,&quot;fontWeight&quot;:&quot;bold&quot;,&quot;fontStyle&quot;:&quot;normal&quot;,&quot;decoration&quot;:&quot;none&quot;},&quot;range&quot;:[0,7]}],&quot;text&quot;:&quot;125ug/ul&quot;}],&quot;_lastCaretLocation&quot;:{&quot;lineIndex&quot;:0,&quot;runIndex&quot;:0,&quot;charIndex&quot;:3}},&quot;format&quot;:&quot;BETTER_TEXT&quot;,&quot;size&quot;:{&quot;x&quot;:47.28437522644744,&quot;y&quot;:21.92974338076874},&quot;targetSize&quot;:{&quot;x&quot;:47.28437522644744,&quot;y&quot;:21.92974338076874}},&quot;parent&quot;:{&quot;type&quot;:&quot;CHILD&quot;,&quot;parentId&quot;:&quot;82468011-4845-45d2-ae7e-533a19310ec4&quot;,&quot;order&quot;:&quot;99999&quot;}},&quot;39a2c20b-6631-4d92-b1bb-3a5c15e800fe&quot;:{&quot;id&quot;:&quot;39a2c20b-6631-4d92-b1bb-3a5c15e800fe&quot;,&quot;type&quot;:&quot;FIGURE_OBJECT&quot;,&quot;relativeTransform&quot;:{&quot;translate&quot;:{&quot;x&quot;:-312.65344804808046,&quot;y&quot;:98.42534901658448},&quot;rotate&quot;:0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9.23357616032368,&quot;color&quot;:&quot;black&quot;,&quot;fontWeight&quot;:&quot;bold&quot;,&quot;fontStyle&quot;:&quot;normal&quot;,&quot;decoration&quot;:&quot;none&quot;},&quot;range&quot;:[0,8]}],&quot;text&quot;:&quot;62.5ug/ul&quot;}],&quot;_lastCaretLocation&quot;:{&quot;lineIndex&quot;:0,&quot;runIndex&quot;:0,&quot;charIndex&quot;:4}},&quot;format&quot;:&quot;BETTER_TEXT&quot;,&quot;size&quot;:{&quot;x&quot;:47.28437522644744,&quot;y&quot;:21.92974338076874},&quot;targetSize&quot;:{&quot;x&quot;:47.28437522644744,&quot;y&quot;:21.92974338076874}},&quot;parent&quot;:{&quot;type&quot;:&quot;CHILD&quot;,&quot;parentId&quot;:&quot;82468011-4845-45d2-ae7e-533a19310ec4&quot;,&quot;order&quot;:&quot;999995&quot;}},&quot;38865a9e-db12-4ad4-8ac4-328cad0ba19d&quot;:{&quot;id&quot;:&quot;38865a9e-db12-4ad4-8ac4-328cad0ba19d&quot;,&quot;type&quot;:&quot;FIGURE_OBJECT&quot;,&quot;relativeTransform&quot;:{&quot;translate&quot;:{&quot;x&quot;:-254.88819558909557,&quot;y&quot;:98.42534901658448},&quot;rotate&quot;:0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9.23357616032368,&quot;color&quot;:&quot;black&quot;,&quot;fontWeight&quot;:&quot;bold&quot;,&quot;fontStyle&quot;:&quot;normal&quot;,&quot;decoration&quot;:&quot;none&quot;},&quot;range&quot;:[0,9]}],&quot;text&quot;:&quot;31.25ug/ul&quot;}],&quot;_lastCaretLocation&quot;:{&quot;lineIndex&quot;:0,&quot;runIndex&quot;:0,&quot;charIndex&quot;:5}},&quot;format&quot;:&quot;BETTER_TEXT&quot;,&quot;size&quot;:{&quot;x&quot;:47.28437522644744,&quot;y&quot;:21.92974338076874},&quot;targetSize&quot;:{&quot;x&quot;:47.28437522644744,&quot;y&quot;:21.92974338076874}},&quot;parent&quot;:{&quot;type&quot;:&quot;CHILD&quot;,&quot;parentId&quot;:&quot;82468011-4845-45d2-ae7e-533a19310ec4&quot;,&quot;order&quot;:&quot;999997&quot;}},&quot;161fda7e-912d-4bd6-9610-efb86e12f955&quot;:{&quot;id&quot;:&quot;161fda7e-912d-4bd6-9610-efb86e12f955&quot;,&quot;type&quot;:&quot;FIGURE_OBJECT&quot;,&quot;relativeTransform&quot;:{&quot;translate&quot;:{&quot;x&quot;:-197.12294313011063,&quot;y&quot;:98.42534901658448},&quot;rotate&quot;:0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9.23357616032368,&quot;color&quot;:&quot;black&quot;,&quot;fontWeight&quot;:&quot;bold&quot;,&quot;fontStyle&quot;:&quot;normal&quot;,&quot;decoration&quot;:&quot;none&quot;},&quot;range&quot;:[0,9]}],&quot;text&quot;:&quot;15.63ug/ul&quot;}],&quot;_lastCaretLocation&quot;:{&quot;lineIndex&quot;:0,&quot;runIndex&quot;:0,&quot;charIndex&quot;:5}},&quot;format&quot;:&quot;BETTER_TEXT&quot;,&quot;size&quot;:{&quot;x&quot;:47.28437522644744,&quot;y&quot;:21.92974338076874},&quot;targetSize&quot;:{&quot;x&quot;:47.28437522644744,&quot;y&quot;:21.92974338076874}},&quot;parent&quot;:{&quot;type&quot;:&quot;CHILD&quot;,&quot;parentId&quot;:&quot;82468011-4845-45d2-ae7e-533a19310ec4&quot;,&quot;order&quot;:&quot;999998&quot;}},&quot;3abad900-a7b5-4e77-99b1-ce4aa55cb070&quot;:{&quot;id&quot;:&quot;3abad900-a7b5-4e77-99b1-ce4aa55cb070&quot;,&quot;type&quot;:&quot;FIGURE_OBJECT&quot;,&quot;relativeTransform&quot;:{&quot;translate&quot;:{&quot;x&quot;:-139.3588448681457,&quot;y&quot;:98.42534901658448},&quot;rotate&quot;:0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9.23357616032368,&quot;color&quot;:&quot;black&quot;,&quot;fontWeight&quot;:&quot;bold&quot;,&quot;fontStyle&quot;:&quot;normal&quot;,&quot;decoration&quot;:&quot;none&quot;},&quot;range&quot;:[0,8]}],&quot;text&quot;:&quot;7.81ug/ul&quot;}],&quot;_lastCaretLocation&quot;:{&quot;lineIndex&quot;:0,&quot;runIndex&quot;:0,&quot;charIndex&quot;:4}},&quot;format&quot;:&quot;BETTER_TEXT&quot;,&quot;size&quot;:{&quot;x&quot;:47.28437522644744,&quot;y&quot;:21.92974338076874},&quot;targetSize&quot;:{&quot;x&quot;:47.28437522644744,&quot;y&quot;:21.92974338076874}},&quot;parent&quot;:{&quot;type&quot;:&quot;CHILD&quot;,&quot;parentId&quot;:&quot;82468011-4845-45d2-ae7e-533a19310ec4&quot;,&quot;order&quot;:&quot;999999&quot;}},&quot;a797ac97-4ddb-44d9-a2d5-93795d0ffdb6&quot;:{&quot;id&quot;:&quot;a797ac97-4ddb-44d9-a2d5-93795d0ffdb6&quot;,&quot;type&quot;:&quot;FIGURE_OBJECT&quot;,&quot;relativeTransform&quot;:{&quot;translate&quot;:{&quot;x&quot;:-81.59359240916076,&quot;y&quot;:98.42534901658448},&quot;rotate&quot;:0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9.23357616032368,&quot;color&quot;:&quot;black&quot;,&quot;fontWeight&quot;:&quot;bold&quot;,&quot;fontStyle&quot;:&quot;normal&quot;,&quot;decoration&quot;:&quot;none&quot;},&quot;range&quot;:[0,8]}],&quot;text&quot;:&quot;3.91ug/ul&quot;}],&quot;_lastCaretLocation&quot;:{&quot;lineIndex&quot;:0,&quot;runIndex&quot;:0,&quot;charIndex&quot;:4}},&quot;format&quot;:&quot;BETTER_TEXT&quot;,&quot;size&quot;:{&quot;x&quot;:47.28437522644744,&quot;y&quot;:21.92974338076874},&quot;targetSize&quot;:{&quot;x&quot;:47.28437522644744,&quot;y&quot;:21.92974338076874}},&quot;parent&quot;:{&quot;type&quot;:&quot;CHILD&quot;,&quot;parentId&quot;:&quot;82468011-4845-45d2-ae7e-533a19310ec4&quot;,&quot;order&quot;:&quot;9999995&quot;}},&quot;b55f0993-d591-463c-8a79-bb19284b4a0f&quot;:{&quot;id&quot;:&quot;b55f0993-d591-463c-8a79-bb19284b4a0f&quot;,&quot;type&quot;:&quot;FIGURE_OBJECT&quot;,&quot;relativeTransform&quot;:{&quot;translate&quot;:{&quot;x&quot;:-23.828339950175817,&quot;y&quot;:98.42534901658448},&quot;rotate&quot;:0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9.23357616032368,&quot;color&quot;:&quot;black&quot;,&quot;fontWeight&quot;:&quot;bold&quot;,&quot;fontStyle&quot;:&quot;normal&quot;,&quot;decoration&quot;:&quot;none&quot;},&quot;range&quot;:[0,8]}],&quot;text&quot;:&quot;1.95ug/ul&quot;}],&quot;_lastCaretLocation&quot;:{&quot;lineIndex&quot;:0,&quot;runIndex&quot;:0,&quot;charIndex&quot;:4}},&quot;format&quot;:&quot;BETTER_TEXT&quot;,&quot;size&quot;:{&quot;x&quot;:47.28437522644744,&quot;y&quot;:21.92974338076874},&quot;targetSize&quot;:{&quot;x&quot;:47.28437522644744,&quot;y&quot;:21.92974338076874}},&quot;parent&quot;:{&quot;type&quot;:&quot;CHILD&quot;,&quot;parentId&quot;:&quot;82468011-4845-45d2-ae7e-533a19310ec4&quot;,&quot;order&quot;:&quot;9999997&quot;}},&quot;482515c3-d169-4f80-ac4a-e451c0700f19&quot;:{&quot;id&quot;:&quot;482515c3-d169-4f80-ac4a-e451c0700f19&quot;,&quot;type&quot;:&quot;FIGURE_OBJECT&quot;,&quot;relativeTransform&quot;:{&quot;translate&quot;:{&quot;x&quot;:33.93575831178908,&quot;y&quot;:98.42534901658448},&quot;rotate&quot;:0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9.23357616032368,&quot;color&quot;:&quot;black&quot;,&quot;fontWeight&quot;:&quot;bold&quot;,&quot;fontStyle&quot;:&quot;normal&quot;,&quot;decoration&quot;:&quot;none&quot;},&quot;range&quot;:[0,8]}],&quot;text&quot;:&quot;0.98ug/ul&quot;}],&quot;_lastCaretLocation&quot;:{&quot;lineIndex&quot;:0,&quot;runIndex&quot;:0,&quot;charIndex&quot;:4}},&quot;format&quot;:&quot;BETTER_TEXT&quot;,&quot;size&quot;:{&quot;x&quot;:47.28437522644744,&quot;y&quot;:21.92974338076874},&quot;targetSize&quot;:{&quot;x&quot;:47.28437522644744,&quot;y&quot;:21.92974338076874}},&quot;parent&quot;:{&quot;type&quot;:&quot;CHILD&quot;,&quot;parentId&quot;:&quot;82468011-4845-45d2-ae7e-533a19310ec4&quot;,&quot;order&quot;:&quot;9999998&quot;}},&quot;fc74942d-48e5-47b4-9907-55ff5c3eb7b3&quot;:{&quot;id&quot;:&quot;fc74942d-48e5-47b4-9907-55ff5c3eb7b3&quot;,&quot;type&quot;:&quot;FIGURE_OBJECT&quot;,&quot;relativeTransform&quot;:{&quot;translate&quot;:{&quot;x&quot;:91.70101077077403,&quot;y&quot;:98.42534901658448},&quot;rotate&quot;:0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9.23357616032368,&quot;color&quot;:&quot;black&quot;,&quot;fontWeight&quot;:&quot;bold&quot;,&quot;fontStyle&quot;:&quot;normal&quot;,&quot;decoration&quot;:&quot;none&quot;},&quot;range&quot;:[0,8]}],&quot;text&quot;:&quot;0.49ug/ul&quot;}],&quot;_lastCaretLocation&quot;:{&quot;lineIndex&quot;:0,&quot;runIndex&quot;:0,&quot;charIndex&quot;:4}},&quot;format&quot;:&quot;BETTER_TEXT&quot;,&quot;size&quot;:{&quot;x&quot;:47.28437522644744,&quot;y&quot;:21.92974338076874},&quot;targetSize&quot;:{&quot;x&quot;:47.28437522644744,&quot;y&quot;:21.92974338076874}},&quot;parent&quot;:{&quot;type&quot;:&quot;CHILD&quot;,&quot;parentId&quot;:&quot;82468011-4845-45d2-ae7e-533a19310ec4&quot;,&quot;order&quot;:&quot;9999999&quot;}},&quot;0faf8d26-ce12-49f7-a8ef-5d5fcd202484&quot;:{&quot;id&quot;:&quot;0faf8d26-ce12-49f7-a8ef-5d5fcd202484&quot;,&quot;type&quot;:&quot;FIGURE_OBJECT&quot;,&quot;relativeTransform&quot;:{&quot;translate&quot;:{&quot;x&quot;:149.46626322975897,&quot;y&quot;:98.42534901658448},&quot;rotate&quot;:0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9.23357616032368,&quot;color&quot;:&quot;black&quot;,&quot;fontWeight&quot;:&quot;bold&quot;,&quot;fontStyle&quot;:&quot;normal&quot;,&quot;decoration&quot;:&quot;none&quot;},&quot;range&quot;:[0,8]}],&quot;text&quot;:&quot;0.24ug/ul&quot;}],&quot;_lastCaretLocation&quot;:{&quot;lineIndex&quot;:0,&quot;runIndex&quot;:0,&quot;charIndex&quot;:4}},&quot;format&quot;:&quot;BETTER_TEXT&quot;,&quot;size&quot;:{&quot;x&quot;:47.28437522644744,&quot;y&quot;:21.92974338076874},&quot;targetSize&quot;:{&quot;x&quot;:47.28437522644744,&quot;y&quot;:21.92974338076874}},&quot;parent&quot;:{&quot;type&quot;:&quot;CHILD&quot;,&quot;parentId&quot;:&quot;82468011-4845-45d2-ae7e-533a19310ec4&quot;,&quot;order&quot;:&quot;99999995&quot;}},&quot;ce59e0cf-9ac7-4c64-b167-be30075df73f&quot;:{&quot;id&quot;:&quot;ce59e0cf-9ac7-4c64-b167-be30075df73f&quot;,&quot;type&quot;:&quot;FIGURE_OBJECT&quot;,&quot;relativeTransform&quot;:{&quot;translate&quot;:{&quot;x&quot;:207.2315156887439,&quot;y&quot;:98.42534901658448},&quot;rotate&quot;:0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9.23357616032368,&quot;color&quot;:&quot;black&quot;,&quot;fontWeight&quot;:&quot;bold&quot;,&quot;fontStyle&quot;:&quot;normal&quot;,&quot;decoration&quot;:&quot;none&quot;},&quot;range&quot;:[0,8]}],&quot;text&quot;:&quot;0.12ug/ul&quot;}],&quot;_lastCaretLocation&quot;:{&quot;lineIndex&quot;:0,&quot;runIndex&quot;:0,&quot;charIndex&quot;:4}},&quot;format&quot;:&quot;BETTER_TEXT&quot;,&quot;size&quot;:{&quot;x&quot;:47.28437522644744,&quot;y&quot;:21.92974338076874},&quot;targetSize&quot;:{&quot;x&quot;:47.28437522644744,&quot;y&quot;:21.92974338076874}},&quot;parent&quot;:{&quot;type&quot;:&quot;CHILD&quot;,&quot;parentId&quot;:&quot;82468011-4845-45d2-ae7e-533a19310ec4&quot;,&quot;order&quot;:&quot;99999997&quot;}},&quot;4f40f22e-6d93-420c-a70d-cb79e81de7da&quot;:{&quot;id&quot;:&quot;4f40f22e-6d93-420c-a70d-cb79e81de7da&quot;,&quot;type&quot;:&quot;FIGURE_OBJECT&quot;,&quot;relativeTransform&quot;:{&quot;translate&quot;:{&quot;x&quot;:264.99676814772886,&quot;y&quot;:98.42534901658448},&quot;rotate&quot;:0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9.23357616032368,&quot;color&quot;:&quot;black&quot;,&quot;fontWeight&quot;:&quot;bold&quot;,&quot;fontStyle&quot;:&quot;normal&quot;,&quot;decoration&quot;:&quot;none&quot;},&quot;range&quot;:[0,8]}],&quot;text&quot;:&quot;0.06ug/ul&quot;}],&quot;_lastCaretLocation&quot;:{&quot;lineIndex&quot;:0,&quot;runIndex&quot;:0,&quot;charIndex&quot;:4}},&quot;format&quot;:&quot;BETTER_TEXT&quot;,&quot;size&quot;:{&quot;x&quot;:47.28437522644744,&quot;y&quot;:21.92974338076874},&quot;targetSize&quot;:{&quot;x&quot;:47.28437522644744,&quot;y&quot;:21.92974338076874}},&quot;parent&quot;:{&quot;type&quot;:&quot;CHILD&quot;,&quot;parentId&quot;:&quot;82468011-4845-45d2-ae7e-533a19310ec4&quot;,&quot;order&quot;:&quot;99999998&quot;}},&quot;3fcb2252-1f1f-4cc1-9094-17e74a1ef956&quot;:{&quot;id&quot;:&quot;3fcb2252-1f1f-4cc1-9094-17e74a1ef956&quot;,&quot;type&quot;:&quot;FIGURE_OBJECT&quot;,&quot;relativeTransform&quot;:{&quot;translate&quot;:{&quot;x&quot;:322.7608664096938,&quot;y&quot;:98.42534901658448},&quot;rotate&quot;:0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9.23357616032368,&quot;color&quot;:&quot;black&quot;,&quot;fontWeight&quot;:&quot;bold&quot;,&quot;fontStyle&quot;:&quot;normal&quot;,&quot;decoration&quot;:&quot;none&quot;},&quot;range&quot;:[0,8]}],&quot;text&quot;:&quot;0.03ug/ul&quot;}],&quot;_lastCaretLocation&quot;:{&quot;lineIndex&quot;:0,&quot;runIndex&quot;:0,&quot;charIndex&quot;:4}},&quot;format&quot;:&quot;BETTER_TEXT&quot;,&quot;size&quot;:{&quot;x&quot;:47.28437522644744,&quot;y&quot;:21.92974338076874},&quot;targetSize&quot;:{&quot;x&quot;:47.28437522644744,&quot;y&quot;:21.92974338076874}},&quot;parent&quot;:{&quot;type&quot;:&quot;CHILD&quot;,&quot;parentId&quot;:&quot;82468011-4845-45d2-ae7e-533a19310ec4&quot;,&quot;order&quot;:&quot;99999999&quot;}},&quot;24dc0a3d-6ed1-4b39-b331-78ccb50f9f1c&quot;:{&quot;id&quot;:&quot;24dc0a3d-6ed1-4b39-b331-78ccb50f9f1c&quot;,&quot;type&quot;:&quot;FIGURE_OBJECT&quot;,&quot;relativeTransform&quot;:{&quot;translate&quot;:{&quot;x&quot;:380.52611886867874,&quot;y&quot;:98.42534901658448},&quot;rotate&quot;:0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9.23357616032368,&quot;color&quot;:&quot;black&quot;,&quot;fontWeight&quot;:&quot;bold&quot;,&quot;fontStyle&quot;:&quot;normal&quot;,&quot;decoration&quot;:&quot;none&quot;},&quot;range&quot;:[0,8]}],&quot;text&quot;:&quot;0.02ug/ul&quot;}],&quot;_lastCaretLocation&quot;:{&quot;lineIndex&quot;:0,&quot;runIndex&quot;:0,&quot;charIndex&quot;:4}},&quot;format&quot;:&quot;BETTER_TEXT&quot;,&quot;size&quot;:{&quot;x&quot;:47.28437522644744,&quot;y&quot;:21.92974338076874},&quot;targetSize&quot;:{&quot;x&quot;:47.28437522644744,&quot;y&quot;:21.92974338076874}},&quot;parent&quot;:{&quot;type&quot;:&quot;CHILD&quot;,&quot;parentId&quot;:&quot;82468011-4845-45d2-ae7e-533a19310ec4&quot;,&quot;order&quot;:&quot;999999995&quot;}},&quot;1af5bc60-585f-459c-bb9f-e516f84437b7&quot;:{&quot;id&quot;:&quot;1af5bc60-585f-459c-bb9f-e516f84437b7&quot;,&quot;type&quot;:&quot;FIGURE_OBJECT&quot;,&quot;relativeTransform&quot;:{&quot;translate&quot;:{&quot;x&quot;:438.2913713276637,&quot;y&quot;:98.42534901658448},&quot;rotate&quot;:0},&quot;text&quot;:{&quot;textData&quot;:{&quot;lineSpacing&quot;:&quot;normal&quot;,&quot;alignment&quot;:&quot;left&quot;,&quot;verticalAlign&quot;:&quot;TOP&quot;,&quot;lines&quot;:[{&quot;runs&quot;:[{&quot;style&quot;:{&quot;fontFamily&quot;:&quot;Roboto&quot;,&quot;fontSize&quot;:9.23357616032368,&quot;color&quot;:&quot;black&quot;,&quot;fontWeight&quot;:&quot;bold&quot;,&quot;fontStyle&quot;:&quot;normal&quot;,&quot;decoration&quot;:&quot;none&quot;},&quot;range&quot;:[0,8]}],&quot;text&quot;:&quot;0.01ug/ul&quot;}],&quot;_lastCaretLocation&quot;:{&quot;lineIndex&quot;:0,&quot;runIndex&quot;:0,&quot;charIndex&quot;:4}},&quot;format&quot;:&quot;BETTER_TEXT&quot;,&quot;size&quot;:{&quot;x&quot;:47.28437522644744,&quot;y&quot;:21.92974338076874},&quot;targetSize&quot;:{&quot;x&quot;:47.28437522644744,&quot;y&quot;:21.92974338076874}},&quot;parent&quot;:{&quot;type&quot;:&quot;CHILD&quot;,&quot;parentId&quot;:&quot;82468011-4845-45d2-ae7e-533a19310ec4&quot;,&quot;order&quot;:&quot;999999997&quot;}},&quot;62676c2e-4b76-4b64-b20d-d668707f6443&quot;:{&quot;relativeTransform&quot;:{&quot;translate&quot;:{&quot;x&quot;:-438.4272188008795,&quot;y&quot;:37.09831177856836},&quot;rotate&quot;:0,&quot;skewX&quot;:0,&quot;scale&quot;:{&quot;x&quot;:1,&quot;y&quot;:1}},&quot;type&quot;:&quot;FIGURE_OBJECT&quot;,&quot;id&quot;:&quot;62676c2e-4b76-4b64-b20d-d668707f6443&quot;,&quot;opacity&quot;:1,&quot;path&quot;:{&quot;type&quot;:&quot;POLY_LINE&quot;,&quot;points&quot;:[{&quot;x&quot;:4.974641926767617,&quot;y&quot;:-137.02271231082307},{&quot;x&quot;:13.185661039235299,&quot;y&quot;:-158.41658203145784},{&quot;x&quot;:28.715525288267486,&quot;y&quot;:-168.3407703671512},{&quot;x&quot;:44.33526212272119,&quot;y&quot;:-158.81658203145784},{&quot;x&quot;:54.935953265994215,&quot;y&quot;:-135.79148492246026}],&quot;closed&quot;:false,&quot;selectedObjectIds&quot;:[&quot;69922a4c-8668-4e32-9dc7-a4d983b2e733&quot;]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82468011-4845-45d2-ae7e-533a19310ec4&quot;,&quot;order&quot;:&quot;999999998&quot;},&quot;connectorInfo&quot;:{&quot;connectedObjects&quot;:[],&quot;type&quot;:&quot;CUBIC&quot;,&quot;offset&quot;:{&quot;x&quot;:0,&quot;y&quot;:0},&quot;bending&quot;:-0.1,&quot;firstElementIsHead&quot;:true,&quot;customized&quot;:true},&quot;pathSmoothing&quot;:{&quot;type&quot;:&quot;CATMULL_SMOOTHING&quot;,&quot;smoothing&quot;:0.2},&quot;name&quot;:&quot;Curving arrow (editable) 4&quot;,&quot;displayName&quot;:&quot;Curving arrow (editable) 4&quot;,&quot;source&quot;:{&quot;id&quot;:&quot;62698ecb4e765946d04af2fb&quot;,&quot;type&quot;:&quot;ASSETS&quot;},&quot;isPremium&quot;:false},&quot;aefb9f7f-fbed-4d52-b927-7dbec0c8c768&quot;:{&quot;relativeTransform&quot;:{&quot;translate&quot;:{&quot;x&quot;:-377.37767446646785,&quot;y&quot;:37.098630225681404},&quot;rotate&quot;:0,&quot;skewX&quot;:0,&quot;scale&quot;:{&quot;x&quot;:1,&quot;y&quot;:1}},&quot;type&quot;:&quot;FIGURE_OBJECT&quot;,&quot;id&quot;:&quot;aefb9f7f-fbed-4d52-b927-7dbec0c8c768&quot;,&quot;opacity&quot;:1,&quot;path&quot;:{&quot;type&quot;:&quot;POLY_LINE&quot;,&quot;points&quot;:[{&quot;x&quot;:4.974641926767617,&quot;y&quot;:-137.02271231082307},{&quot;x&quot;:13.185661039235299,&quot;y&quot;:-158.41658203145784},{&quot;x&quot;:28.715525288267486,&quot;y&quot;:-168.3407703671512},{&quot;x&quot;:44.33526212272119,&quot;y&quot;:-158.81658203145784},{&quot;x&quot;:54.935953265994215,&quot;y&quot;:-135.79148492246026}],&quot;closed&quot;:false,&quot;selectedObjectIds&quot;:[&quot;69922a4c-8668-4e32-9dc7-a4d983b2e733&quot;]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82468011-4845-45d2-ae7e-533a19310ec4&quot;,&quot;order&quot;:&quot;999999999&quot;},&quot;connectorInfo&quot;:{&quot;connectedObjects&quot;:[],&quot;type&quot;:&quot;CUBIC&quot;,&quot;offset&quot;:{&quot;x&quot;:0,&quot;y&quot;:0},&quot;bending&quot;:-0.1,&quot;firstElementIsHead&quot;:true,&quot;customized&quot;:true},&quot;pathSmoothing&quot;:{&quot;type&quot;:&quot;CATMULL_SMOOTHING&quot;,&quot;smoothing&quot;:0.2},&quot;name&quot;:&quot;Curving arrow (editable) 4&quot;,&quot;displayName&quot;:&quot;Curving arrow (editable) 4&quot;,&quot;source&quot;:{&quot;id&quot;:&quot;62698ecb4e765946d04af2fb&quot;,&quot;type&quot;:&quot;ASSETS&quot;},&quot;isPremium&quot;:false},&quot;2a14c0b7-ceed-4e29-82e3-0ae18007b86c&quot;:{&quot;relativeTransform&quot;:{&quot;translate&quot;:{&quot;x&quot;:-316.3279029477606,&quot;y&quot;:37.098539611362554},&quot;rotate&quot;:0,&quot;skewX&quot;:0,&quot;scale&quot;:{&quot;x&quot;:1,&quot;y&quot;:1}},&quot;type&quot;:&quot;FIGURE_OBJECT&quot;,&quot;id&quot;:&quot;2a14c0b7-ceed-4e29-82e3-0ae18007b86c&quot;,&quot;opacity&quot;:1,&quot;path&quot;:{&quot;type&quot;:&quot;POLY_LINE&quot;,&quot;points&quot;:[{&quot;x&quot;:4.974641926767617,&quot;y&quot;:-137.02271231082307},{&quot;x&quot;:13.185661039235299,&quot;y&quot;:-158.41658203145784},{&quot;x&quot;:28.715525288267486,&quot;y&quot;:-168.3407703671512},{&quot;x&quot;:44.33526212272119,&quot;y&quot;:-158.81658203145784},{&quot;x&quot;:54.935953265994215,&quot;y&quot;:-135.79148492246026}],&quot;closed&quot;:false,&quot;selectedObjectIds&quot;:[&quot;69922a4c-8668-4e32-9dc7-a4d983b2e733&quot;]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82468011-4845-45d2-ae7e-533a19310ec4&quot;,&quot;order&quot;:&quot;9999999995&quot;},&quot;connectorInfo&quot;:{&quot;connectedObjects&quot;:[],&quot;type&quot;:&quot;CUBIC&quot;,&quot;offset&quot;:{&quot;x&quot;:0,&quot;y&quot;:0},&quot;bending&quot;:-0.1,&quot;firstElementIsHead&quot;:true,&quot;customized&quot;:true},&quot;pathSmoothing&quot;:{&quot;type&quot;:&quot;CATMULL_SMOOTHING&quot;,&quot;smoothing&quot;:0.2},&quot;name&quot;:&quot;Curving arrow (editable) 4&quot;,&quot;displayName&quot;:&quot;Curving arrow (editable) 4&quot;,&quot;source&quot;:{&quot;id&quot;:&quot;62698ecb4e765946d04af2fb&quot;,&quot;type&quot;:&quot;ASSETS&quot;},&quot;isPremium&quot;:false},&quot;a3d698a0-cb9f-46d9-bba6-9a85cef2c33a&quot;:{&quot;relativeTransform&quot;:{&quot;translate&quot;:{&quot;x&quot;:-259.9805175126562,&quot;y&quot;:37.09849430420314},&quot;rotate&quot;:0,&quot;skewX&quot;:0,&quot;scale&quot;:{&quot;x&quot;:1,&quot;y&quot;:1}},&quot;type&quot;:&quot;FIGURE_OBJECT&quot;,&quot;id&quot;:&quot;a3d698a0-cb9f-46d9-bba6-9a85cef2c33a&quot;,&quot;opacity&quot;:1,&quot;path&quot;:{&quot;type&quot;:&quot;POLY_LINE&quot;,&quot;points&quot;:[{&quot;x&quot;:4.974641926767617,&quot;y&quot;:-137.02271231082307},{&quot;x&quot;:13.185661039235299,&quot;y&quot;:-158.41658203145784},{&quot;x&quot;:28.715525288267486,&quot;y&quot;:-168.3407703671512},{&quot;x&quot;:44.33526212272119,&quot;y&quot;:-158.81658203145784},{&quot;x&quot;:54.935953265994215,&quot;y&quot;:-135.79148492246026}],&quot;closed&quot;:false,&quot;selectedObjectIds&quot;:[&quot;69922a4c-8668-4e32-9dc7-a4d983b2e733&quot;]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82468011-4845-45d2-ae7e-533a19310ec4&quot;,&quot;order&quot;:&quot;9999999997&quot;},&quot;connectorInfo&quot;:{&quot;connectedObjects&quot;:[],&quot;type&quot;:&quot;CUBIC&quot;,&quot;offset&quot;:{&quot;x&quot;:0,&quot;y&quot;:0},&quot;bending&quot;:-0.1,&quot;firstElementIsHead&quot;:true,&quot;customized&quot;:true},&quot;pathSmoothing&quot;:{&quot;type&quot;:&quot;CATMULL_SMOOTHING&quot;,&quot;smoothing&quot;:0.2},&quot;name&quot;:&quot;Curving arrow (editable) 4&quot;,&quot;displayName&quot;:&quot;Curving arrow (editable) 4&quot;,&quot;source&quot;:{&quot;id&quot;:&quot;62698ecb4e765946d04af2fb&quot;,&quot;type&quot;:&quot;ASSETS&quot;},&quot;isPremium&quot;:false},&quot;df980a80-e5e5-421e-b5dc-e788ec362c1b&quot;:{&quot;relativeTransform&quot;:{&quot;translate&quot;:{&quot;x&quot;:-202.2894958318243,&quot;y&quot;:37.09822181274805},&quot;rotate&quot;:0,&quot;skewX&quot;:0,&quot;scale&quot;:{&quot;x&quot;:1,&quot;y&quot;:1}},&quot;type&quot;:&quot;FIGURE_OBJECT&quot;,&quot;id&quot;:&quot;df980a80-e5e5-421e-b5dc-e788ec362c1b&quot;,&quot;opacity&quot;:1,&quot;path&quot;:{&quot;type&quot;:&quot;POLY_LINE&quot;,&quot;points&quot;:[{&quot;x&quot;:4.974641926767617,&quot;y&quot;:-137.02271231082307},{&quot;x&quot;:13.185661039235299,&quot;y&quot;:-158.41658203145784},{&quot;x&quot;:28.715525288267486,&quot;y&quot;:-168.3407703671512},{&quot;x&quot;:44.33526212272119,&quot;y&quot;:-158.81658203145784},{&quot;x&quot;:54.935953265994215,&quot;y&quot;:-135.79148492246026}],&quot;closed&quot;:false,&quot;selectedObjectIds&quot;:[&quot;69922a4c-8668-4e32-9dc7-a4d983b2e733&quot;]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82468011-4845-45d2-ae7e-533a19310ec4&quot;,&quot;order&quot;:&quot;9999999998&quot;},&quot;connectorInfo&quot;:{&quot;connectedObjects&quot;:[],&quot;type&quot;:&quot;CUBIC&quot;,&quot;offset&quot;:{&quot;x&quot;:0,&quot;y&quot;:0},&quot;bending&quot;:-0.1,&quot;firstElementIsHead&quot;:true,&quot;customized&quot;:true},&quot;pathSmoothing&quot;:{&quot;type&quot;:&quot;CATMULL_SMOOTHING&quot;,&quot;smoothing&quot;:0.2},&quot;name&quot;:&quot;Curving arrow (editable) 4&quot;,&quot;displayName&quot;:&quot;Curving arrow (editable) 4&quot;,&quot;source&quot;:{&quot;id&quot;:&quot;62698ecb4e765946d04af2fb&quot;,&quot;type&quot;:&quot;ASSETS&quot;},&quot;isPremium&quot;:false},&quot;169d4c86-1e30-4247-b981-eb01f43c1457&quot;:{&quot;relativeTransform&quot;:{&quot;translate&quot;:{&quot;x&quot;:-144.59876962027644,&quot;y&quot;:37.0980629134408},&quot;rotate&quot;:0,&quot;skewX&quot;:0,&quot;scale&quot;:{&quot;x&quot;:1,&quot;y&quot;:1}},&quot;type&quot;:&quot;FIGURE_OBJECT&quot;,&quot;id&quot;:&quot;169d4c86-1e30-4247-b981-eb01f43c1457&quot;,&quot;opacity&quot;:1,&quot;path&quot;:{&quot;type&quot;:&quot;POLY_LINE&quot;,&quot;points&quot;:[{&quot;x&quot;:4.974641926767617,&quot;y&quot;:-137.02271231082307},{&quot;x&quot;:13.185661039235299,&quot;y&quot;:-158.41658203145784},{&quot;x&quot;:28.715525288267486,&quot;y&quot;:-168.3407703671512},{&quot;x&quot;:44.33526212272119,&quot;y&quot;:-158.81658203145784},{&quot;x&quot;:54.935953265994215,&quot;y&quot;:-135.79148492246026}],&quot;closed&quot;:false,&quot;selectedObjectIds&quot;:[&quot;69922a4c-8668-4e32-9dc7-a4d983b2e733&quot;]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82468011-4845-45d2-ae7e-533a19310ec4&quot;,&quot;order&quot;:&quot;9999999999&quot;},&quot;connectorInfo&quot;:{&quot;connectedObjects&quot;:[],&quot;type&quot;:&quot;CUBIC&quot;,&quot;offset&quot;:{&quot;x&quot;:0,&quot;y&quot;:0},&quot;bending&quot;:-0.1,&quot;firstElementIsHead&quot;:true,&quot;customized&quot;:true},&quot;pathSmoothing&quot;:{&quot;type&quot;:&quot;CATMULL_SMOOTHING&quot;,&quot;smoothing&quot;:0.2},&quot;name&quot;:&quot;Curving arrow (editable) 4&quot;,&quot;displayName&quot;:&quot;Curving arrow (editable) 4&quot;,&quot;source&quot;:{&quot;id&quot;:&quot;62698ecb4e765946d04af2fb&quot;,&quot;type&quot;:&quot;ASSETS&quot;},&quot;isPremium&quot;:false},&quot;61a80fd1-f1f5-4ef7-9575-93f0426416ad&quot;:{&quot;relativeTransform&quot;:{&quot;translate&quot;:{&quot;x&quot;:-86.90752075514888,&quot;y&quot;:37.09883572914515},&quot;rotate&quot;:0,&quot;skewX&quot;:0,&quot;scale&quot;:{&quot;x&quot;:1,&quot;y&quot;:1}},&quot;type&quot;:&quot;FIGURE_OBJECT&quot;,&quot;id&quot;:&quot;61a80fd1-f1f5-4ef7-9575-93f0426416ad&quot;,&quot;opacity&quot;:1,&quot;path&quot;:{&quot;type&quot;:&quot;POLY_LINE&quot;,&quot;points&quot;:[{&quot;x&quot;:4.974641926767617,&quot;y&quot;:-137.02271231082307},{&quot;x&quot;:13.185661039235299,&quot;y&quot;:-158.41658203145784},{&quot;x&quot;:28.715525288267486,&quot;y&quot;:-168.3407703671512},{&quot;x&quot;:44.33526212272119,&quot;y&quot;:-158.81658203145784},{&quot;x&quot;:54.935953265994215,&quot;y&quot;:-135.79148492246026}],&quot;closed&quot;:false,&quot;selectedObjectIds&quot;:[&quot;69922a4c-8668-4e32-9dc7-a4d983b2e733&quot;]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82468011-4845-45d2-ae7e-533a19310ec4&quot;,&quot;order&quot;:&quot;99999999995&quot;},&quot;connectorInfo&quot;:{&quot;connectedObjects&quot;:[],&quot;type&quot;:&quot;CUBIC&quot;,&quot;offset&quot;:{&quot;x&quot;:0,&quot;y&quot;:0},&quot;bending&quot;:-0.1,&quot;firstElementIsHead&quot;:true,&quot;customized&quot;:true},&quot;pathSmoothing&quot;:{&quot;type&quot;:&quot;CATMULL_SMOOTHING&quot;,&quot;smoothing&quot;:0.2},&quot;name&quot;:&quot;Curving arrow (editable) 4&quot;,&quot;displayName&quot;:&quot;Curving arrow (editable) 4&quot;,&quot;source&quot;:{&quot;id&quot;:&quot;62698ecb4e765946d04af2fb&quot;,&quot;type&quot;:&quot;ASSETS&quot;},&quot;isPremium&quot;:false},&quot;60e4f638-8b1a-4736-9d86-f0effc5bc224&quot;:{&quot;relativeTransform&quot;:{&quot;translate&quot;:{&quot;x&quot;:-29.217090012885087,&quot;y&quot;:37.099154176258196},&quot;rotate&quot;:0,&quot;skewX&quot;:0,&quot;scale&quot;:{&quot;x&quot;:1,&quot;y&quot;:1}},&quot;type&quot;:&quot;FIGURE_OBJECT&quot;,&quot;id&quot;:&quot;60e4f638-8b1a-4736-9d86-f0effc5bc224&quot;,&quot;opacity&quot;:1,&quot;path&quot;:{&quot;type&quot;:&quot;POLY_LINE&quot;,&quot;points&quot;:[{&quot;x&quot;:4.974641926767617,&quot;y&quot;:-137.02271231082307},{&quot;x&quot;:13.185661039235299,&quot;y&quot;:-158.41658203145784},{&quot;x&quot;:28.715525288267486,&quot;y&quot;:-168.3407703671512},{&quot;x&quot;:44.33526212272119,&quot;y&quot;:-158.81658203145784},{&quot;x&quot;:54.935953265994215,&quot;y&quot;:-135.79148492246026}],&quot;closed&quot;:false,&quot;selectedObjectIds&quot;:[&quot;69922a4c-8668-4e32-9dc7-a4d983b2e733&quot;]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82468011-4845-45d2-ae7e-533a19310ec4&quot;,&quot;order&quot;:&quot;99999999997&quot;},&quot;connectorInfo&quot;:{&quot;connectedObjects&quot;:[],&quot;type&quot;:&quot;CUBIC&quot;,&quot;offset&quot;:{&quot;x&quot;:0,&quot;y&quot;:0},&quot;bending&quot;:-0.1,&quot;firstElementIsHead&quot;:true,&quot;customized&quot;:true},&quot;pathSmoothing&quot;:{&quot;type&quot;:&quot;CATMULL_SMOOTHING&quot;,&quot;smoothing&quot;:0.2},&quot;name&quot;:&quot;Curving arrow (editable) 4&quot;,&quot;displayName&quot;:&quot;Curving arrow (editable) 4&quot;,&quot;source&quot;:{&quot;id&quot;:&quot;62698ecb4e765946d04af2fb&quot;,&quot;type&quot;:&quot;ASSETS&quot;},&quot;isPremium&quot;:false},&quot;fb2ad363-9f47-4e90-bd58-85fc5e562336&quot;:{&quot;relativeTransform&quot;:{&quot;translate&quot;:{&quot;x&quot;:27.13081807579899,&quot;y&quot;:37.098404338382835},&quot;rotate&quot;:0,&quot;skewX&quot;:0,&quot;scale&quot;:{&quot;x&quot;:1,&quot;y&quot;:1}},&quot;type&quot;:&quot;FIGURE_OBJECT&quot;,&quot;id&quot;:&quot;fb2ad363-9f47-4e90-bd58-85fc5e562336&quot;,&quot;opacity&quot;:1,&quot;path&quot;:{&quot;type&quot;:&quot;POLY_LINE&quot;,&quot;points&quot;:[{&quot;x&quot;:4.974641926767617,&quot;y&quot;:-137.02271231082307},{&quot;x&quot;:13.185661039235299,&quot;y&quot;:-158.41658203145784},{&quot;x&quot;:28.715525288267486,&quot;y&quot;:-168.3407703671512},{&quot;x&quot;:44.33526212272119,&quot;y&quot;:-158.81658203145784},{&quot;x&quot;:54.935953265994215,&quot;y&quot;:-135.79148492246026}],&quot;closed&quot;:false,&quot;selectedObjectIds&quot;:[&quot;69922a4c-8668-4e32-9dc7-a4d983b2e733&quot;]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82468011-4845-45d2-ae7e-533a19310ec4&quot;,&quot;order&quot;:&quot;99999999998&quot;},&quot;connectorInfo&quot;:{&quot;connectedObjects&quot;:[],&quot;type&quot;:&quot;CUBIC&quot;,&quot;offset&quot;:{&quot;x&quot;:0,&quot;y&quot;:0},&quot;bending&quot;:-0.1,&quot;firstElementIsHead&quot;:true,&quot;customized&quot;:true},&quot;pathSmoothing&quot;:{&quot;type&quot;:&quot;CATMULL_SMOOTHING&quot;,&quot;smoothing&quot;:0.2},&quot;name&quot;:&quot;Curving arrow (editable) 4&quot;,&quot;displayName&quot;:&quot;Curving arrow (editable) 4&quot;,&quot;source&quot;:{&quot;id&quot;:&quot;62698ecb4e765946d04af2fb&quot;,&quot;type&quot;:&quot;ASSETS&quot;},&quot;isPremium&quot;:false},&quot;03b8e9dc-e460-476b-95eb-482553010608&quot;:{&quot;relativeTransform&quot;:{&quot;translate&quot;:{&quot;x&quot;:88.18054428734683,&quot;y&quot;:37.09883637764371},&quot;rotate&quot;:0,&quot;skewX&quot;:0,&quot;scale&quot;:{&quot;x&quot;:1,&quot;y&quot;:1}},&quot;type&quot;:&quot;FIGURE_OBJECT&quot;,&quot;id&quot;:&quot;03b8e9dc-e460-476b-95eb-482553010608&quot;,&quot;opacity&quot;:1,&quot;path&quot;:{&quot;type&quot;:&quot;POLY_LINE&quot;,&quot;points&quot;:[{&quot;x&quot;:4.974641926767617,&quot;y&quot;:-137.02271231082307},{&quot;x&quot;:13.185661039235299,&quot;y&quot;:-158.41658203145784},{&quot;x&quot;:28.715525288267486,&quot;y&quot;:-168.3407703671512},{&quot;x&quot;:44.33526212272119,&quot;y&quot;:-158.81658203145784},{&quot;x&quot;:54.935953265994215,&quot;y&quot;:-135.79148492246026}],&quot;closed&quot;:false,&quot;selectedObjectIds&quot;:[&quot;69922a4c-8668-4e32-9dc7-a4d983b2e733&quot;]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82468011-4845-45d2-ae7e-533a19310ec4&quot;,&quot;order&quot;:&quot;99999999999&quot;},&quot;connectorInfo&quot;:{&quot;connectedObjects&quot;:[],&quot;type&quot;:&quot;CUBIC&quot;,&quot;offset&quot;:{&quot;x&quot;:0,&quot;y&quot;:0},&quot;bending&quot;:-0.1,&quot;firstElementIsHead&quot;:true,&quot;customized&quot;:true},&quot;pathSmoothing&quot;:{&quot;type&quot;:&quot;CATMULL_SMOOTHING&quot;,&quot;smoothing&quot;:0.2},&quot;name&quot;:&quot;Curving arrow (editable) 4&quot;,&quot;displayName&quot;:&quot;Curving arrow (editable) 4&quot;,&quot;source&quot;:{&quot;id&quot;:&quot;62698ecb4e765946d04af2fb&quot;,&quot;type&quot;:&quot;ASSETS&quot;},&quot;isPremium&quot;:false},&quot;80cd7535-aabd-4075-be13-3cb7f4145ce0&quot;:{&quot;relativeTransform&quot;:{&quot;translate&quot;:{&quot;x&quot;:142.8277931160022,&quot;y&quot;:38.44208652153225},&quot;rotate&quot;:0,&quot;skewX&quot;:0,&quot;scale&quot;:{&quot;x&quot;:1,&quot;y&quot;:1}},&quot;type&quot;:&quot;FIGURE_OBJECT&quot;,&quot;id&quot;:&quot;80cd7535-aabd-4075-be13-3cb7f4145ce0&quot;,&quot;opacity&quot;:1,&quot;path&quot;:{&quot;type&quot;:&quot;POLY_LINE&quot;,&quot;points&quot;:[{&quot;x&quot;:4.974641926767617,&quot;y&quot;:-137.02271231082307},{&quot;x&quot;:13.185661039235299,&quot;y&quot;:-158.41658203145784},{&quot;x&quot;:28.715525288267486,&quot;y&quot;:-168.3407703671512},{&quot;x&quot;:44.33526212272119,&quot;y&quot;:-158.81658203145784},{&quot;x&quot;:54.935953265994215,&quot;y&quot;:-135.79148492246026}],&quot;closed&quot;:false,&quot;selectedObjectIds&quot;:[&quot;69922a4c-8668-4e32-9dc7-a4d983b2e733&quot;]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82468011-4845-45d2-ae7e-533a19310ec4&quot;,&quot;order&quot;:&quot;999999999995&quot;},&quot;connectorInfo&quot;:{&quot;connectedObjects&quot;:[],&quot;type&quot;:&quot;CUBIC&quot;,&quot;offset&quot;:{&quot;x&quot;:0,&quot;y&quot;:0},&quot;bending&quot;:-0.1,&quot;firstElementIsHead&quot;:true,&quot;customized&quot;:true},&quot;pathSmoothing&quot;:{&quot;type&quot;:&quot;CATMULL_SMOOTHING&quot;,&quot;smoothing&quot;:0.2},&quot;name&quot;:&quot;Curving arrow (editable) 4&quot;,&quot;displayName&quot;:&quot;Curving arrow (editable) 4&quot;,&quot;source&quot;:{&quot;id&quot;:&quot;62698ecb4e765946d04af2fb&quot;,&quot;type&quot;:&quot;ASSETS&quot;},&quot;isPremium&quot;:false},&quot;6cae8e80-36b7-4d81-b1d2-4cfae14cb9ba&quot;:{&quot;relativeTransform&quot;:{&quot;translate&quot;:{&quot;x&quot;:198.8193373957055,&quot;y&quot;:38.441995907213396},&quot;rotate&quot;:0,&quot;skewX&quot;:0,&quot;scale&quot;:{&quot;x&quot;:1,&quot;y&quot;:1}},&quot;type&quot;:&quot;FIGURE_OBJECT&quot;,&quot;id&quot;:&quot;6cae8e80-36b7-4d81-b1d2-4cfae14cb9ba&quot;,&quot;opacity&quot;:1,&quot;path&quot;:{&quot;type&quot;:&quot;POLY_LINE&quot;,&quot;points&quot;:[{&quot;x&quot;:4.974641926767617,&quot;y&quot;:-137.02271231082307},{&quot;x&quot;:13.185661039235299,&quot;y&quot;:-158.41658203145784},{&quot;x&quot;:28.715525288267486,&quot;y&quot;:-168.3407703671512},{&quot;x&quot;:44.33526212272119,&quot;y&quot;:-158.81658203145784},{&quot;x&quot;:54.935953265994215,&quot;y&quot;:-135.79148492246026}],&quot;closed&quot;:false,&quot;selectedObjectIds&quot;:[&quot;69922a4c-8668-4e32-9dc7-a4d983b2e733&quot;]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82468011-4845-45d2-ae7e-533a19310ec4&quot;,&quot;order&quot;:&quot;999999999997&quot;},&quot;connectorInfo&quot;:{&quot;connectedObjects&quot;:[],&quot;type&quot;:&quot;CUBIC&quot;,&quot;offset&quot;:{&quot;x&quot;:0,&quot;y&quot;:0},&quot;bending&quot;:-0.1,&quot;firstElementIsHead&quot;:true,&quot;customized&quot;:true},&quot;pathSmoothing&quot;:{&quot;type&quot;:&quot;CATMULL_SMOOTHING&quot;,&quot;smoothing&quot;:0.2},&quot;name&quot;:&quot;Curving arrow (editable) 4&quot;,&quot;displayName&quot;:&quot;Curving arrow (editable) 4&quot;,&quot;source&quot;:{&quot;id&quot;:&quot;62698ecb4e765946d04af2fb&quot;,&quot;type&quot;:&quot;ASSETS&quot;},&quot;isPremium&quot;:false},&quot;b6691bc7-eb59-43e6-9bfa-21b6c97d2e30&quot;:{&quot;relativeTransform&quot;:{&quot;translate&quot;:{&quot;x&quot;:256.5516545458215,&quot;y&quot;:38.442837007906135},&quot;rotate&quot;:0,&quot;skewX&quot;:0,&quot;scale&quot;:{&quot;x&quot;:1,&quot;y&quot;:1}},&quot;type&quot;:&quot;FIGURE_OBJECT&quot;,&quot;id&quot;:&quot;b6691bc7-eb59-43e6-9bfa-21b6c97d2e30&quot;,&quot;opacity&quot;:1,&quot;path&quot;:{&quot;type&quot;:&quot;POLY_LINE&quot;,&quot;points&quot;:[{&quot;x&quot;:4.974641926767617,&quot;y&quot;:-137.02271231082307},{&quot;x&quot;:13.185661039235299,&quot;y&quot;:-158.41658203145784},{&quot;x&quot;:28.715525288267486,&quot;y&quot;:-168.3407703671512},{&quot;x&quot;:44.33526212272119,&quot;y&quot;:-158.81658203145784},{&quot;x&quot;:54.935953265994215,&quot;y&quot;:-135.79148492246026}],&quot;closed&quot;:false,&quot;selectedObjectIds&quot;:[&quot;69922a4c-8668-4e32-9dc7-a4d983b2e733&quot;]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82468011-4845-45d2-ae7e-533a19310ec4&quot;,&quot;order&quot;:&quot;999999999998&quot;},&quot;connectorInfo&quot;:{&quot;connectedObjects&quot;:[],&quot;type&quot;:&quot;CUBIC&quot;,&quot;offset&quot;:{&quot;x&quot;:0,&quot;y&quot;:0},&quot;bending&quot;:-0.1,&quot;firstElementIsHead&quot;:true,&quot;customized&quot;:true},&quot;pathSmoothing&quot;:{&quot;type&quot;:&quot;CATMULL_SMOOTHING&quot;,&quot;smoothing&quot;:0.2},&quot;name&quot;:&quot;Curving arrow (editable) 4&quot;,&quot;displayName&quot;:&quot;Curving arrow (editable) 4&quot;,&quot;source&quot;:{&quot;id&quot;:&quot;62698ecb4e765946d04af2fb&quot;,&quot;type&quot;:&quot;ASSETS&quot;},&quot;isPremium&quot;:false},&quot;a61dfb4d-a13e-4ccf-970a-fe50614c6c74&quot;:{&quot;relativeTransform&quot;:{&quot;translate&quot;:{&quot;x&quot;:316.25778981880126,&quot;y&quot;:38.44238263931483},&quot;rotate&quot;:0,&quot;skewX&quot;:0,&quot;scale&quot;:{&quot;x&quot;:1,&quot;y&quot;:1}},&quot;type&quot;:&quot;FIGURE_OBJECT&quot;,&quot;id&quot;:&quot;a61dfb4d-a13e-4ccf-970a-fe50614c6c74&quot;,&quot;opacity&quot;:1,&quot;path&quot;:{&quot;type&quot;:&quot;POLY_LINE&quot;,&quot;points&quot;:[{&quot;x&quot;:4.974641926767617,&quot;y&quot;:-137.02271231082307},{&quot;x&quot;:13.185661039235299,&quot;y&quot;:-158.41658203145784},{&quot;x&quot;:28.715525288267486,&quot;y&quot;:-168.3407703671512},{&quot;x&quot;:44.33526212272119,&quot;y&quot;:-158.81658203145784},{&quot;x&quot;:54.935953265994215,&quot;y&quot;:-135.79148492246026}],&quot;closed&quot;:false,&quot;selectedObjectIds&quot;:[&quot;69922a4c-8668-4e32-9dc7-a4d983b2e733&quot;]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82468011-4845-45d2-ae7e-533a19310ec4&quot;,&quot;order&quot;:&quot;999999999999&quot;},&quot;connectorInfo&quot;:{&quot;connectedObjects&quot;:[],&quot;type&quot;:&quot;CUBIC&quot;,&quot;offset&quot;:{&quot;x&quot;:0,&quot;y&quot;:0},&quot;bending&quot;:-0.1,&quot;firstElementIsHead&quot;:true,&quot;customized&quot;:true},&quot;pathSmoothing&quot;:{&quot;type&quot;:&quot;CATMULL_SMOOTHING&quot;,&quot;smoothing&quot;:0.2},&quot;name&quot;:&quot;Curving arrow (editable) 4&quot;,&quot;displayName&quot;:&quot;Curving arrow (editable) 4&quot;,&quot;source&quot;:{&quot;id&quot;:&quot;62698ecb4e765946d04af2fb&quot;,&quot;type&quot;:&quot;ASSETS&quot;},&quot;isPremium&quot;:false},&quot;216b342f-c87a-4156-907a-a081aab63bb6&quot;:{&quot;relativeTransform&quot;:{&quot;translate&quot;:{&quot;x&quot;:375.29187983021177,&quot;y&quot;:38.44251920929163},&quot;rotate&quot;:0,&quot;skewX&quot;:0,&quot;scale&quot;:{&quot;x&quot;:1,&quot;y&quot;:1}},&quot;type&quot;:&quot;FIGURE_OBJECT&quot;,&quot;id&quot;:&quot;216b342f-c87a-4156-907a-a081aab63bb6&quot;,&quot;opacity&quot;:1,&quot;path&quot;:{&quot;type&quot;:&quot;POLY_LINE&quot;,&quot;points&quot;:[{&quot;x&quot;:4.974641926767617,&quot;y&quot;:-137.02271231082307},{&quot;x&quot;:13.185661039235299,&quot;y&quot;:-158.41658203145784},{&quot;x&quot;:28.715525288267486,&quot;y&quot;:-168.3407703671512},{&quot;x&quot;:44.33526212272119,&quot;y&quot;:-158.81658203145784},{&quot;x&quot;:54.935953265994215,&quot;y&quot;:-135.79148492246026}],&quot;closed&quot;:false,&quot;selectedObjectIds&quot;:[&quot;69922a4c-8668-4e32-9dc7-a4d983b2e733&quot;]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82468011-4845-45d2-ae7e-533a19310ec4&quot;,&quot;order&quot;:&quot;9999999999995&quot;},&quot;connectorInfo&quot;:{&quot;connectedObjects&quot;:[],&quot;type&quot;:&quot;CUBIC&quot;,&quot;offset&quot;:{&quot;x&quot;:0,&quot;y&quot;:0},&quot;bending&quot;:-0.1,&quot;firstElementIsHead&quot;:true,&quot;customized&quot;:true},&quot;pathSmoothing&quot;:{&quot;type&quot;:&quot;CATMULL_SMOOTHING&quot;,&quot;smoothing&quot;:0.2},&quot;name&quot;:&quot;Curving arrow (editable) 4&quot;,&quot;displayName&quot;:&quot;Curving arrow (editable) 4&quot;,&quot;source&quot;:{&quot;id&quot;:&quot;62698ecb4e765946d04af2fb&quot;,&quot;type&quot;:&quot;ASSETS&quot;},&quot;isPremium&quot;:false},&quot;5ea89c95-945f-4fb3-b68c-c6c311cf1c3c&quot;:{&quot;relativeTransform&quot;:{&quot;translate&quot;:{&quot;x&quot;:-29.880295383379007,&quot;y&quot;:-177.86439488250943},&quot;rotate&quot;:3.141592653589793,&quot;skewX&quot;:0,&quot;scale&quot;:{&quot;x&quot;:0.9999999999999998,&quot;y&quot;:0.9999999999999998}},&quot;type&quot;:&quot;FIGURE_OBJECT&quot;,&quot;id&quot;:&quot;5ea89c95-945f-4fb3-b68c-c6c311cf1c3c&quot;,&quot;opacity&quot;:1,&quot;path&quot;:{&quot;type&quot;:&quot;POLY_LINE&quot;,&quot;points&quot;:[{&quot;x&quot;:0,&quot;y&quot;:29.91988592127491},{&quot;x&quot;:0,&quot;y&quot;:-29.91988592127491}],&quot;closed&quot;:false},&quot;pathStyles&quot;:[{&quot;type&quot;:&quot;FILL&quot;,&quot;fillStyle&quot;:&quot;rgba(0,0,0,0)&quot;},{&quot;type&quot;:&quot;STROKE&quot;,&quot;strokeStyle&quot;:&quot;#232323&quot;,&quot;lineWidth&quot;:9.634241258256798,&quot;lineJoin&quot;:&quot;round&quot;}],&quot;isLocked&quot;:false,&quot;parent&quot;:{&quot;type&quot;:&quot;CHILD&quot;,&quot;parentId&quot;:&quot;82468011-4845-45d2-ae7e-533a19310ec4&quot;,&quot;order&quot;:&quot;9999999999997&quot;},&quot;connectorInfo&quot;:{&quot;connectedObjects&quot;:[],&quot;type&quot;:&quot;LINE&quot;,&quot;offset&quot;:{&quot;x&quot;:0,&quot;y&quot;:0},&quot;bending&quot;:0.1,&quot;firstElementIsHead&quot;:true,&quot;customized&quot;:false},&quot;pathMarkers&quot;:{&quot;markerEnd&quot;:{&quot;type&quot;:&quot;PATH&quot;,&quot;units&quot;:{&quot;type&quot;:&quot;STROKE_WIDTH&quot;,&quot;scale&quot;:0.5},&quot;orient&quot;:{&quot;type&quot;:&quot;CLIPPED_CHORD&quot;},&quot;clipDistance&quot;:2,&quot;name&quot;:&quot;short-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2.5,&quot;y&quot;:-2.5,&quot;isEndPoint&quot;:true},{&quot;x&quot;:-2.5,&quot;y&quot;:2.5,&quot;isEndPoint&quot;:true}],&quot;closed&quot;:true}},&quot;pathStyles&quot;:[{&quot;type&quot;:&quot;FILL&quot;,&quot;fillStyle&quot;:&quot;context-stroke-flat&quot;}]}},&quot;name&quot;:&quot;Straight arrow (thick, large arrowhead, editable)&quot;,&quot;displayName&quot;:&quot;Straight arrow (thick, large arrowhead, editable)&quot;,&quot;source&quot;:{&quot;id&quot;:&quot;648741de5ca6211d7d057176&quot;,&quot;type&quot;:&quot;ASSETS&quot;},&quot;isPremium&quot;:false},&quot;7d00253c-afbb-4c9e-bb74-214a016034ee&quot;:{&quot;relativeTransform&quot;:{&quot;translate&quot;:{&quot;x&quot;:84.85440231742463,&quot;y&quot;:-177.86445457918379},&quot;rotate&quot;:3.141592653589793,&quot;skewX&quot;:0,&quot;scale&quot;:{&quot;x&quot;:0.9999999999999998,&quot;y&quot;:0.9999999999999998}},&quot;type&quot;:&quot;FIGURE_OBJECT&quot;,&quot;id&quot;:&quot;7d00253c-afbb-4c9e-bb74-214a016034ee&quot;,&quot;opacity&quot;:1,&quot;path&quot;:{&quot;type&quot;:&quot;POLY_LINE&quot;,&quot;points&quot;:[{&quot;x&quot;:0,&quot;y&quot;:29.91988592127491},{&quot;x&quot;:0,&quot;y&quot;:-29.91988592127491}],&quot;closed&quot;:false},&quot;pathStyles&quot;:[{&quot;type&quot;:&quot;FILL&quot;,&quot;fillStyle&quot;:&quot;rgba(0,0,0,0)&quot;},{&quot;type&quot;:&quot;STROKE&quot;,&quot;strokeStyle&quot;:&quot;#232323&quot;,&quot;lineWidth&quot;:9.634241258256798,&quot;lineJoin&quot;:&quot;round&quot;}],&quot;isLocked&quot;:false,&quot;parent&quot;:{&quot;type&quot;:&quot;CHILD&quot;,&quot;parentId&quot;:&quot;82468011-4845-45d2-ae7e-533a19310ec4&quot;,&quot;order&quot;:&quot;9999999999998&quot;},&quot;connectorInfo&quot;:{&quot;connectedObjects&quot;:[],&quot;type&quot;:&quot;LINE&quot;,&quot;offset&quot;:{&quot;x&quot;:0,&quot;y&quot;:0},&quot;bending&quot;:0.1,&quot;firstElementIsHead&quot;:true,&quot;customized&quot;:false},&quot;pathMarkers&quot;:{&quot;markerEnd&quot;:{&quot;type&quot;:&quot;PATH&quot;,&quot;units&quot;:{&quot;type&quot;:&quot;STROKE_WIDTH&quot;,&quot;scale&quot;:0.5},&quot;orient&quot;:{&quot;type&quot;:&quot;CLIPPED_CHORD&quot;},&quot;clipDistance&quot;:2,&quot;name&quot;:&quot;short-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2.5,&quot;y&quot;:-2.5,&quot;isEndPoint&quot;:true},{&quot;x&quot;:-2.5,&quot;y&quot;:2.5,&quot;isEndPoint&quot;:true}],&quot;closed&quot;:true}},&quot;pathStyles&quot;:[{&quot;type&quot;:&quot;FILL&quot;,&quot;fillStyle&quot;:&quot;context-stroke-flat&quot;}]}},&quot;name&quot;:&quot;Straight arrow (thick, large arrowhead, editable)&quot;,&quot;displayName&quot;:&quot;Straight arrow (thick, large arrowhead, editable)&quot;,&quot;source&quot;:{&quot;id&quot;:&quot;648741de5ca6211d7d057176&quot;,&quot;type&quot;:&quot;ASSETS&quot;},&quot;isPremium&quot;:false},&quot;b7396c60-43ee-421e-9e57-131b23603bdb&quot;:{&quot;relativeTransform&quot;:{&quot;translate&quot;:{&quot;x&quot;:313.1645406273183,&quot;y&quot;:-177.0348845785116},&quot;rotate&quot;:3.141592653589793,&quot;skewX&quot;:0,&quot;scale&quot;:{&quot;x&quot;:0.9999999999999998,&quot;y&quot;:0.9999999999999998}},&quot;type&quot;:&quot;FIGURE_OBJECT&quot;,&quot;id&quot;:&quot;b7396c60-43ee-421e-9e57-131b23603bdb&quot;,&quot;opacity&quot;:1,&quot;path&quot;:{&quot;type&quot;:&quot;POLY_LINE&quot;,&quot;points&quot;:[{&quot;x&quot;:0,&quot;y&quot;:29.91988592127491},{&quot;x&quot;:0,&quot;y&quot;:-29.91988592127491}],&quot;closed&quot;:false},&quot;pathStyles&quot;:[{&quot;type&quot;:&quot;FILL&quot;,&quot;fillStyle&quot;:&quot;rgba(0,0,0,0)&quot;},{&quot;type&quot;:&quot;STROKE&quot;,&quot;strokeStyle&quot;:&quot;#232323&quot;,&quot;lineWidth&quot;:9.634241258256798,&quot;lineJoin&quot;:&quot;round&quot;}],&quot;isLocked&quot;:false,&quot;parent&quot;:{&quot;type&quot;:&quot;CHILD&quot;,&quot;parentId&quot;:&quot;82468011-4845-45d2-ae7e-533a19310ec4&quot;,&quot;order&quot;:&quot;9999999999999&quot;},&quot;connectorInfo&quot;:{&quot;connectedObjects&quot;:[],&quot;type&quot;:&quot;LINE&quot;,&quot;offset&quot;:{&quot;x&quot;:0,&quot;y&quot;:0},&quot;bending&quot;:0.1,&quot;firstElementIsHead&quot;:true,&quot;customized&quot;:false},&quot;pathMarkers&quot;:{&quot;markerEnd&quot;:{&quot;type&quot;:&quot;PATH&quot;,&quot;units&quot;:{&quot;type&quot;:&quot;STROKE_WIDTH&quot;,&quot;scale&quot;:0.5},&quot;orient&quot;:{&quot;type&quot;:&quot;CLIPPED_CHORD&quot;},&quot;clipDistance&quot;:2,&quot;name&quot;:&quot;short-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2.5,&quot;y&quot;:-2.5,&quot;isEndPoint&quot;:true},{&quot;x&quot;:-2.5,&quot;y&quot;:2.5,&quot;isEndPoint&quot;:true}],&quot;closed&quot;:true}},&quot;pathStyles&quot;:[{&quot;type&quot;:&quot;FILL&quot;,&quot;fillStyle&quot;:&quot;context-stroke-flat&quot;}]}},&quot;name&quot;:&quot;Straight arrow (thick, large arrowhead, editable)&quot;,&quot;displayName&quot;:&quot;Straight arrow (thick, large arrowhead, editable)&quot;,&quot;source&quot;:{&quot;id&quot;:&quot;648741de5ca6211d7d057176&quot;,&quot;type&quot;:&quot;ASSETS&quot;},&quot;isPremium&quot;:false},&quot;ec685a19-6c4a-4288-885a-01c108417700&quot;:{&quot;relativeTransform&quot;:{&quot;translate&quot;:{&quot;x&quot;:436.04497906783257,&quot;y&quot;:-180.34773639579578},&quot;rotate&quot;:3.141592653589793,&quot;skewX&quot;:0,&quot;scale&quot;:{&quot;x&quot;:0.9999999999999998,&quot;y&quot;:0.9999999999999998}},&quot;type&quot;:&quot;FIGURE_OBJECT&quot;,&quot;id&quot;:&quot;ec685a19-6c4a-4288-885a-01c108417700&quot;,&quot;opacity&quot;:1,&quot;path&quot;:{&quot;type&quot;:&quot;POLY_LINE&quot;,&quot;points&quot;:[{&quot;x&quot;:0,&quot;y&quot;:29.91988592127491},{&quot;x&quot;:0,&quot;y&quot;:-29.91988592127491}],&quot;closed&quot;:false},&quot;pathStyles&quot;:[{&quot;type&quot;:&quot;FILL&quot;,&quot;fillStyle&quot;:&quot;rgba(0,0,0,0)&quot;},{&quot;type&quot;:&quot;STROKE&quot;,&quot;strokeStyle&quot;:&quot;#232323&quot;,&quot;lineWidth&quot;:9.634241258256798,&quot;lineJoin&quot;:&quot;round&quot;}],&quot;isLocked&quot;:false,&quot;parent&quot;:{&quot;type&quot;:&quot;CHILD&quot;,&quot;parentId&quot;:&quot;82468011-4845-45d2-ae7e-533a19310ec4&quot;,&quot;order&quot;:&quot;99999999999995&quot;},&quot;connectorInfo&quot;:{&quot;connectedObjects&quot;:[],&quot;type&quot;:&quot;LINE&quot;,&quot;offset&quot;:{&quot;x&quot;:0,&quot;y&quot;:0},&quot;bending&quot;:0.1,&quot;firstElementIsHead&quot;:true,&quot;customized&quot;:false},&quot;pathMarkers&quot;:{&quot;markerEnd&quot;:{&quot;type&quot;:&quot;PATH&quot;,&quot;units&quot;:{&quot;type&quot;:&quot;STROKE_WIDTH&quot;,&quot;scale&quot;:0.5},&quot;orient&quot;:{&quot;type&quot;:&quot;CLIPPED_CHORD&quot;},&quot;clipDistance&quot;:2,&quot;name&quot;:&quot;short-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2.5,&quot;y&quot;:-2.5,&quot;isEndPoint&quot;:true},{&quot;x&quot;:-2.5,&quot;y&quot;:2.5,&quot;isEndPoint&quot;:true}],&quot;closed&quot;:true}},&quot;pathStyles&quot;:[{&quot;type&quot;:&quot;FILL&quot;,&quot;fillStyle&quot;:&quot;context-stroke-flat&quot;}]}},&quot;name&quot;:&quot;Straight arrow (thick, large arrowhead, editable)&quot;,&quot;displayName&quot;:&quot;Straight arrow (thick, large arrowhead, editable)&quot;,&quot;source&quot;:{&quot;id&quot;:&quot;648741de5ca6211d7d057176&quot;,&quot;type&quot;:&quot;ASSETS&quot;},&quot;isPremium&quot;:false},&quot;91a35f98-8575-4fe1-bb6d-f0540201c969&quot;:{&quot;id&quot;:&quot;91a35f98-8575-4fe1-bb6d-f0540201c969&quot;,&quot;type&quot;:&quot;FIGURE_OBJECT&quot;,&quot;relativeTransform&quot;:{&quot;translate&quot;:{&quot;x&quot;:-34.152823715150575,&quot;y&quot;:-228.0846901471161},&quot;rotate&quot;:0,&quot;skewX&quot;:0,&quot;scale&quot;:{&quot;x&quot;:1,&quot;y&quot;:1}},&quot;text&quot;:{&quot;textData&quot;:{&quot;lineSpacing&quot;:&quot;normal&quot;,&quot;alignment&quot;:&quot;center&quot;,&quot;verticalAlign&quot;:&quot;TOP&quot;,&quot;lines&quot;:[{&quot;runs&quot;:[{&quot;style&quot;:{&quot;fontFamily&quot;:&quot;Roboto&quot;,&quot;fontSize&quot;:10.666666666666666,&quot;color&quot;:&quot;black&quot;,&quot;fontWeight&quot;:&quot;bold&quot;,&quot;fontStyle&quot;:&quot;normal&quot;,&quot;decoration&quot;:&quot;none&quot;},&quot;range&quot;:[0,6]}],&quot;text&quot;:&quot;MIC for&quot;},{&quot;runs&quot;:[{&quot;style&quot;:{&quot;fontFamily&quot;:&quot;Roboto&quot;,&quot;fontSize&quot;:10.666666666666666,&quot;color&quot;:&quot;black&quot;,&quot;fontWeight&quot;:&quot;bold&quot;,&quot;fontStyle&quot;:&quot;normal&quot;,&quot;decoration&quot;:&quot;none&quot;},&quot;range&quot;:[0,17]}],&quot;text&quot;:&quot; Resistant Isolate&quot;,&quot;baseStyle&quot;:{&quot;fontFamily&quot;:&quot;Roboto&quot;,&quot;fontSize&quot;:10.666666666666666,&quot;color&quot;:&quot;black&quot;,&quot;fontWeight&quot;:&quot;bold&quot;,&quot;fontStyle&quot;:&quot;normal&quot;,&quot;decoration&quot;:&quot;none&quot;,&quot;script&quot;:&quot;none&quot;}}],&quot;_lastCaretLocation&quot;:{&quot;lineIndex&quot;:0,&quot;runIndex&quot;:-1,&quot;charIndex&quot;:-1,&quot;endOfLine&quot;:true}},&quot;format&quot;:&quot;BETTER_TEXT&quot;,&quot;size&quot;:{&quot;x&quot;:121.7444828791618,&quot;y&quot;:26},&quot;targetSize&quot;:{&quot;x&quot;:121.7444828791618,&quot;y&quot;:26}},&quot;parent&quot;:{&quot;type&quot;:&quot;CHILD&quot;,&quot;parentId&quot;:&quot;82468011-4845-45d2-ae7e-533a19310ec4&quot;,&quot;order&quot;:&quot;99999999999997&quot;}},&quot;293d6f33-0564-46a4-b60e-9cedbd46a2b1&quot;:{&quot;id&quot;:&quot;293d6f33-0564-46a4-b60e-9cedbd46a2b1&quot;,&quot;type&quot;:&quot;FIGURE_OBJECT&quot;,&quot;relativeTransform&quot;:{&quot;translate&quot;:{&quot;x&quot;:87.59113949877002,&quot;y&quot;:-234.58480954046482},&quot;rotate&quot;:0,&quot;skewX&quot;:0,&quot;scale&quot;:{&quot;x&quot;:1,&quot;y&quot;:1}},&quot;text&quot;:{&quot;textData&quot;:{&quot;lineSpacing&quot;:&quot;normal&quot;,&quot;alignment&quot;:&quot;center&quot;,&quot;verticalAlign&quot;:&quot;TOP&quot;,&quot;lines&quot;:[{&quot;runs&quot;:[{&quot;style&quot;:{&quot;fontFamily&quot;:&quot;Roboto&quot;,&quot;fontSize&quot;:10.666666666666666,&quot;color&quot;:&quot;#000000&quot;,&quot;fontWeight&quot;:&quot;bold&quot;,&quot;fontStyle&quot;:&quot;normal&quot;,&quot;decoration&quot;:&quot;none&quot;},&quot;range&quot;:[0,27]}],&quot;text&quot;:&quot;Challenge Concentration for &quot;,&quot;baseStyle&quot;:{&quot;fontFamily&quot;:&quot;Roboto&quot;,&quot;fontSize&quot;:10.666666666666666,&quot;color&quot;:&quot;#000000&quot;,&quot;fontWeight&quot;:&quot;bold&quot;,&quot;fontStyle&quot;:&quot;normal&quot;,&quot;decoration&quot;:&quot;none&quot;,&quot;script&quot;:&quot;none&quot;}},{&quot;runs&quot;:[{&quot;style&quot;:{&quot;fontFamily&quot;:&quot;Roboto&quot;,&quot;fontSize&quot;:10.666666666666666,&quot;color&quot;:&quot;#000000&quot;,&quot;fontWeight&quot;:&quot;bold&quot;,&quot;fontStyle&quot;:&quot;normal&quot;,&quot;decoration&quot;:&quot;none&quot;},&quot;range&quot;:[0,16]}],&quot;text&quot;:&quot;Resistant Isolate&quot;,&quot;baseStyle&quot;:{&quot;fontFamily&quot;:&quot;Roboto&quot;,&quot;fontSize&quot;:10.666666666666666,&quot;color&quot;:&quot;#000000&quot;,&quot;fontWeight&quot;:&quot;bold&quot;,&quot;fontStyle&quot;:&quot;normal&quot;,&quot;decoration&quot;:&quot;none&quot;,&quot;script&quot;:&quot;none&quot;}}],&quot;_lastCaretLocation&quot;:{&quot;lineIndex&quot;:0,&quot;runIndex&quot;:0,&quot;charIndex&quot;:29}},&quot;format&quot;:&quot;BETTER_TEXT&quot;,&quot;size&quot;:{&quot;x&quot;:121.7444828791618,&quot;y&quot;:39},&quot;targetSize&quot;:{&quot;x&quot;:121.7444828791618,&quot;y&quot;:26}},&quot;parent&quot;:{&quot;type&quot;:&quot;CHILD&quot;,&quot;parentId&quot;:&quot;82468011-4845-45d2-ae7e-533a19310ec4&quot;,&quot;order&quot;:&quot;99999999999998&quot;}},&quot;cc8d3fdf-a698-4613-b531-f8b1069c812f&quot;:{&quot;id&quot;:&quot;cc8d3fdf-a698-4613-b531-f8b1069c812f&quot;,&quot;type&quot;:&quot;FIGURE_OBJECT&quot;,&quot;relativeTransform&quot;:{&quot;translate&quot;:{&quot;x&quot;:419.1274057136176,&quot;y&quot;:-234.58529518099064},&quot;rotate&quot;:0,&quot;skewX&quot;:0,&quot;scale&quot;:{&quot;x&quot;:1,&quot;y&quot;:1}},&quot;text&quot;:{&quot;textData&quot;:{&quot;lineSpacing&quot;:&quot;normal&quot;,&quot;alignment&quot;:&quot;center&quot;,&quot;verticalAlign&quot;:&quot;TOP&quot;,&quot;lines&quot;:[{&quot;runs&quot;:[{&quot;style&quot;:{&quot;fontFamily&quot;:&quot;Roboto&quot;,&quot;fontSize&quot;:10.666666666666666,&quot;color&quot;:&quot;#000000&quot;,&quot;fontWeight&quot;:&quot;bold&quot;,&quot;fontStyle&quot;:&quot;normal&quot;,&quot;decoration&quot;:&quot;none&quot;},&quot;range&quot;:[0,27]}],&quot;text&quot;:&quot;Challenge Concentration for &quot;,&quot;baseStyle&quot;:{&quot;fontFamily&quot;:&quot;Roboto&quot;,&quot;fontSize&quot;:10.666666666666666,&quot;color&quot;:&quot;#000000&quot;,&quot;fontWeight&quot;:&quot;bold&quot;,&quot;fontStyle&quot;:&quot;normal&quot;,&quot;decoration&quot;:&quot;none&quot;,&quot;script&quot;:&quot;none&quot;}},{&quot;runs&quot;:[{&quot;style&quot;:{&quot;fontFamily&quot;:&quot;Roboto&quot;,&quot;fontSize&quot;:10.666666666666666,&quot;color&quot;:&quot;#000000&quot;,&quot;fontWeight&quot;:&quot;bold&quot;,&quot;fontStyle&quot;:&quot;normal&quot;,&quot;decoration&quot;:&quot;none&quot;},&quot;range&quot;:[0,18]}],&quot;text&quot;:&quot;Susceptible Isolate&quot;}],&quot;_lastCaretLocation&quot;:{&quot;lineIndex&quot;:1,&quot;runIndex&quot;:0,&quot;charIndex&quot;:11}},&quot;format&quot;:&quot;BETTER_TEXT&quot;,&quot;size&quot;:{&quot;x&quot;:121.7444828791618,&quot;y&quot;:39},&quot;targetSize&quot;:{&quot;x&quot;:121.7444828791618,&quot;y&quot;:26}},&quot;parent&quot;:{&quot;type&quot;:&quot;CHILD&quot;,&quot;parentId&quot;:&quot;82468011-4845-45d2-ae7e-533a19310ec4&quot;,&quot;order&quot;:&quot;99999999999999&quot;}},&quot;746f8c1a-8986-4a2f-a309-cd1c75534c6f&quot;:{&quot;id&quot;:&quot;746f8c1a-8986-4a2f-a309-cd1c75534c6f&quot;,&quot;type&quot;:&quot;FIGURE_OBJECT&quot;,&quot;relativeTransform&quot;:{&quot;translate&quot;:{&quot;x&quot;:302.1416009379027,&quot;y&quot;:-228.08495765276186},&quot;rotate&quot;:0,&quot;skewX&quot;:0,&quot;scale&quot;:{&quot;x&quot;:1,&quot;y&quot;:1}},&quot;text&quot;:{&quot;textData&quot;:{&quot;lineSpacing&quot;:&quot;normal&quot;,&quot;alignment&quot;:&quot;center&quot;,&quot;verticalAlign&quot;:&quot;TOP&quot;,&quot;lines&quot;:[{&quot;runs&quot;:[{&quot;style&quot;:{&quot;fontFamily&quot;:&quot;Roboto&quot;,&quot;fontSize&quot;:10.666666666666666,&quot;color&quot;:&quot;black&quot;,&quot;fontWeight&quot;:&quot;bold&quot;,&quot;fontStyle&quot;:&quot;normal&quot;,&quot;decoration&quot;:&quot;none&quot;},&quot;range&quot;:[0,6]}],&quot;text&quot;:&quot;MIC for&quot;},{&quot;runs&quot;:[{&quot;style&quot;:{&quot;fontFamily&quot;:&quot;Roboto&quot;,&quot;fontSize&quot;:10.666666666666666,&quot;color&quot;:&quot;black&quot;,&quot;fontWeight&quot;:&quot;bold&quot;,&quot;fontStyle&quot;:&quot;normal&quot;,&quot;decoration&quot;:&quot;none&quot;},&quot;range&quot;:[0,17]}],&quot;text&quot;:&quot; Resistant Isolate&quot;,&quot;baseStyle&quot;:{&quot;fontFamily&quot;:&quot;Roboto&quot;,&quot;fontSize&quot;:10.666666666666666,&quot;color&quot;:&quot;black&quot;,&quot;fontWeight&quot;:&quot;bold&quot;,&quot;fontStyle&quot;:&quot;normal&quot;,&quot;decoration&quot;:&quot;none&quot;,&quot;script&quot;:&quot;none&quot;}}],&quot;_lastCaretLocation&quot;:{&quot;lineIndex&quot;:0,&quot;runIndex&quot;:-1,&quot;charIndex&quot;:-1,&quot;endOfLine&quot;:true}},&quot;format&quot;:&quot;BETTER_TEXT&quot;,&quot;size&quot;:{&quot;x&quot;:121.7444828791618,&quot;y&quot;:26},&quot;targetSize&quot;:{&quot;x&quot;:121.7444828791618,&quot;y&quot;:26}},&quot;parent&quot;:{&quot;type&quot;:&quot;CHILD&quot;,&quot;parentId&quot;:&quot;82468011-4845-45d2-ae7e-533a19310ec4&quot;,&quot;order&quot;:&quot;999999999999995&quot;}},&quot;37e2aa28-cd10-4bfd-92df-0a3c31376c99&quot;:{&quot;id&quot;:&quot;37e2aa28-cd10-4bfd-92df-0a3c31376c99&quot;,&quot;type&quot;:&quot;FIGURE_OBJECT&quot;,&quot;document&quot;:{&quot;type&quot;:&quot;DOCUMENT_GROUP&quot;,&quot;canvasType&quot;:&quot;FIGURE&quot;,&quot;units&quot;:&quot;in&quot;}}}}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9695d10ed4b5880ee2c709d"/>
  <p:tag name="FIGURESLIDEID" val="82468011-4845-45d2-ae7e-533a19310ec4"/>
  <p:tag name="SELECTIONIDS" val="401e99b0-db7f-47f1-92e1-9a088688b26c"/>
  <p:tag name="TRANSPARENTBACKGROUND" val="true"/>
  <p:tag name="VERSION" val="1770643664268"/>
  <p:tag name="TITLE" val="Broth Dilution"/>
  <p:tag name="CREATORNAME" val="Woubit Abebe"/>
  <p:tag name="DATEINSERTED" val="1770643663814"/>
  <p:tag name="DPI" val="300"/>
  <p:tag name="BIOJSON" val="{&quot;id&quot;:&quot;37e2aa28-cd10-4bfd-92df-0a3c31376c99&quot;,&quot;objects&quot;:{&quot;401e99b0-db7f-47f1-92e1-9a088688b26c&quot;:{&quot;id&quot;:&quot;401e99b0-db7f-47f1-92e1-9a088688b26c&quot;,&quot;name&quot;:&quot;Test tube (15 mL, 1/2 liquid)&quot;,&quot;displayName&quot;:&quot;&quot;,&quot;type&quot;:&quot;FIGURE_OBJECT&quot;,&quot;relativeTransform&quot;:{&quot;translate&quot;:{&quot;x&quot;:28.086714122830855,&quot;y&quot;:-5.116172516627941},&quot;rotate&quot;:0,&quot;skewX&quot;:0,&quot;scale&quot;:{&quot;x&quot;:0.7117130970948358,&quot;y&quot;:0.7117130970948358}},&quot;image&quot;:{&quot;url&quot;:&quot;https://icons.cdn.biorender.com/biorender/5e56940cc45c7c0028ca1e8e/20200226201646/image/5e56940cc45c7c0028ca1e8e.png&quot;,&quot;isPremium&quot;:true,&quot;isOrgIcon&quot;:false,&quot;size&quot;:{&quot;x&quot;:50,&quot;y&quot;:222.80701754385964}},&quot;source&quot;:{&quot;id&quot;:&quot;5e56940cc45c7c0028ca1e8e&quot;,&quot;version&quot;:&quot;20200226201646&quot;,&quot;type&quot;:&quot;ASSETS&quot;},&quot;isPremium&quot;:true,&quot;parent&quot;:{&quot;type&quot;:&quot;CHILD&quot;,&quot;parentId&quot;:&quot;82468011-4845-45d2-ae7e-533a19310ec4&quot;,&quot;order&quot;:&quot;995&quot;}},&quot;82468011-4845-45d2-ae7e-533a19310ec4&quot;:{&quot;id&quot;:&quot;82468011-4845-45d2-ae7e-533a19310ec4&quot;,&quot;type&quot;:&quot;FIGURE_OBJECT&quot;,&quot;document&quot;:{&quot;type&quot;:&quot;FIGURE&quot;,&quot;canvasType&quot;:&quot;FIGURE&quot;,&quot;units&quot;:&quot;in&quot;},&quot;parent&quot;:{&quot;parentId&quot;:&quot;37e2aa28-cd10-4bfd-92df-0a3c31376c99&quot;,&quot;type&quot;:&quot;DOCUMENT&quot;,&quot;order&quot;:&quot;5&quot;}},&quot;37e2aa28-cd10-4bfd-92df-0a3c31376c99&quot;:{&quot;id&quot;:&quot;37e2aa28-cd10-4bfd-92df-0a3c31376c99&quot;,&quot;type&quot;:&quot;FIGURE_OBJECT&quot;,&quot;document&quot;:{&quot;type&quot;:&quot;DOCUMENT_GROUP&quot;,&quot;canvasType&quot;:&quot;FIGURE&quot;,&quot;units&quot;:&quot;in&quot;}}}}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9695d10ed4b5880ee2c709d"/>
  <p:tag name="FIGURESLIDEID" val="82468011-4845-45d2-ae7e-533a19310ec4"/>
  <p:tag name="SELECTIONIDS" val="c5a4bf77-e8e0-4e41-8007-e2aa10b63c49"/>
  <p:tag name="TRANSPARENTBACKGROUND" val="true"/>
  <p:tag name="VERSION" val="1770643664268"/>
  <p:tag name="TITLE" val="Broth Dilution"/>
  <p:tag name="CREATORNAME" val="Woubit Abebe"/>
  <p:tag name="DATEINSERTED" val="1770643663814"/>
  <p:tag name="DPI" val="300"/>
  <p:tag name="BIOJSON" val="{&quot;id&quot;:&quot;37e2aa28-cd10-4bfd-92df-0a3c31376c99&quot;,&quot;objects&quot;:{&quot;c5a4bf77-e8e0-4e41-8007-e2aa10b63c49&quot;:{&quot;id&quot;:&quot;c5a4bf77-e8e0-4e41-8007-e2aa10b63c49&quot;,&quot;name&quot;:&quot;Test tube (15 mL, 1/2 liquid)&quot;,&quot;displayName&quot;:&quot;&quot;,&quot;type&quot;:&quot;FIGURE_OBJECT&quot;,&quot;relativeTransform&quot;:{&quot;translate&quot;:{&quot;x&quot;:85.85157325754513,&quot;y&quot;:-5.116172516627941},&quot;rotate&quot;:0,&quot;skewX&quot;:0,&quot;scale&quot;:{&quot;x&quot;:0.7117130970948358,&quot;y&quot;:0.7117130970948358}},&quot;image&quot;:{&quot;url&quot;:&quot;https://icons.cdn.biorender.com/biorender/5e56940cc45c7c0028ca1e8e/20200226201646/image/5e56940cc45c7c0028ca1e8e.png&quot;,&quot;isPremium&quot;:true,&quot;isOrgIcon&quot;:false,&quot;size&quot;:{&quot;x&quot;:50,&quot;y&quot;:222.80701754385964}},&quot;source&quot;:{&quot;id&quot;:&quot;5e56940cc45c7c0028ca1e8e&quot;,&quot;version&quot;:&quot;20200226201646&quot;,&quot;type&quot;:&quot;ASSETS&quot;},&quot;isPremium&quot;:true,&quot;parent&quot;:{&quot;type&quot;:&quot;CHILD&quot;,&quot;parentId&quot;:&quot;82468011-4845-45d2-ae7e-533a19310ec4&quot;,&quot;order&quot;:&quot;997&quot;}},&quot;82468011-4845-45d2-ae7e-533a19310ec4&quot;:{&quot;id&quot;:&quot;82468011-4845-45d2-ae7e-533a19310ec4&quot;,&quot;type&quot;:&quot;FIGURE_OBJECT&quot;,&quot;document&quot;:{&quot;type&quot;:&quot;FIGURE&quot;,&quot;canvasType&quot;:&quot;FIGURE&quot;,&quot;units&quot;:&quot;in&quot;},&quot;parent&quot;:{&quot;parentId&quot;:&quot;37e2aa28-cd10-4bfd-92df-0a3c31376c99&quot;,&quot;type&quot;:&quot;DOCUMENT&quot;,&quot;order&quot;:&quot;5&quot;}},&quot;37e2aa28-cd10-4bfd-92df-0a3c31376c99&quot;:{&quot;id&quot;:&quot;37e2aa28-cd10-4bfd-92df-0a3c31376c99&quot;,&quot;type&quot;:&quot;FIGURE_OBJECT&quot;,&quot;document&quot;:{&quot;type&quot;:&quot;DOCUMENT_GROUP&quot;,&quot;canvasType&quot;:&quot;FIGURE&quot;,&quot;units&quot;:&quot;in&quot;}}}}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9695d10ed4b5880ee2c709d"/>
  <p:tag name="FIGURESLIDEID" val="82468011-4845-45d2-ae7e-533a19310ec4"/>
  <p:tag name="SELECTIONIDS" val="fe06d0bc-52a5-4cf2-b4f4-de62190afb85"/>
  <p:tag name="TRANSPARENTBACKGROUND" val="true"/>
  <p:tag name="VERSION" val="1770643664268"/>
  <p:tag name="TITLE" val="Broth Dilution"/>
  <p:tag name="CREATORNAME" val="Woubit Abebe"/>
  <p:tag name="DATEINSERTED" val="1770643663814"/>
  <p:tag name="DPI" val="300"/>
  <p:tag name="BIOJSON" val="{&quot;id&quot;:&quot;37e2aa28-cd10-4bfd-92df-0a3c31376c99&quot;,&quot;objects&quot;:{&quot;fe06d0bc-52a5-4cf2-b4f4-de62190afb85&quot;:{&quot;id&quot;:&quot;fe06d0bc-52a5-4cf2-b4f4-de62190afb85&quot;,&quot;name&quot;:&quot;Test tube (15 mL, 1/2 liquid)&quot;,&quot;displayName&quot;:&quot;&quot;,&quot;type&quot;:&quot;FIGURE_OBJECT&quot;,&quot;relativeTransform&quot;:{&quot;translate&quot;:{&quot;x&quot;:143.61643239225936,&quot;y&quot;:-5.116172516627941},&quot;rotate&quot;:0,&quot;skewX&quot;:0,&quot;scale&quot;:{&quot;x&quot;:0.7117130970948358,&quot;y&quot;:0.7117130970948358}},&quot;image&quot;:{&quot;url&quot;:&quot;https://icons.cdn.biorender.com/biorender/5e56940cc45c7c0028ca1e8e/20200226201646/image/5e56940cc45c7c0028ca1e8e.png&quot;,&quot;isPremium&quot;:true,&quot;isOrgIcon&quot;:false,&quot;size&quot;:{&quot;x&quot;:50,&quot;y&quot;:222.80701754385964}},&quot;source&quot;:{&quot;id&quot;:&quot;5e56940cc45c7c0028ca1e8e&quot;,&quot;version&quot;:&quot;20200226201646&quot;,&quot;type&quot;:&quot;ASSETS&quot;},&quot;isPremium&quot;:true,&quot;parent&quot;:{&quot;type&quot;:&quot;CHILD&quot;,&quot;parentId&quot;:&quot;82468011-4845-45d2-ae7e-533a19310ec4&quot;,&quot;order&quot;:&quot;998&quot;}},&quot;82468011-4845-45d2-ae7e-533a19310ec4&quot;:{&quot;id&quot;:&quot;82468011-4845-45d2-ae7e-533a19310ec4&quot;,&quot;type&quot;:&quot;FIGURE_OBJECT&quot;,&quot;document&quot;:{&quot;type&quot;:&quot;FIGURE&quot;,&quot;canvasType&quot;:&quot;FIGURE&quot;,&quot;units&quot;:&quot;in&quot;},&quot;parent&quot;:{&quot;parentId&quot;:&quot;37e2aa28-cd10-4bfd-92df-0a3c31376c99&quot;,&quot;type&quot;:&quot;DOCUMENT&quot;,&quot;order&quot;:&quot;5&quot;}},&quot;37e2aa28-cd10-4bfd-92df-0a3c31376c99&quot;:{&quot;id&quot;:&quot;37e2aa28-cd10-4bfd-92df-0a3c31376c99&quot;,&quot;type&quot;:&quot;FIGURE_OBJECT&quot;,&quot;document&quot;:{&quot;type&quot;:&quot;DOCUMENT_GROUP&quot;,&quot;canvasType&quot;:&quot;FIGURE&quot;,&quot;units&quot;:&quot;in&quot;}}}}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9695d10ed4b5880ee2c709d"/>
  <p:tag name="FIGURESLIDEID" val="82468011-4845-45d2-ae7e-533a19310ec4"/>
  <p:tag name="SELECTIONIDS" val="814d49dc-236e-416f-958d-838cc5adf3db"/>
  <p:tag name="TRANSPARENTBACKGROUND" val="true"/>
  <p:tag name="VERSION" val="1770643664268"/>
  <p:tag name="TITLE" val="Broth Dilution"/>
  <p:tag name="CREATORNAME" val="Woubit Abebe"/>
  <p:tag name="DATEINSERTED" val="1770643663814"/>
  <p:tag name="DPI" val="300"/>
  <p:tag name="BIOJSON" val="{&quot;id&quot;:&quot;37e2aa28-cd10-4bfd-92df-0a3c31376c99&quot;,&quot;objects&quot;:{&quot;814d49dc-236e-416f-958d-838cc5adf3db&quot;:{&quot;id&quot;:&quot;814d49dc-236e-416f-958d-838cc5adf3db&quot;,&quot;name&quot;:&quot;Test tube (15 mL, 1/2 liquid)&quot;,&quot;displayName&quot;:&quot;&quot;,&quot;type&quot;:&quot;FIGURE_OBJECT&quot;,&quot;relativeTransform&quot;:{&quot;translate&quot;:{&quot;x&quot;:201.38129152697365,&quot;y&quot;:-5.116172516627941},&quot;rotate&quot;:0,&quot;skewX&quot;:0,&quot;scale&quot;:{&quot;x&quot;:0.7117130970948358,&quot;y&quot;:0.7117130970948358}},&quot;image&quot;:{&quot;url&quot;:&quot;https://icons.cdn.biorender.com/biorender/5e56940cc45c7c0028ca1e8e/20200226201646/image/5e56940cc45c7c0028ca1e8e.png&quot;,&quot;isPremium&quot;:true,&quot;isOrgIcon&quot;:false,&quot;size&quot;:{&quot;x&quot;:50,&quot;y&quot;:222.80701754385964}},&quot;source&quot;:{&quot;id&quot;:&quot;5e56940cc45c7c0028ca1e8e&quot;,&quot;version&quot;:&quot;20200226201646&quot;,&quot;type&quot;:&quot;ASSETS&quot;},&quot;isPremium&quot;:true,&quot;parent&quot;:{&quot;type&quot;:&quot;CHILD&quot;,&quot;parentId&quot;:&quot;82468011-4845-45d2-ae7e-533a19310ec4&quot;,&quot;order&quot;:&quot;999&quot;}},&quot;82468011-4845-45d2-ae7e-533a19310ec4&quot;:{&quot;id&quot;:&quot;82468011-4845-45d2-ae7e-533a19310ec4&quot;,&quot;type&quot;:&quot;FIGURE_OBJECT&quot;,&quot;document&quot;:{&quot;type&quot;:&quot;FIGURE&quot;,&quot;canvasType&quot;:&quot;FIGURE&quot;,&quot;units&quot;:&quot;in&quot;},&quot;parent&quot;:{&quot;parentId&quot;:&quot;37e2aa28-cd10-4bfd-92df-0a3c31376c99&quot;,&quot;type&quot;:&quot;DOCUMENT&quot;,&quot;order&quot;:&quot;5&quot;}},&quot;37e2aa28-cd10-4bfd-92df-0a3c31376c99&quot;:{&quot;id&quot;:&quot;37e2aa28-cd10-4bfd-92df-0a3c31376c99&quot;,&quot;type&quot;:&quot;FIGURE_OBJECT&quot;,&quot;document&quot;:{&quot;type&quot;:&quot;DOCUMENT_GROUP&quot;,&quot;canvasType&quot;:&quot;FIGURE&quot;,&quot;units&quot;:&quot;in&quot;}}}}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9695d10ed4b5880ee2c709d"/>
  <p:tag name="FIGURESLIDEID" val="82468011-4845-45d2-ae7e-533a19310ec4"/>
  <p:tag name="SELECTIONIDS" val="db077e4d-a26c-4d2b-a647-b477e5f45157"/>
  <p:tag name="TRANSPARENTBACKGROUND" val="true"/>
  <p:tag name="VERSION" val="1770643664268"/>
  <p:tag name="TITLE" val="Broth Dilution"/>
  <p:tag name="CREATORNAME" val="Woubit Abebe"/>
  <p:tag name="DATEINSERTED" val="1770643663814"/>
  <p:tag name="DPI" val="300"/>
  <p:tag name="BIOJSON" val="{&quot;id&quot;:&quot;37e2aa28-cd10-4bfd-92df-0a3c31376c99&quot;,&quot;objects&quot;:{&quot;db077e4d-a26c-4d2b-a647-b477e5f45157&quot;:{&quot;id&quot;:&quot;db077e4d-a26c-4d2b-a647-b477e5f45157&quot;,&quot;name&quot;:&quot;Test tube (15 mL, 1/2 liquid)&quot;,&quot;displayName&quot;:&quot;&quot;,&quot;type&quot;:&quot;FIGURE_OBJECT&quot;,&quot;relativeTransform&quot;:{&quot;translate&quot;:{&quot;x&quot;:259.1461506616879,&quot;y&quot;:-5.116172516627941},&quot;rotate&quot;:0,&quot;skewX&quot;:0,&quot;scale&quot;:{&quot;x&quot;:0.7117130970948358,&quot;y&quot;:0.7117130970948358}},&quot;image&quot;:{&quot;url&quot;:&quot;https://icons.cdn.biorender.com/biorender/5e56940cc45c7c0028ca1e8e/20200226201646/image/5e56940cc45c7c0028ca1e8e.png&quot;,&quot;isPremium&quot;:true,&quot;isOrgIcon&quot;:false,&quot;size&quot;:{&quot;x&quot;:50,&quot;y&quot;:222.80701754385964}},&quot;source&quot;:{&quot;id&quot;:&quot;5e56940cc45c7c0028ca1e8e&quot;,&quot;version&quot;:&quot;20200226201646&quot;,&quot;type&quot;:&quot;ASSETS&quot;},&quot;isPremium&quot;:true,&quot;parent&quot;:{&quot;type&quot;:&quot;CHILD&quot;,&quot;parentId&quot;:&quot;82468011-4845-45d2-ae7e-533a19310ec4&quot;,&quot;order&quot;:&quot;9995&quot;}},&quot;82468011-4845-45d2-ae7e-533a19310ec4&quot;:{&quot;id&quot;:&quot;82468011-4845-45d2-ae7e-533a19310ec4&quot;,&quot;type&quot;:&quot;FIGURE_OBJECT&quot;,&quot;document&quot;:{&quot;type&quot;:&quot;FIGURE&quot;,&quot;canvasType&quot;:&quot;FIGURE&quot;,&quot;units&quot;:&quot;in&quot;},&quot;parent&quot;:{&quot;parentId&quot;:&quot;37e2aa28-cd10-4bfd-92df-0a3c31376c99&quot;,&quot;type&quot;:&quot;DOCUMENT&quot;,&quot;order&quot;:&quot;5&quot;}},&quot;37e2aa28-cd10-4bfd-92df-0a3c31376c99&quot;:{&quot;id&quot;:&quot;37e2aa28-cd10-4bfd-92df-0a3c31376c99&quot;,&quot;type&quot;:&quot;FIGURE_OBJECT&quot;,&quot;document&quot;:{&quot;type&quot;:&quot;DOCUMENT_GROUP&quot;,&quot;canvasType&quot;:&quot;FIGURE&quot;,&quot;units&quot;:&quot;in&quot;}}}}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9695d10ed4b5880ee2c709d"/>
  <p:tag name="FIGURESLIDEID" val="82468011-4845-45d2-ae7e-533a19310ec4"/>
  <p:tag name="SELECTIONIDS" val="d69a8487-0e56-4698-a021-c90245988433"/>
  <p:tag name="TRANSPARENTBACKGROUND" val="true"/>
  <p:tag name="VERSION" val="1770643664268"/>
  <p:tag name="TITLE" val="Broth Dilution"/>
  <p:tag name="CREATORNAME" val="Woubit Abebe"/>
  <p:tag name="DATEINSERTED" val="1770643663814"/>
  <p:tag name="DPI" val="300"/>
  <p:tag name="BIOJSON" val="{&quot;id&quot;:&quot;37e2aa28-cd10-4bfd-92df-0a3c31376c99&quot;,&quot;objects&quot;:{&quot;d69a8487-0e56-4698-a021-c90245988433&quot;:{&quot;id&quot;:&quot;d69a8487-0e56-4698-a021-c90245988433&quot;,&quot;name&quot;:&quot;Test tube (15 mL, 1/2 liquid)&quot;,&quot;displayName&quot;:&quot;&quot;,&quot;type&quot;:&quot;FIGURE_OBJECT&quot;,&quot;relativeTransform&quot;:{&quot;translate&quot;:{&quot;x&quot;:316.91100979640214,&quot;y&quot;:-5.116172516627941},&quot;rotate&quot;:0,&quot;skewX&quot;:0,&quot;scale&quot;:{&quot;x&quot;:0.7117130970948358,&quot;y&quot;:0.7117130970948358}},&quot;image&quot;:{&quot;url&quot;:&quot;https://icons.cdn.biorender.com/biorender/5e56940cc45c7c0028ca1e8e/20200226201646/image/5e56940cc45c7c0028ca1e8e.png&quot;,&quot;isPremium&quot;:true,&quot;isOrgIcon&quot;:false,&quot;size&quot;:{&quot;x&quot;:50,&quot;y&quot;:222.80701754385964}},&quot;source&quot;:{&quot;id&quot;:&quot;5e56940cc45c7c0028ca1e8e&quot;,&quot;version&quot;:&quot;20200226201646&quot;,&quot;type&quot;:&quot;ASSETS&quot;},&quot;isPremium&quot;:true,&quot;parent&quot;:{&quot;type&quot;:&quot;CHILD&quot;,&quot;parentId&quot;:&quot;82468011-4845-45d2-ae7e-533a19310ec4&quot;,&quot;order&quot;:&quot;9997&quot;}},&quot;82468011-4845-45d2-ae7e-533a19310ec4&quot;:{&quot;id&quot;:&quot;82468011-4845-45d2-ae7e-533a19310ec4&quot;,&quot;type&quot;:&quot;FIGURE_OBJECT&quot;,&quot;document&quot;:{&quot;type&quot;:&quot;FIGURE&quot;,&quot;canvasType&quot;:&quot;FIGURE&quot;,&quot;units&quot;:&quot;in&quot;},&quot;parent&quot;:{&quot;parentId&quot;:&quot;37e2aa28-cd10-4bfd-92df-0a3c31376c99&quot;,&quot;type&quot;:&quot;DOCUMENT&quot;,&quot;order&quot;:&quot;5&quot;}},&quot;37e2aa28-cd10-4bfd-92df-0a3c31376c99&quot;:{&quot;id&quot;:&quot;37e2aa28-cd10-4bfd-92df-0a3c31376c99&quot;,&quot;type&quot;:&quot;FIGURE_OBJECT&quot;,&quot;document&quot;:{&quot;type&quot;:&quot;DOCUMENT_GROUP&quot;,&quot;canvasType&quot;:&quot;FIGURE&quot;,&quot;units&quot;:&quot;in&quot;}}}}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9695d10ed4b5880ee2c709d"/>
  <p:tag name="FIGURESLIDEID" val="82468011-4845-45d2-ae7e-533a19310ec4"/>
  <p:tag name="SELECTIONIDS" val="a5ff86f5-a462-4280-965a-b119be7f14b6"/>
  <p:tag name="TRANSPARENTBACKGROUND" val="true"/>
  <p:tag name="VERSION" val="1770643664268"/>
  <p:tag name="TITLE" val="Broth Dilution"/>
  <p:tag name="CREATORNAME" val="Woubit Abebe"/>
  <p:tag name="DATEINSERTED" val="1770643663814"/>
  <p:tag name="DPI" val="300"/>
  <p:tag name="BIOJSON" val="{&quot;id&quot;:&quot;37e2aa28-cd10-4bfd-92df-0a3c31376c99&quot;,&quot;objects&quot;:{&quot;a5ff86f5-a462-4280-965a-b119be7f14b6&quot;:{&quot;id&quot;:&quot;a5ff86f5-a462-4280-965a-b119be7f14b6&quot;,&quot;name&quot;:&quot;Test tube (15 mL, 1/2 liquid)&quot;,&quot;displayName&quot;:&quot;&quot;,&quot;type&quot;:&quot;FIGURE_OBJECT&quot;,&quot;relativeTransform&quot;:{&quot;translate&quot;:{&quot;x&quot;:374.6758689311164,&quot;y&quot;:-5.116172516627941},&quot;rotate&quot;:0,&quot;skewX&quot;:0,&quot;scale&quot;:{&quot;x&quot;:0.7117130970948358,&quot;y&quot;:0.7117130970948358}},&quot;image&quot;:{&quot;url&quot;:&quot;https://icons.cdn.biorender.com/biorender/5e56940cc45c7c0028ca1e8e/20200226201646/image/5e56940cc45c7c0028ca1e8e.png&quot;,&quot;isPremium&quot;:true,&quot;isOrgIcon&quot;:false,&quot;size&quot;:{&quot;x&quot;:50,&quot;y&quot;:222.80701754385964}},&quot;source&quot;:{&quot;id&quot;:&quot;5e56940cc45c7c0028ca1e8e&quot;,&quot;version&quot;:&quot;20200226201646&quot;,&quot;type&quot;:&quot;ASSETS&quot;},&quot;isPremium&quot;:true,&quot;parent&quot;:{&quot;type&quot;:&quot;CHILD&quot;,&quot;parentId&quot;:&quot;82468011-4845-45d2-ae7e-533a19310ec4&quot;,&quot;order&quot;:&quot;9998&quot;}},&quot;82468011-4845-45d2-ae7e-533a19310ec4&quot;:{&quot;id&quot;:&quot;82468011-4845-45d2-ae7e-533a19310ec4&quot;,&quot;type&quot;:&quot;FIGURE_OBJECT&quot;,&quot;document&quot;:{&quot;type&quot;:&quot;FIGURE&quot;,&quot;canvasType&quot;:&quot;FIGURE&quot;,&quot;units&quot;:&quot;in&quot;},&quot;parent&quot;:{&quot;parentId&quot;:&quot;37e2aa28-cd10-4bfd-92df-0a3c31376c99&quot;,&quot;type&quot;:&quot;DOCUMENT&quot;,&quot;order&quot;:&quot;5&quot;}},&quot;37e2aa28-cd10-4bfd-92df-0a3c31376c99&quot;:{&quot;id&quot;:&quot;37e2aa28-cd10-4bfd-92df-0a3c31376c99&quot;,&quot;type&quot;:&quot;FIGURE_OBJECT&quot;,&quot;document&quot;:{&quot;type&quot;:&quot;DOCUMENT_GROUP&quot;,&quot;canvasType&quot;:&quot;FIGURE&quot;,&quot;units&quot;:&quot;in&quot;}}}}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9695d10ed4b5880ee2c709d"/>
  <p:tag name="FIGURESLIDEID" val="82468011-4845-45d2-ae7e-533a19310ec4"/>
  <p:tag name="SELECTIONIDS" val="4488bf75-7dc2-4237-8de6-24bdc3f4461f"/>
  <p:tag name="TRANSPARENTBACKGROUND" val="true"/>
  <p:tag name="VERSION" val="1770643664268"/>
  <p:tag name="TITLE" val="Broth Dilution"/>
  <p:tag name="CREATORNAME" val="Woubit Abebe"/>
  <p:tag name="DATEINSERTED" val="1770643663814"/>
  <p:tag name="DPI" val="300"/>
  <p:tag name="BIOJSON" val="{&quot;id&quot;:&quot;37e2aa28-cd10-4bfd-92df-0a3c31376c99&quot;,&quot;objects&quot;:{&quot;4488bf75-7dc2-4237-8de6-24bdc3f4461f&quot;:{&quot;id&quot;:&quot;4488bf75-7dc2-4237-8de6-24bdc3f4461f&quot;,&quot;name&quot;:&quot;Test tube (15 mL, 1/2 liquid)&quot;,&quot;displayName&quot;:&quot;&quot;,&quot;type&quot;:&quot;FIGURE_OBJECT&quot;,&quot;relativeTransform&quot;:{&quot;translate&quot;:{&quot;x&quot;:432.4407280658307,&quot;y&quot;:-5.116172516627941},&quot;rotate&quot;:0,&quot;skewX&quot;:0,&quot;scale&quot;:{&quot;x&quot;:0.7117130970948358,&quot;y&quot;:0.7117130970948358}},&quot;image&quot;:{&quot;url&quot;:&quot;https://icons.cdn.biorender.com/biorender/5e56940cc45c7c0028ca1e8e/20200226201646/image/5e56940cc45c7c0028ca1e8e.png&quot;,&quot;isPremium&quot;:true,&quot;isOrgIcon&quot;:false,&quot;size&quot;:{&quot;x&quot;:50,&quot;y&quot;:222.80701754385964}},&quot;source&quot;:{&quot;id&quot;:&quot;5e56940cc45c7c0028ca1e8e&quot;,&quot;version&quot;:&quot;20200226201646&quot;,&quot;type&quot;:&quot;ASSETS&quot;},&quot;isPremium&quot;:true,&quot;parent&quot;:{&quot;type&quot;:&quot;CHILD&quot;,&quot;parentId&quot;:&quot;82468011-4845-45d2-ae7e-533a19310ec4&quot;,&quot;order&quot;:&quot;9999&quot;}},&quot;82468011-4845-45d2-ae7e-533a19310ec4&quot;:{&quot;id&quot;:&quot;82468011-4845-45d2-ae7e-533a19310ec4&quot;,&quot;type&quot;:&quot;FIGURE_OBJECT&quot;,&quot;document&quot;:{&quot;type&quot;:&quot;FIGURE&quot;,&quot;canvasType&quot;:&quot;FIGURE&quot;,&quot;units&quot;:&quot;in&quot;},&quot;parent&quot;:{&quot;parentId&quot;:&quot;37e2aa28-cd10-4bfd-92df-0a3c31376c99&quot;,&quot;type&quot;:&quot;DOCUMENT&quot;,&quot;order&quot;:&quot;5&quot;}},&quot;37e2aa28-cd10-4bfd-92df-0a3c31376c99&quot;:{&quot;id&quot;:&quot;37e2aa28-cd10-4bfd-92df-0a3c31376c99&quot;,&quot;type&quot;:&quot;FIGURE_OBJECT&quot;,&quot;document&quot;:{&quot;type&quot;:&quot;DOCUMENT_GROUP&quot;,&quot;canvasType&quot;:&quot;FIGURE&quot;,&quot;units&quot;:&quot;in&quot;}}}}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9695d10ed4b5880ee2c709d"/>
  <p:tag name="FIGURESLIDEID" val="82468011-4845-45d2-ae7e-533a19310ec4"/>
  <p:tag name="SELECTIONIDS" val="62676c2e-4b76-4b64-b20d-d668707f6443"/>
  <p:tag name="TRANSPARENTBACKGROUND" val="true"/>
  <p:tag name="VERSION" val="1770643664268"/>
  <p:tag name="TITLE" val="Broth Dilution"/>
  <p:tag name="CREATORNAME" val="Woubit Abebe"/>
  <p:tag name="DATEINSERTED" val="1770643663814"/>
  <p:tag name="DPI" val="300"/>
  <p:tag name="BIOJSON" val="{&quot;id&quot;:&quot;37e2aa28-cd10-4bfd-92df-0a3c31376c99&quot;,&quot;objects&quot;:{&quot;62676c2e-4b76-4b64-b20d-d668707f6443&quot;:{&quot;relativeTransform&quot;:{&quot;translate&quot;:{&quot;x&quot;:-438.4272188008795,&quot;y&quot;:37.09831177856836},&quot;rotate&quot;:0,&quot;skewX&quot;:0,&quot;scale&quot;:{&quot;x&quot;:1,&quot;y&quot;:1}},&quot;type&quot;:&quot;FIGURE_OBJECT&quot;,&quot;id&quot;:&quot;62676c2e-4b76-4b64-b20d-d668707f6443&quot;,&quot;opacity&quot;:1,&quot;path&quot;:{&quot;type&quot;:&quot;POLY_LINE&quot;,&quot;points&quot;:[{&quot;x&quot;:4.974641926767617,&quot;y&quot;:-137.02271231082307},{&quot;x&quot;:13.185661039235299,&quot;y&quot;:-158.41658203145784},{&quot;x&quot;:28.715525288267486,&quot;y&quot;:-168.3407703671512},{&quot;x&quot;:44.33526212272119,&quot;y&quot;:-158.81658203145784},{&quot;x&quot;:54.935953265994215,&quot;y&quot;:-135.79148492246026}],&quot;closed&quot;:false,&quot;selectedObjectIds&quot;:[&quot;69922a4c-8668-4e32-9dc7-a4d983b2e733&quot;]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82468011-4845-45d2-ae7e-533a19310ec4&quot;,&quot;order&quot;:&quot;999999998&quot;},&quot;connectorInfo&quot;:{&quot;connectedObjects&quot;:[],&quot;type&quot;:&quot;CUBIC&quot;,&quot;offset&quot;:{&quot;x&quot;:0,&quot;y&quot;:0},&quot;bending&quot;:-0.1,&quot;firstElementIsHead&quot;:true,&quot;customized&quot;:true},&quot;pathSmoothing&quot;:{&quot;type&quot;:&quot;CATMULL_SMOOTHING&quot;,&quot;smoothing&quot;:0.2},&quot;name&quot;:&quot;Curving arrow (editable) 4&quot;,&quot;displayName&quot;:&quot;Curving arrow (editable) 4&quot;,&quot;source&quot;:{&quot;id&quot;:&quot;62698ecb4e765946d04af2fb&quot;,&quot;type&quot;:&quot;ASSETS&quot;},&quot;isPremium&quot;:false},&quot;82468011-4845-45d2-ae7e-533a19310ec4&quot;:{&quot;id&quot;:&quot;82468011-4845-45d2-ae7e-533a19310ec4&quot;,&quot;type&quot;:&quot;FIGURE_OBJECT&quot;,&quot;document&quot;:{&quot;type&quot;:&quot;FIGURE&quot;,&quot;canvasType&quot;:&quot;FIGURE&quot;,&quot;units&quot;:&quot;in&quot;},&quot;parent&quot;:{&quot;parentId&quot;:&quot;37e2aa28-cd10-4bfd-92df-0a3c31376c99&quot;,&quot;type&quot;:&quot;DOCUMENT&quot;,&quot;order&quot;:&quot;5&quot;}},&quot;37e2aa28-cd10-4bfd-92df-0a3c31376c99&quot;:{&quot;id&quot;:&quot;37e2aa28-cd10-4bfd-92df-0a3c31376c99&quot;,&quot;type&quot;:&quot;FIGURE_OBJECT&quot;,&quot;document&quot;:{&quot;type&quot;:&quot;DOCUMENT_GROUP&quot;,&quot;canvasType&quot;:&quot;FIGURE&quot;,&quot;units&quot;:&quot;in&quot;}}}}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9695d10ed4b5880ee2c709d"/>
  <p:tag name="FIGURESLIDEID" val="82468011-4845-45d2-ae7e-533a19310ec4"/>
  <p:tag name="SELECTIONIDS" val="aefb9f7f-fbed-4d52-b927-7dbec0c8c768"/>
  <p:tag name="TRANSPARENTBACKGROUND" val="true"/>
  <p:tag name="VERSION" val="1770643664268"/>
  <p:tag name="TITLE" val="Broth Dilution"/>
  <p:tag name="CREATORNAME" val="Woubit Abebe"/>
  <p:tag name="DATEINSERTED" val="1770643663814"/>
  <p:tag name="DPI" val="300"/>
  <p:tag name="BIOJSON" val="{&quot;id&quot;:&quot;37e2aa28-cd10-4bfd-92df-0a3c31376c99&quot;,&quot;objects&quot;:{&quot;aefb9f7f-fbed-4d52-b927-7dbec0c8c768&quot;:{&quot;relativeTransform&quot;:{&quot;translate&quot;:{&quot;x&quot;:-377.37767446646785,&quot;y&quot;:37.098630225681404},&quot;rotate&quot;:0,&quot;skewX&quot;:0,&quot;scale&quot;:{&quot;x&quot;:1,&quot;y&quot;:1}},&quot;type&quot;:&quot;FIGURE_OBJECT&quot;,&quot;id&quot;:&quot;aefb9f7f-fbed-4d52-b927-7dbec0c8c768&quot;,&quot;opacity&quot;:1,&quot;path&quot;:{&quot;type&quot;:&quot;POLY_LINE&quot;,&quot;points&quot;:[{&quot;x&quot;:4.974641926767617,&quot;y&quot;:-137.02271231082307},{&quot;x&quot;:13.185661039235299,&quot;y&quot;:-158.41658203145784},{&quot;x&quot;:28.715525288267486,&quot;y&quot;:-168.3407703671512},{&quot;x&quot;:44.33526212272119,&quot;y&quot;:-158.81658203145784},{&quot;x&quot;:54.935953265994215,&quot;y&quot;:-135.79148492246026}],&quot;closed&quot;:false,&quot;selectedObjectIds&quot;:[&quot;69922a4c-8668-4e32-9dc7-a4d983b2e733&quot;]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82468011-4845-45d2-ae7e-533a19310ec4&quot;,&quot;order&quot;:&quot;999999999&quot;},&quot;connectorInfo&quot;:{&quot;connectedObjects&quot;:[],&quot;type&quot;:&quot;CUBIC&quot;,&quot;offset&quot;:{&quot;x&quot;:0,&quot;y&quot;:0},&quot;bending&quot;:-0.1,&quot;firstElementIsHead&quot;:true,&quot;customized&quot;:true},&quot;pathSmoothing&quot;:{&quot;type&quot;:&quot;CATMULL_SMOOTHING&quot;,&quot;smoothing&quot;:0.2},&quot;name&quot;:&quot;Curving arrow (editable) 4&quot;,&quot;displayName&quot;:&quot;Curving arrow (editable) 4&quot;,&quot;source&quot;:{&quot;id&quot;:&quot;62698ecb4e765946d04af2fb&quot;,&quot;type&quot;:&quot;ASSETS&quot;},&quot;isPremium&quot;:false},&quot;82468011-4845-45d2-ae7e-533a19310ec4&quot;:{&quot;id&quot;:&quot;82468011-4845-45d2-ae7e-533a19310ec4&quot;,&quot;type&quot;:&quot;FIGURE_OBJECT&quot;,&quot;document&quot;:{&quot;type&quot;:&quot;FIGURE&quot;,&quot;canvasType&quot;:&quot;FIGURE&quot;,&quot;units&quot;:&quot;in&quot;},&quot;parent&quot;:{&quot;parentId&quot;:&quot;37e2aa28-cd10-4bfd-92df-0a3c31376c99&quot;,&quot;type&quot;:&quot;DOCUMENT&quot;,&quot;order&quot;:&quot;5&quot;}},&quot;37e2aa28-cd10-4bfd-92df-0a3c31376c99&quot;:{&quot;id&quot;:&quot;37e2aa28-cd10-4bfd-92df-0a3c31376c99&quot;,&quot;type&quot;:&quot;FIGURE_OBJECT&quot;,&quot;document&quot;:{&quot;type&quot;:&quot;DOCUMENT_GROUP&quot;,&quot;canvasType&quot;:&quot;FIGURE&quot;,&quot;units&quot;:&quot;in&quot;}}}}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9695d10ed4b5880ee2c709d"/>
  <p:tag name="FIGURESLIDEID" val="82468011-4845-45d2-ae7e-533a19310ec4"/>
  <p:tag name="SELECTIONIDS" val="cf36c8c4-aa3e-43d0-a644-90a4694725cb"/>
  <p:tag name="TRANSPARENTBACKGROUND" val="true"/>
  <p:tag name="VERSION" val="1770643664268"/>
  <p:tag name="TITLE" val="Broth Dilution"/>
  <p:tag name="CREATORNAME" val="Woubit Abebe"/>
  <p:tag name="DATEINSERTED" val="1770643663814"/>
  <p:tag name="DPI" val="300"/>
  <p:tag name="BIOJSON" val="{&quot;id&quot;:&quot;37e2aa28-cd10-4bfd-92df-0a3c31376c99&quot;,&quot;objects&quot;:{&quot;cf36c8c4-aa3e-43d0-a644-90a4694725cb&quot;:{&quot;id&quot;:&quot;cf36c8c4-aa3e-43d0-a644-90a4694725cb&quot;,&quot;name&quot;:&quot;Test tube (15 mL, 1/2 liquid)&quot;,&quot;displayName&quot;:&quot;&quot;,&quot;type&quot;:&quot;FIGURE_OBJECT&quot;,&quot;relativeTransform&quot;:{&quot;translate&quot;:{&quot;x&quot;:-434.03215895488313,&quot;y&quot;:-5.116172516627941},&quot;rotate&quot;:0,&quot;skewX&quot;:0,&quot;scale&quot;:{&quot;x&quot;:0.7117130970948358,&quot;y&quot;:0.7117130970948358}},&quot;image&quot;:{&quot;url&quot;:&quot;https://icons.cdn.biorender.com/biorender/5e56940cc45c7c0028ca1e8e/20200226201646/image/5e56940cc45c7c0028ca1e8e.png&quot;,&quot;isPremium&quot;:true,&quot;isOrgIcon&quot;:false,&quot;size&quot;:{&quot;x&quot;:50,&quot;y&quot;:222.80701754385964}},&quot;source&quot;:{&quot;id&quot;:&quot;5e56940cc45c7c0028ca1e8e&quot;,&quot;version&quot;:&quot;20200226201646&quot;,&quot;type&quot;:&quot;ASSETS&quot;},&quot;isPremium&quot;:true,&quot;parent&quot;:{&quot;type&quot;:&quot;CHILD&quot;,&quot;parentId&quot;:&quot;82468011-4845-45d2-ae7e-533a19310ec4&quot;,&quot;order&quot;:&quot;5&quot;}},&quot;82468011-4845-45d2-ae7e-533a19310ec4&quot;:{&quot;id&quot;:&quot;82468011-4845-45d2-ae7e-533a19310ec4&quot;,&quot;type&quot;:&quot;FIGURE_OBJECT&quot;,&quot;document&quot;:{&quot;type&quot;:&quot;FIGURE&quot;,&quot;canvasType&quot;:&quot;FIGURE&quot;,&quot;units&quot;:&quot;in&quot;},&quot;parent&quot;:{&quot;parentId&quot;:&quot;37e2aa28-cd10-4bfd-92df-0a3c31376c99&quot;,&quot;type&quot;:&quot;DOCUMENT&quot;,&quot;order&quot;:&quot;5&quot;}},&quot;37e2aa28-cd10-4bfd-92df-0a3c31376c99&quot;:{&quot;id&quot;:&quot;37e2aa28-cd10-4bfd-92df-0a3c31376c99&quot;,&quot;type&quot;:&quot;FIGURE_OBJECT&quot;,&quot;document&quot;:{&quot;type&quot;:&quot;DOCUMENT_GROUP&quot;,&quot;canvasType&quot;:&quot;FIGURE&quot;,&quot;units&quot;:&quot;in&quot;}}}}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9695d10ed4b5880ee2c709d"/>
  <p:tag name="FIGURESLIDEID" val="82468011-4845-45d2-ae7e-533a19310ec4"/>
  <p:tag name="SELECTIONIDS" val="2a14c0b7-ceed-4e29-82e3-0ae18007b86c"/>
  <p:tag name="TRANSPARENTBACKGROUND" val="true"/>
  <p:tag name="VERSION" val="1770643664268"/>
  <p:tag name="TITLE" val="Broth Dilution"/>
  <p:tag name="CREATORNAME" val="Woubit Abebe"/>
  <p:tag name="DATEINSERTED" val="1770643663814"/>
  <p:tag name="DPI" val="300"/>
  <p:tag name="BIOJSON" val="{&quot;id&quot;:&quot;37e2aa28-cd10-4bfd-92df-0a3c31376c99&quot;,&quot;objects&quot;:{&quot;2a14c0b7-ceed-4e29-82e3-0ae18007b86c&quot;:{&quot;relativeTransform&quot;:{&quot;translate&quot;:{&quot;x&quot;:-316.3279029477606,&quot;y&quot;:37.098539611362554},&quot;rotate&quot;:0,&quot;skewX&quot;:0,&quot;scale&quot;:{&quot;x&quot;:1,&quot;y&quot;:1}},&quot;type&quot;:&quot;FIGURE_OBJECT&quot;,&quot;id&quot;:&quot;2a14c0b7-ceed-4e29-82e3-0ae18007b86c&quot;,&quot;opacity&quot;:1,&quot;path&quot;:{&quot;type&quot;:&quot;POLY_LINE&quot;,&quot;points&quot;:[{&quot;x&quot;:4.974641926767617,&quot;y&quot;:-137.02271231082307},{&quot;x&quot;:13.185661039235299,&quot;y&quot;:-158.41658203145784},{&quot;x&quot;:28.715525288267486,&quot;y&quot;:-168.3407703671512},{&quot;x&quot;:44.33526212272119,&quot;y&quot;:-158.81658203145784},{&quot;x&quot;:54.935953265994215,&quot;y&quot;:-135.79148492246026}],&quot;closed&quot;:false,&quot;selectedObjectIds&quot;:[&quot;69922a4c-8668-4e32-9dc7-a4d983b2e733&quot;]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82468011-4845-45d2-ae7e-533a19310ec4&quot;,&quot;order&quot;:&quot;9999999995&quot;},&quot;connectorInfo&quot;:{&quot;connectedObjects&quot;:[],&quot;type&quot;:&quot;CUBIC&quot;,&quot;offset&quot;:{&quot;x&quot;:0,&quot;y&quot;:0},&quot;bending&quot;:-0.1,&quot;firstElementIsHead&quot;:true,&quot;customized&quot;:true},&quot;pathSmoothing&quot;:{&quot;type&quot;:&quot;CATMULL_SMOOTHING&quot;,&quot;smoothing&quot;:0.2},&quot;name&quot;:&quot;Curving arrow (editable) 4&quot;,&quot;displayName&quot;:&quot;Curving arrow (editable) 4&quot;,&quot;source&quot;:{&quot;id&quot;:&quot;62698ecb4e765946d04af2fb&quot;,&quot;type&quot;:&quot;ASSETS&quot;},&quot;isPremium&quot;:false},&quot;82468011-4845-45d2-ae7e-533a19310ec4&quot;:{&quot;id&quot;:&quot;82468011-4845-45d2-ae7e-533a19310ec4&quot;,&quot;type&quot;:&quot;FIGURE_OBJECT&quot;,&quot;document&quot;:{&quot;type&quot;:&quot;FIGURE&quot;,&quot;canvasType&quot;:&quot;FIGURE&quot;,&quot;units&quot;:&quot;in&quot;},&quot;parent&quot;:{&quot;parentId&quot;:&quot;37e2aa28-cd10-4bfd-92df-0a3c31376c99&quot;,&quot;type&quot;:&quot;DOCUMENT&quot;,&quot;order&quot;:&quot;5&quot;}},&quot;37e2aa28-cd10-4bfd-92df-0a3c31376c99&quot;:{&quot;id&quot;:&quot;37e2aa28-cd10-4bfd-92df-0a3c31376c99&quot;,&quot;type&quot;:&quot;FIGURE_OBJECT&quot;,&quot;document&quot;:{&quot;type&quot;:&quot;DOCUMENT_GROUP&quot;,&quot;canvasType&quot;:&quot;FIGURE&quot;,&quot;units&quot;:&quot;in&quot;}}}}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9695d10ed4b5880ee2c709d"/>
  <p:tag name="FIGURESLIDEID" val="82468011-4845-45d2-ae7e-533a19310ec4"/>
  <p:tag name="SELECTIONIDS" val="a3d698a0-cb9f-46d9-bba6-9a85cef2c33a"/>
  <p:tag name="TRANSPARENTBACKGROUND" val="true"/>
  <p:tag name="VERSION" val="1770643664268"/>
  <p:tag name="TITLE" val="Broth Dilution"/>
  <p:tag name="CREATORNAME" val="Woubit Abebe"/>
  <p:tag name="DATEINSERTED" val="1770643663814"/>
  <p:tag name="DPI" val="300"/>
  <p:tag name="BIOJSON" val="{&quot;id&quot;:&quot;37e2aa28-cd10-4bfd-92df-0a3c31376c99&quot;,&quot;objects&quot;:{&quot;a3d698a0-cb9f-46d9-bba6-9a85cef2c33a&quot;:{&quot;relativeTransform&quot;:{&quot;translate&quot;:{&quot;x&quot;:-259.9805175126562,&quot;y&quot;:37.09849430420314},&quot;rotate&quot;:0,&quot;skewX&quot;:0,&quot;scale&quot;:{&quot;x&quot;:1,&quot;y&quot;:1}},&quot;type&quot;:&quot;FIGURE_OBJECT&quot;,&quot;id&quot;:&quot;a3d698a0-cb9f-46d9-bba6-9a85cef2c33a&quot;,&quot;opacity&quot;:1,&quot;path&quot;:{&quot;type&quot;:&quot;POLY_LINE&quot;,&quot;points&quot;:[{&quot;x&quot;:4.974641926767617,&quot;y&quot;:-137.02271231082307},{&quot;x&quot;:13.185661039235299,&quot;y&quot;:-158.41658203145784},{&quot;x&quot;:28.715525288267486,&quot;y&quot;:-168.3407703671512},{&quot;x&quot;:44.33526212272119,&quot;y&quot;:-158.81658203145784},{&quot;x&quot;:54.935953265994215,&quot;y&quot;:-135.79148492246026}],&quot;closed&quot;:false,&quot;selectedObjectIds&quot;:[&quot;69922a4c-8668-4e32-9dc7-a4d983b2e733&quot;]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82468011-4845-45d2-ae7e-533a19310ec4&quot;,&quot;order&quot;:&quot;9999999997&quot;},&quot;connectorInfo&quot;:{&quot;connectedObjects&quot;:[],&quot;type&quot;:&quot;CUBIC&quot;,&quot;offset&quot;:{&quot;x&quot;:0,&quot;y&quot;:0},&quot;bending&quot;:-0.1,&quot;firstElementIsHead&quot;:true,&quot;customized&quot;:true},&quot;pathSmoothing&quot;:{&quot;type&quot;:&quot;CATMULL_SMOOTHING&quot;,&quot;smoothing&quot;:0.2},&quot;name&quot;:&quot;Curving arrow (editable) 4&quot;,&quot;displayName&quot;:&quot;Curving arrow (editable) 4&quot;,&quot;source&quot;:{&quot;id&quot;:&quot;62698ecb4e765946d04af2fb&quot;,&quot;type&quot;:&quot;ASSETS&quot;},&quot;isPremium&quot;:false},&quot;82468011-4845-45d2-ae7e-533a19310ec4&quot;:{&quot;id&quot;:&quot;82468011-4845-45d2-ae7e-533a19310ec4&quot;,&quot;type&quot;:&quot;FIGURE_OBJECT&quot;,&quot;document&quot;:{&quot;type&quot;:&quot;FIGURE&quot;,&quot;canvasType&quot;:&quot;FIGURE&quot;,&quot;units&quot;:&quot;in&quot;},&quot;parent&quot;:{&quot;parentId&quot;:&quot;37e2aa28-cd10-4bfd-92df-0a3c31376c99&quot;,&quot;type&quot;:&quot;DOCUMENT&quot;,&quot;order&quot;:&quot;5&quot;}},&quot;37e2aa28-cd10-4bfd-92df-0a3c31376c99&quot;:{&quot;id&quot;:&quot;37e2aa28-cd10-4bfd-92df-0a3c31376c99&quot;,&quot;type&quot;:&quot;FIGURE_OBJECT&quot;,&quot;document&quot;:{&quot;type&quot;:&quot;DOCUMENT_GROUP&quot;,&quot;canvasType&quot;:&quot;FIGURE&quot;,&quot;units&quot;:&quot;in&quot;}}}}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9695d10ed4b5880ee2c709d"/>
  <p:tag name="FIGURESLIDEID" val="82468011-4845-45d2-ae7e-533a19310ec4"/>
  <p:tag name="SELECTIONIDS" val="df980a80-e5e5-421e-b5dc-e788ec362c1b"/>
  <p:tag name="TRANSPARENTBACKGROUND" val="true"/>
  <p:tag name="VERSION" val="1770643664268"/>
  <p:tag name="TITLE" val="Broth Dilution"/>
  <p:tag name="CREATORNAME" val="Woubit Abebe"/>
  <p:tag name="DATEINSERTED" val="1770643663814"/>
  <p:tag name="DPI" val="300"/>
  <p:tag name="BIOJSON" val="{&quot;id&quot;:&quot;37e2aa28-cd10-4bfd-92df-0a3c31376c99&quot;,&quot;objects&quot;:{&quot;df980a80-e5e5-421e-b5dc-e788ec362c1b&quot;:{&quot;relativeTransform&quot;:{&quot;translate&quot;:{&quot;x&quot;:-202.2894958318243,&quot;y&quot;:37.09822181274805},&quot;rotate&quot;:0,&quot;skewX&quot;:0,&quot;scale&quot;:{&quot;x&quot;:1,&quot;y&quot;:1}},&quot;type&quot;:&quot;FIGURE_OBJECT&quot;,&quot;id&quot;:&quot;df980a80-e5e5-421e-b5dc-e788ec362c1b&quot;,&quot;opacity&quot;:1,&quot;path&quot;:{&quot;type&quot;:&quot;POLY_LINE&quot;,&quot;points&quot;:[{&quot;x&quot;:4.974641926767617,&quot;y&quot;:-137.02271231082307},{&quot;x&quot;:13.185661039235299,&quot;y&quot;:-158.41658203145784},{&quot;x&quot;:28.715525288267486,&quot;y&quot;:-168.3407703671512},{&quot;x&quot;:44.33526212272119,&quot;y&quot;:-158.81658203145784},{&quot;x&quot;:54.935953265994215,&quot;y&quot;:-135.79148492246026}],&quot;closed&quot;:false,&quot;selectedObjectIds&quot;:[&quot;69922a4c-8668-4e32-9dc7-a4d983b2e733&quot;]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82468011-4845-45d2-ae7e-533a19310ec4&quot;,&quot;order&quot;:&quot;9999999998&quot;},&quot;connectorInfo&quot;:{&quot;connectedObjects&quot;:[],&quot;type&quot;:&quot;CUBIC&quot;,&quot;offset&quot;:{&quot;x&quot;:0,&quot;y&quot;:0},&quot;bending&quot;:-0.1,&quot;firstElementIsHead&quot;:true,&quot;customized&quot;:true},&quot;pathSmoothing&quot;:{&quot;type&quot;:&quot;CATMULL_SMOOTHING&quot;,&quot;smoothing&quot;:0.2},&quot;name&quot;:&quot;Curving arrow (editable) 4&quot;,&quot;displayName&quot;:&quot;Curving arrow (editable) 4&quot;,&quot;source&quot;:{&quot;id&quot;:&quot;62698ecb4e765946d04af2fb&quot;,&quot;type&quot;:&quot;ASSETS&quot;},&quot;isPremium&quot;:false},&quot;82468011-4845-45d2-ae7e-533a19310ec4&quot;:{&quot;id&quot;:&quot;82468011-4845-45d2-ae7e-533a19310ec4&quot;,&quot;type&quot;:&quot;FIGURE_OBJECT&quot;,&quot;document&quot;:{&quot;type&quot;:&quot;FIGURE&quot;,&quot;canvasType&quot;:&quot;FIGURE&quot;,&quot;units&quot;:&quot;in&quot;},&quot;parent&quot;:{&quot;parentId&quot;:&quot;37e2aa28-cd10-4bfd-92df-0a3c31376c99&quot;,&quot;type&quot;:&quot;DOCUMENT&quot;,&quot;order&quot;:&quot;5&quot;}},&quot;37e2aa28-cd10-4bfd-92df-0a3c31376c99&quot;:{&quot;id&quot;:&quot;37e2aa28-cd10-4bfd-92df-0a3c31376c99&quot;,&quot;type&quot;:&quot;FIGURE_OBJECT&quot;,&quot;document&quot;:{&quot;type&quot;:&quot;DOCUMENT_GROUP&quot;,&quot;canvasType&quot;:&quot;FIGURE&quot;,&quot;units&quot;:&quot;in&quot;}}}}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9695d10ed4b5880ee2c709d"/>
  <p:tag name="FIGURESLIDEID" val="82468011-4845-45d2-ae7e-533a19310ec4"/>
  <p:tag name="SELECTIONIDS" val="169d4c86-1e30-4247-b981-eb01f43c1457"/>
  <p:tag name="TRANSPARENTBACKGROUND" val="true"/>
  <p:tag name="VERSION" val="1770643664268"/>
  <p:tag name="TITLE" val="Broth Dilution"/>
  <p:tag name="CREATORNAME" val="Woubit Abebe"/>
  <p:tag name="DATEINSERTED" val="1770643663814"/>
  <p:tag name="DPI" val="300"/>
  <p:tag name="BIOJSON" val="{&quot;id&quot;:&quot;37e2aa28-cd10-4bfd-92df-0a3c31376c99&quot;,&quot;objects&quot;:{&quot;169d4c86-1e30-4247-b981-eb01f43c1457&quot;:{&quot;relativeTransform&quot;:{&quot;translate&quot;:{&quot;x&quot;:-144.59876962027644,&quot;y&quot;:37.0980629134408},&quot;rotate&quot;:0,&quot;skewX&quot;:0,&quot;scale&quot;:{&quot;x&quot;:1,&quot;y&quot;:1}},&quot;type&quot;:&quot;FIGURE_OBJECT&quot;,&quot;id&quot;:&quot;169d4c86-1e30-4247-b981-eb01f43c1457&quot;,&quot;opacity&quot;:1,&quot;path&quot;:{&quot;type&quot;:&quot;POLY_LINE&quot;,&quot;points&quot;:[{&quot;x&quot;:4.974641926767617,&quot;y&quot;:-137.02271231082307},{&quot;x&quot;:13.185661039235299,&quot;y&quot;:-158.41658203145784},{&quot;x&quot;:28.715525288267486,&quot;y&quot;:-168.3407703671512},{&quot;x&quot;:44.33526212272119,&quot;y&quot;:-158.81658203145784},{&quot;x&quot;:54.935953265994215,&quot;y&quot;:-135.79148492246026}],&quot;closed&quot;:false,&quot;selectedObjectIds&quot;:[&quot;69922a4c-8668-4e32-9dc7-a4d983b2e733&quot;]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82468011-4845-45d2-ae7e-533a19310ec4&quot;,&quot;order&quot;:&quot;9999999999&quot;},&quot;connectorInfo&quot;:{&quot;connectedObjects&quot;:[],&quot;type&quot;:&quot;CUBIC&quot;,&quot;offset&quot;:{&quot;x&quot;:0,&quot;y&quot;:0},&quot;bending&quot;:-0.1,&quot;firstElementIsHead&quot;:true,&quot;customized&quot;:true},&quot;pathSmoothing&quot;:{&quot;type&quot;:&quot;CATMULL_SMOOTHING&quot;,&quot;smoothing&quot;:0.2},&quot;name&quot;:&quot;Curving arrow (editable) 4&quot;,&quot;displayName&quot;:&quot;Curving arrow (editable) 4&quot;,&quot;source&quot;:{&quot;id&quot;:&quot;62698ecb4e765946d04af2fb&quot;,&quot;type&quot;:&quot;ASSETS&quot;},&quot;isPremium&quot;:false},&quot;82468011-4845-45d2-ae7e-533a19310ec4&quot;:{&quot;id&quot;:&quot;82468011-4845-45d2-ae7e-533a19310ec4&quot;,&quot;type&quot;:&quot;FIGURE_OBJECT&quot;,&quot;document&quot;:{&quot;type&quot;:&quot;FIGURE&quot;,&quot;canvasType&quot;:&quot;FIGURE&quot;,&quot;units&quot;:&quot;in&quot;},&quot;parent&quot;:{&quot;parentId&quot;:&quot;37e2aa28-cd10-4bfd-92df-0a3c31376c99&quot;,&quot;type&quot;:&quot;DOCUMENT&quot;,&quot;order&quot;:&quot;5&quot;}},&quot;37e2aa28-cd10-4bfd-92df-0a3c31376c99&quot;:{&quot;id&quot;:&quot;37e2aa28-cd10-4bfd-92df-0a3c31376c99&quot;,&quot;type&quot;:&quot;FIGURE_OBJECT&quot;,&quot;document&quot;:{&quot;type&quot;:&quot;DOCUMENT_GROUP&quot;,&quot;canvasType&quot;:&quot;FIGURE&quot;,&quot;units&quot;:&quot;in&quot;}}}}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9695d10ed4b5880ee2c709d"/>
  <p:tag name="FIGURESLIDEID" val="82468011-4845-45d2-ae7e-533a19310ec4"/>
  <p:tag name="SELECTIONIDS" val="61a80fd1-f1f5-4ef7-9575-93f0426416ad"/>
  <p:tag name="TRANSPARENTBACKGROUND" val="true"/>
  <p:tag name="VERSION" val="1770643664268"/>
  <p:tag name="TITLE" val="Broth Dilution"/>
  <p:tag name="CREATORNAME" val="Woubit Abebe"/>
  <p:tag name="DATEINSERTED" val="1770643663814"/>
  <p:tag name="DPI" val="300"/>
  <p:tag name="BIOJSON" val="{&quot;id&quot;:&quot;37e2aa28-cd10-4bfd-92df-0a3c31376c99&quot;,&quot;objects&quot;:{&quot;61a80fd1-f1f5-4ef7-9575-93f0426416ad&quot;:{&quot;relativeTransform&quot;:{&quot;translate&quot;:{&quot;x&quot;:-86.90752075514888,&quot;y&quot;:37.09883572914515},&quot;rotate&quot;:0,&quot;skewX&quot;:0,&quot;scale&quot;:{&quot;x&quot;:1,&quot;y&quot;:1}},&quot;type&quot;:&quot;FIGURE_OBJECT&quot;,&quot;id&quot;:&quot;61a80fd1-f1f5-4ef7-9575-93f0426416ad&quot;,&quot;opacity&quot;:1,&quot;path&quot;:{&quot;type&quot;:&quot;POLY_LINE&quot;,&quot;points&quot;:[{&quot;x&quot;:4.974641926767617,&quot;y&quot;:-137.02271231082307},{&quot;x&quot;:13.185661039235299,&quot;y&quot;:-158.41658203145784},{&quot;x&quot;:28.715525288267486,&quot;y&quot;:-168.3407703671512},{&quot;x&quot;:44.33526212272119,&quot;y&quot;:-158.81658203145784},{&quot;x&quot;:54.935953265994215,&quot;y&quot;:-135.79148492246026}],&quot;closed&quot;:false,&quot;selectedObjectIds&quot;:[&quot;69922a4c-8668-4e32-9dc7-a4d983b2e733&quot;]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82468011-4845-45d2-ae7e-533a19310ec4&quot;,&quot;order&quot;:&quot;99999999995&quot;},&quot;connectorInfo&quot;:{&quot;connectedObjects&quot;:[],&quot;type&quot;:&quot;CUBIC&quot;,&quot;offset&quot;:{&quot;x&quot;:0,&quot;y&quot;:0},&quot;bending&quot;:-0.1,&quot;firstElementIsHead&quot;:true,&quot;customized&quot;:true},&quot;pathSmoothing&quot;:{&quot;type&quot;:&quot;CATMULL_SMOOTHING&quot;,&quot;smoothing&quot;:0.2},&quot;name&quot;:&quot;Curving arrow (editable) 4&quot;,&quot;displayName&quot;:&quot;Curving arrow (editable) 4&quot;,&quot;source&quot;:{&quot;id&quot;:&quot;62698ecb4e765946d04af2fb&quot;,&quot;type&quot;:&quot;ASSETS&quot;},&quot;isPremium&quot;:false},&quot;82468011-4845-45d2-ae7e-533a19310ec4&quot;:{&quot;id&quot;:&quot;82468011-4845-45d2-ae7e-533a19310ec4&quot;,&quot;type&quot;:&quot;FIGURE_OBJECT&quot;,&quot;document&quot;:{&quot;type&quot;:&quot;FIGURE&quot;,&quot;canvasType&quot;:&quot;FIGURE&quot;,&quot;units&quot;:&quot;in&quot;},&quot;parent&quot;:{&quot;parentId&quot;:&quot;37e2aa28-cd10-4bfd-92df-0a3c31376c99&quot;,&quot;type&quot;:&quot;DOCUMENT&quot;,&quot;order&quot;:&quot;5&quot;}},&quot;37e2aa28-cd10-4bfd-92df-0a3c31376c99&quot;:{&quot;id&quot;:&quot;37e2aa28-cd10-4bfd-92df-0a3c31376c99&quot;,&quot;type&quot;:&quot;FIGURE_OBJECT&quot;,&quot;document&quot;:{&quot;type&quot;:&quot;DOCUMENT_GROUP&quot;,&quot;canvasType&quot;:&quot;FIGURE&quot;,&quot;units&quot;:&quot;in&quot;}}}}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9695d10ed4b5880ee2c709d"/>
  <p:tag name="FIGURESLIDEID" val="82468011-4845-45d2-ae7e-533a19310ec4"/>
  <p:tag name="SELECTIONIDS" val="60e4f638-8b1a-4736-9d86-f0effc5bc224"/>
  <p:tag name="TRANSPARENTBACKGROUND" val="true"/>
  <p:tag name="VERSION" val="1770643664268"/>
  <p:tag name="TITLE" val="Broth Dilution"/>
  <p:tag name="CREATORNAME" val="Woubit Abebe"/>
  <p:tag name="DATEINSERTED" val="1770643663814"/>
  <p:tag name="DPI" val="300"/>
  <p:tag name="BIOJSON" val="{&quot;id&quot;:&quot;37e2aa28-cd10-4bfd-92df-0a3c31376c99&quot;,&quot;objects&quot;:{&quot;60e4f638-8b1a-4736-9d86-f0effc5bc224&quot;:{&quot;relativeTransform&quot;:{&quot;translate&quot;:{&quot;x&quot;:-29.217090012885087,&quot;y&quot;:37.099154176258196},&quot;rotate&quot;:0,&quot;skewX&quot;:0,&quot;scale&quot;:{&quot;x&quot;:1,&quot;y&quot;:1}},&quot;type&quot;:&quot;FIGURE_OBJECT&quot;,&quot;id&quot;:&quot;60e4f638-8b1a-4736-9d86-f0effc5bc224&quot;,&quot;opacity&quot;:1,&quot;path&quot;:{&quot;type&quot;:&quot;POLY_LINE&quot;,&quot;points&quot;:[{&quot;x&quot;:4.974641926767617,&quot;y&quot;:-137.02271231082307},{&quot;x&quot;:13.185661039235299,&quot;y&quot;:-158.41658203145784},{&quot;x&quot;:28.715525288267486,&quot;y&quot;:-168.3407703671512},{&quot;x&quot;:44.33526212272119,&quot;y&quot;:-158.81658203145784},{&quot;x&quot;:54.935953265994215,&quot;y&quot;:-135.79148492246026}],&quot;closed&quot;:false,&quot;selectedObjectIds&quot;:[&quot;69922a4c-8668-4e32-9dc7-a4d983b2e733&quot;]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82468011-4845-45d2-ae7e-533a19310ec4&quot;,&quot;order&quot;:&quot;99999999997&quot;},&quot;connectorInfo&quot;:{&quot;connectedObjects&quot;:[],&quot;type&quot;:&quot;CUBIC&quot;,&quot;offset&quot;:{&quot;x&quot;:0,&quot;y&quot;:0},&quot;bending&quot;:-0.1,&quot;firstElementIsHead&quot;:true,&quot;customized&quot;:true},&quot;pathSmoothing&quot;:{&quot;type&quot;:&quot;CATMULL_SMOOTHING&quot;,&quot;smoothing&quot;:0.2},&quot;name&quot;:&quot;Curving arrow (editable) 4&quot;,&quot;displayName&quot;:&quot;Curving arrow (editable) 4&quot;,&quot;source&quot;:{&quot;id&quot;:&quot;62698ecb4e765946d04af2fb&quot;,&quot;type&quot;:&quot;ASSETS&quot;},&quot;isPremium&quot;:false},&quot;82468011-4845-45d2-ae7e-533a19310ec4&quot;:{&quot;id&quot;:&quot;82468011-4845-45d2-ae7e-533a19310ec4&quot;,&quot;type&quot;:&quot;FIGURE_OBJECT&quot;,&quot;document&quot;:{&quot;type&quot;:&quot;FIGURE&quot;,&quot;canvasType&quot;:&quot;FIGURE&quot;,&quot;units&quot;:&quot;in&quot;},&quot;parent&quot;:{&quot;parentId&quot;:&quot;37e2aa28-cd10-4bfd-92df-0a3c31376c99&quot;,&quot;type&quot;:&quot;DOCUMENT&quot;,&quot;order&quot;:&quot;5&quot;}},&quot;37e2aa28-cd10-4bfd-92df-0a3c31376c99&quot;:{&quot;id&quot;:&quot;37e2aa28-cd10-4bfd-92df-0a3c31376c99&quot;,&quot;type&quot;:&quot;FIGURE_OBJECT&quot;,&quot;document&quot;:{&quot;type&quot;:&quot;DOCUMENT_GROUP&quot;,&quot;canvasType&quot;:&quot;FIGURE&quot;,&quot;units&quot;:&quot;in&quot;}}}}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9695d10ed4b5880ee2c709d"/>
  <p:tag name="FIGURESLIDEID" val="82468011-4845-45d2-ae7e-533a19310ec4"/>
  <p:tag name="SELECTIONIDS" val="fb2ad363-9f47-4e90-bd58-85fc5e562336"/>
  <p:tag name="TRANSPARENTBACKGROUND" val="true"/>
  <p:tag name="VERSION" val="1770643664268"/>
  <p:tag name="TITLE" val="Broth Dilution"/>
  <p:tag name="CREATORNAME" val="Woubit Abebe"/>
  <p:tag name="DATEINSERTED" val="1770643663814"/>
  <p:tag name="DPI" val="300"/>
  <p:tag name="BIOJSON" val="{&quot;id&quot;:&quot;37e2aa28-cd10-4bfd-92df-0a3c31376c99&quot;,&quot;objects&quot;:{&quot;fb2ad363-9f47-4e90-bd58-85fc5e562336&quot;:{&quot;relativeTransform&quot;:{&quot;translate&quot;:{&quot;x&quot;:27.13081807579899,&quot;y&quot;:37.098404338382835},&quot;rotate&quot;:0,&quot;skewX&quot;:0,&quot;scale&quot;:{&quot;x&quot;:1,&quot;y&quot;:1}},&quot;type&quot;:&quot;FIGURE_OBJECT&quot;,&quot;id&quot;:&quot;fb2ad363-9f47-4e90-bd58-85fc5e562336&quot;,&quot;opacity&quot;:1,&quot;path&quot;:{&quot;type&quot;:&quot;POLY_LINE&quot;,&quot;points&quot;:[{&quot;x&quot;:4.974641926767617,&quot;y&quot;:-137.02271231082307},{&quot;x&quot;:13.185661039235299,&quot;y&quot;:-158.41658203145784},{&quot;x&quot;:28.715525288267486,&quot;y&quot;:-168.3407703671512},{&quot;x&quot;:44.33526212272119,&quot;y&quot;:-158.81658203145784},{&quot;x&quot;:54.935953265994215,&quot;y&quot;:-135.79148492246026}],&quot;closed&quot;:false,&quot;selectedObjectIds&quot;:[&quot;69922a4c-8668-4e32-9dc7-a4d983b2e733&quot;]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82468011-4845-45d2-ae7e-533a19310ec4&quot;,&quot;order&quot;:&quot;99999999998&quot;},&quot;connectorInfo&quot;:{&quot;connectedObjects&quot;:[],&quot;type&quot;:&quot;CUBIC&quot;,&quot;offset&quot;:{&quot;x&quot;:0,&quot;y&quot;:0},&quot;bending&quot;:-0.1,&quot;firstElementIsHead&quot;:true,&quot;customized&quot;:true},&quot;pathSmoothing&quot;:{&quot;type&quot;:&quot;CATMULL_SMOOTHING&quot;,&quot;smoothing&quot;:0.2},&quot;name&quot;:&quot;Curving arrow (editable) 4&quot;,&quot;displayName&quot;:&quot;Curving arrow (editable) 4&quot;,&quot;source&quot;:{&quot;id&quot;:&quot;62698ecb4e765946d04af2fb&quot;,&quot;type&quot;:&quot;ASSETS&quot;},&quot;isPremium&quot;:false},&quot;82468011-4845-45d2-ae7e-533a19310ec4&quot;:{&quot;id&quot;:&quot;82468011-4845-45d2-ae7e-533a19310ec4&quot;,&quot;type&quot;:&quot;FIGURE_OBJECT&quot;,&quot;document&quot;:{&quot;type&quot;:&quot;FIGURE&quot;,&quot;canvasType&quot;:&quot;FIGURE&quot;,&quot;units&quot;:&quot;in&quot;},&quot;parent&quot;:{&quot;parentId&quot;:&quot;37e2aa28-cd10-4bfd-92df-0a3c31376c99&quot;,&quot;type&quot;:&quot;DOCUMENT&quot;,&quot;order&quot;:&quot;5&quot;}},&quot;37e2aa28-cd10-4bfd-92df-0a3c31376c99&quot;:{&quot;id&quot;:&quot;37e2aa28-cd10-4bfd-92df-0a3c31376c99&quot;,&quot;type&quot;:&quot;FIGURE_OBJECT&quot;,&quot;document&quot;:{&quot;type&quot;:&quot;DOCUMENT_GROUP&quot;,&quot;canvasType&quot;:&quot;FIGURE&quot;,&quot;units&quot;:&quot;in&quot;}}}}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9695d10ed4b5880ee2c709d"/>
  <p:tag name="FIGURESLIDEID" val="82468011-4845-45d2-ae7e-533a19310ec4"/>
  <p:tag name="SELECTIONIDS" val="03b8e9dc-e460-476b-95eb-482553010608"/>
  <p:tag name="TRANSPARENTBACKGROUND" val="true"/>
  <p:tag name="VERSION" val="1770643664268"/>
  <p:tag name="TITLE" val="Broth Dilution"/>
  <p:tag name="CREATORNAME" val="Woubit Abebe"/>
  <p:tag name="DATEINSERTED" val="1770643663814"/>
  <p:tag name="DPI" val="300"/>
  <p:tag name="BIOJSON" val="{&quot;id&quot;:&quot;37e2aa28-cd10-4bfd-92df-0a3c31376c99&quot;,&quot;objects&quot;:{&quot;03b8e9dc-e460-476b-95eb-482553010608&quot;:{&quot;relativeTransform&quot;:{&quot;translate&quot;:{&quot;x&quot;:88.18054428734683,&quot;y&quot;:37.09883637764371},&quot;rotate&quot;:0,&quot;skewX&quot;:0,&quot;scale&quot;:{&quot;x&quot;:1,&quot;y&quot;:1}},&quot;type&quot;:&quot;FIGURE_OBJECT&quot;,&quot;id&quot;:&quot;03b8e9dc-e460-476b-95eb-482553010608&quot;,&quot;opacity&quot;:1,&quot;path&quot;:{&quot;type&quot;:&quot;POLY_LINE&quot;,&quot;points&quot;:[{&quot;x&quot;:4.974641926767617,&quot;y&quot;:-137.02271231082307},{&quot;x&quot;:13.185661039235299,&quot;y&quot;:-158.41658203145784},{&quot;x&quot;:28.715525288267486,&quot;y&quot;:-168.3407703671512},{&quot;x&quot;:44.33526212272119,&quot;y&quot;:-158.81658203145784},{&quot;x&quot;:54.935953265994215,&quot;y&quot;:-135.79148492246026}],&quot;closed&quot;:false,&quot;selectedObjectIds&quot;:[&quot;69922a4c-8668-4e32-9dc7-a4d983b2e733&quot;]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82468011-4845-45d2-ae7e-533a19310ec4&quot;,&quot;order&quot;:&quot;99999999999&quot;},&quot;connectorInfo&quot;:{&quot;connectedObjects&quot;:[],&quot;type&quot;:&quot;CUBIC&quot;,&quot;offset&quot;:{&quot;x&quot;:0,&quot;y&quot;:0},&quot;bending&quot;:-0.1,&quot;firstElementIsHead&quot;:true,&quot;customized&quot;:true},&quot;pathSmoothing&quot;:{&quot;type&quot;:&quot;CATMULL_SMOOTHING&quot;,&quot;smoothing&quot;:0.2},&quot;name&quot;:&quot;Curving arrow (editable) 4&quot;,&quot;displayName&quot;:&quot;Curving arrow (editable) 4&quot;,&quot;source&quot;:{&quot;id&quot;:&quot;62698ecb4e765946d04af2fb&quot;,&quot;type&quot;:&quot;ASSETS&quot;},&quot;isPremium&quot;:false},&quot;82468011-4845-45d2-ae7e-533a19310ec4&quot;:{&quot;id&quot;:&quot;82468011-4845-45d2-ae7e-533a19310ec4&quot;,&quot;type&quot;:&quot;FIGURE_OBJECT&quot;,&quot;document&quot;:{&quot;type&quot;:&quot;FIGURE&quot;,&quot;canvasType&quot;:&quot;FIGURE&quot;,&quot;units&quot;:&quot;in&quot;},&quot;parent&quot;:{&quot;parentId&quot;:&quot;37e2aa28-cd10-4bfd-92df-0a3c31376c99&quot;,&quot;type&quot;:&quot;DOCUMENT&quot;,&quot;order&quot;:&quot;5&quot;}},&quot;37e2aa28-cd10-4bfd-92df-0a3c31376c99&quot;:{&quot;id&quot;:&quot;37e2aa28-cd10-4bfd-92df-0a3c31376c99&quot;,&quot;type&quot;:&quot;FIGURE_OBJECT&quot;,&quot;document&quot;:{&quot;type&quot;:&quot;DOCUMENT_GROUP&quot;,&quot;canvasType&quot;:&quot;FIGURE&quot;,&quot;units&quot;:&quot;in&quot;}}}}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9695d10ed4b5880ee2c709d"/>
  <p:tag name="FIGURESLIDEID" val="82468011-4845-45d2-ae7e-533a19310ec4"/>
  <p:tag name="SELECTIONIDS" val="80cd7535-aabd-4075-be13-3cb7f4145ce0"/>
  <p:tag name="TRANSPARENTBACKGROUND" val="true"/>
  <p:tag name="VERSION" val="1770643664268"/>
  <p:tag name="TITLE" val="Broth Dilution"/>
  <p:tag name="CREATORNAME" val="Woubit Abebe"/>
  <p:tag name="DATEINSERTED" val="1770643663814"/>
  <p:tag name="DPI" val="300"/>
  <p:tag name="BIOJSON" val="{&quot;id&quot;:&quot;37e2aa28-cd10-4bfd-92df-0a3c31376c99&quot;,&quot;objects&quot;:{&quot;80cd7535-aabd-4075-be13-3cb7f4145ce0&quot;:{&quot;relativeTransform&quot;:{&quot;translate&quot;:{&quot;x&quot;:142.8277931160022,&quot;y&quot;:38.44208652153225},&quot;rotate&quot;:0,&quot;skewX&quot;:0,&quot;scale&quot;:{&quot;x&quot;:1,&quot;y&quot;:1}},&quot;type&quot;:&quot;FIGURE_OBJECT&quot;,&quot;id&quot;:&quot;80cd7535-aabd-4075-be13-3cb7f4145ce0&quot;,&quot;opacity&quot;:1,&quot;path&quot;:{&quot;type&quot;:&quot;POLY_LINE&quot;,&quot;points&quot;:[{&quot;x&quot;:4.974641926767617,&quot;y&quot;:-137.02271231082307},{&quot;x&quot;:13.185661039235299,&quot;y&quot;:-158.41658203145784},{&quot;x&quot;:28.715525288267486,&quot;y&quot;:-168.3407703671512},{&quot;x&quot;:44.33526212272119,&quot;y&quot;:-158.81658203145784},{&quot;x&quot;:54.935953265994215,&quot;y&quot;:-135.79148492246026}],&quot;closed&quot;:false,&quot;selectedObjectIds&quot;:[&quot;69922a4c-8668-4e32-9dc7-a4d983b2e733&quot;]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82468011-4845-45d2-ae7e-533a19310ec4&quot;,&quot;order&quot;:&quot;999999999995&quot;},&quot;connectorInfo&quot;:{&quot;connectedObjects&quot;:[],&quot;type&quot;:&quot;CUBIC&quot;,&quot;offset&quot;:{&quot;x&quot;:0,&quot;y&quot;:0},&quot;bending&quot;:-0.1,&quot;firstElementIsHead&quot;:true,&quot;customized&quot;:true},&quot;pathSmoothing&quot;:{&quot;type&quot;:&quot;CATMULL_SMOOTHING&quot;,&quot;smoothing&quot;:0.2},&quot;name&quot;:&quot;Curving arrow (editable) 4&quot;,&quot;displayName&quot;:&quot;Curving arrow (editable) 4&quot;,&quot;source&quot;:{&quot;id&quot;:&quot;62698ecb4e765946d04af2fb&quot;,&quot;type&quot;:&quot;ASSETS&quot;},&quot;isPremium&quot;:false},&quot;82468011-4845-45d2-ae7e-533a19310ec4&quot;:{&quot;id&quot;:&quot;82468011-4845-45d2-ae7e-533a19310ec4&quot;,&quot;type&quot;:&quot;FIGURE_OBJECT&quot;,&quot;document&quot;:{&quot;type&quot;:&quot;FIGURE&quot;,&quot;canvasType&quot;:&quot;FIGURE&quot;,&quot;units&quot;:&quot;in&quot;},&quot;parent&quot;:{&quot;parentId&quot;:&quot;37e2aa28-cd10-4bfd-92df-0a3c31376c99&quot;,&quot;type&quot;:&quot;DOCUMENT&quot;,&quot;order&quot;:&quot;5&quot;}},&quot;37e2aa28-cd10-4bfd-92df-0a3c31376c99&quot;:{&quot;id&quot;:&quot;37e2aa28-cd10-4bfd-92df-0a3c31376c99&quot;,&quot;type&quot;:&quot;FIGURE_OBJECT&quot;,&quot;document&quot;:{&quot;type&quot;:&quot;DOCUMENT_GROUP&quot;,&quot;canvasType&quot;:&quot;FIGURE&quot;,&quot;units&quot;:&quot;in&quot;}}}}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9695d10ed4b5880ee2c709d"/>
  <p:tag name="FIGURESLIDEID" val="82468011-4845-45d2-ae7e-533a19310ec4"/>
  <p:tag name="SELECTIONIDS" val="6cae8e80-36b7-4d81-b1d2-4cfae14cb9ba"/>
  <p:tag name="TRANSPARENTBACKGROUND" val="true"/>
  <p:tag name="VERSION" val="1770643664268"/>
  <p:tag name="TITLE" val="Broth Dilution"/>
  <p:tag name="CREATORNAME" val="Woubit Abebe"/>
  <p:tag name="DATEINSERTED" val="1770643663814"/>
  <p:tag name="DPI" val="300"/>
  <p:tag name="BIOJSON" val="{&quot;id&quot;:&quot;37e2aa28-cd10-4bfd-92df-0a3c31376c99&quot;,&quot;objects&quot;:{&quot;6cae8e80-36b7-4d81-b1d2-4cfae14cb9ba&quot;:{&quot;relativeTransform&quot;:{&quot;translate&quot;:{&quot;x&quot;:198.8193373957055,&quot;y&quot;:38.441995907213396},&quot;rotate&quot;:0,&quot;skewX&quot;:0,&quot;scale&quot;:{&quot;x&quot;:1,&quot;y&quot;:1}},&quot;type&quot;:&quot;FIGURE_OBJECT&quot;,&quot;id&quot;:&quot;6cae8e80-36b7-4d81-b1d2-4cfae14cb9ba&quot;,&quot;opacity&quot;:1,&quot;path&quot;:{&quot;type&quot;:&quot;POLY_LINE&quot;,&quot;points&quot;:[{&quot;x&quot;:4.974641926767617,&quot;y&quot;:-137.02271231082307},{&quot;x&quot;:13.185661039235299,&quot;y&quot;:-158.41658203145784},{&quot;x&quot;:28.715525288267486,&quot;y&quot;:-168.3407703671512},{&quot;x&quot;:44.33526212272119,&quot;y&quot;:-158.81658203145784},{&quot;x&quot;:54.935953265994215,&quot;y&quot;:-135.79148492246026}],&quot;closed&quot;:false,&quot;selectedObjectIds&quot;:[&quot;69922a4c-8668-4e32-9dc7-a4d983b2e733&quot;]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82468011-4845-45d2-ae7e-533a19310ec4&quot;,&quot;order&quot;:&quot;999999999997&quot;},&quot;connectorInfo&quot;:{&quot;connectedObjects&quot;:[],&quot;type&quot;:&quot;CUBIC&quot;,&quot;offset&quot;:{&quot;x&quot;:0,&quot;y&quot;:0},&quot;bending&quot;:-0.1,&quot;firstElementIsHead&quot;:true,&quot;customized&quot;:true},&quot;pathSmoothing&quot;:{&quot;type&quot;:&quot;CATMULL_SMOOTHING&quot;,&quot;smoothing&quot;:0.2},&quot;name&quot;:&quot;Curving arrow (editable) 4&quot;,&quot;displayName&quot;:&quot;Curving arrow (editable) 4&quot;,&quot;source&quot;:{&quot;id&quot;:&quot;62698ecb4e765946d04af2fb&quot;,&quot;type&quot;:&quot;ASSETS&quot;},&quot;isPremium&quot;:false},&quot;82468011-4845-45d2-ae7e-533a19310ec4&quot;:{&quot;id&quot;:&quot;82468011-4845-45d2-ae7e-533a19310ec4&quot;,&quot;type&quot;:&quot;FIGURE_OBJECT&quot;,&quot;document&quot;:{&quot;type&quot;:&quot;FIGURE&quot;,&quot;canvasType&quot;:&quot;FIGURE&quot;,&quot;units&quot;:&quot;in&quot;},&quot;parent&quot;:{&quot;parentId&quot;:&quot;37e2aa28-cd10-4bfd-92df-0a3c31376c99&quot;,&quot;type&quot;:&quot;DOCUMENT&quot;,&quot;order&quot;:&quot;5&quot;}},&quot;37e2aa28-cd10-4bfd-92df-0a3c31376c99&quot;:{&quot;id&quot;:&quot;37e2aa28-cd10-4bfd-92df-0a3c31376c99&quot;,&quot;type&quot;:&quot;FIGURE_OBJECT&quot;,&quot;document&quot;:{&quot;type&quot;:&quot;DOCUMENT_GROUP&quot;,&quot;canvasType&quot;:&quot;FIGURE&quot;,&quot;units&quot;:&quot;in&quot;}}}}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9695d10ed4b5880ee2c709d"/>
  <p:tag name="FIGURESLIDEID" val="82468011-4845-45d2-ae7e-533a19310ec4"/>
  <p:tag name="SELECTIONIDS" val="78fa19c9-0fb4-4a8f-87f2-0a9175bf6932"/>
  <p:tag name="TRANSPARENTBACKGROUND" val="true"/>
  <p:tag name="VERSION" val="1770643664268"/>
  <p:tag name="TITLE" val="Broth Dilution"/>
  <p:tag name="CREATORNAME" val="Woubit Abebe"/>
  <p:tag name="DATEINSERTED" val="1770643663814"/>
  <p:tag name="DPI" val="300"/>
  <p:tag name="BIOJSON" val="{&quot;id&quot;:&quot;37e2aa28-cd10-4bfd-92df-0a3c31376c99&quot;,&quot;objects&quot;:{&quot;78fa19c9-0fb4-4a8f-87f2-0a9175bf6932&quot;:{&quot;id&quot;:&quot;78fa19c9-0fb4-4a8f-87f2-0a9175bf6932&quot;,&quot;name&quot;:&quot;Test tube (15 mL, 1/2 liquid)&quot;,&quot;displayName&quot;:&quot;&quot;,&quot;type&quot;:&quot;FIGURE_OBJECT&quot;,&quot;relativeTransform&quot;:{&quot;translate&quot;:{&quot;x&quot;:-376.26729982016894,&quot;y&quot;:-5.116172516627941},&quot;rotate&quot;:0,&quot;skewX&quot;:0,&quot;scale&quot;:{&quot;x&quot;:0.7117130970948358,&quot;y&quot;:0.7117130970948358}},&quot;image&quot;:{&quot;url&quot;:&quot;https://icons.cdn.biorender.com/biorender/5e56940cc45c7c0028ca1e8e/20200226201646/image/5e56940cc45c7c0028ca1e8e.png&quot;,&quot;isPremium&quot;:true,&quot;isOrgIcon&quot;:false,&quot;size&quot;:{&quot;x&quot;:50,&quot;y&quot;:222.80701754385964}},&quot;source&quot;:{&quot;id&quot;:&quot;5e56940cc45c7c0028ca1e8e&quot;,&quot;version&quot;:&quot;20200226201646&quot;,&quot;type&quot;:&quot;ASSETS&quot;},&quot;isPremium&quot;:true,&quot;parent&quot;:{&quot;type&quot;:&quot;CHILD&quot;,&quot;parentId&quot;:&quot;82468011-4845-45d2-ae7e-533a19310ec4&quot;,&quot;order&quot;:&quot;7&quot;}},&quot;82468011-4845-45d2-ae7e-533a19310ec4&quot;:{&quot;id&quot;:&quot;82468011-4845-45d2-ae7e-533a19310ec4&quot;,&quot;type&quot;:&quot;FIGURE_OBJECT&quot;,&quot;document&quot;:{&quot;type&quot;:&quot;FIGURE&quot;,&quot;canvasType&quot;:&quot;FIGURE&quot;,&quot;units&quot;:&quot;in&quot;},&quot;parent&quot;:{&quot;parentId&quot;:&quot;37e2aa28-cd10-4bfd-92df-0a3c31376c99&quot;,&quot;type&quot;:&quot;DOCUMENT&quot;,&quot;order&quot;:&quot;5&quot;}},&quot;37e2aa28-cd10-4bfd-92df-0a3c31376c99&quot;:{&quot;id&quot;:&quot;37e2aa28-cd10-4bfd-92df-0a3c31376c99&quot;,&quot;type&quot;:&quot;FIGURE_OBJECT&quot;,&quot;document&quot;:{&quot;type&quot;:&quot;DOCUMENT_GROUP&quot;,&quot;canvasType&quot;:&quot;FIGURE&quot;,&quot;units&quot;:&quot;in&quot;}}}}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9695d10ed4b5880ee2c709d"/>
  <p:tag name="FIGURESLIDEID" val="82468011-4845-45d2-ae7e-533a19310ec4"/>
  <p:tag name="SELECTIONIDS" val="b6691bc7-eb59-43e6-9bfa-21b6c97d2e30"/>
  <p:tag name="TRANSPARENTBACKGROUND" val="true"/>
  <p:tag name="VERSION" val="1770643664268"/>
  <p:tag name="TITLE" val="Broth Dilution"/>
  <p:tag name="CREATORNAME" val="Woubit Abebe"/>
  <p:tag name="DATEINSERTED" val="1770643663814"/>
  <p:tag name="DPI" val="300"/>
  <p:tag name="BIOJSON" val="{&quot;id&quot;:&quot;37e2aa28-cd10-4bfd-92df-0a3c31376c99&quot;,&quot;objects&quot;:{&quot;b6691bc7-eb59-43e6-9bfa-21b6c97d2e30&quot;:{&quot;relativeTransform&quot;:{&quot;translate&quot;:{&quot;x&quot;:256.5516545458215,&quot;y&quot;:38.442837007906135},&quot;rotate&quot;:0,&quot;skewX&quot;:0,&quot;scale&quot;:{&quot;x&quot;:1,&quot;y&quot;:1}},&quot;type&quot;:&quot;FIGURE_OBJECT&quot;,&quot;id&quot;:&quot;b6691bc7-eb59-43e6-9bfa-21b6c97d2e30&quot;,&quot;opacity&quot;:1,&quot;path&quot;:{&quot;type&quot;:&quot;POLY_LINE&quot;,&quot;points&quot;:[{&quot;x&quot;:4.974641926767617,&quot;y&quot;:-137.02271231082307},{&quot;x&quot;:13.185661039235299,&quot;y&quot;:-158.41658203145784},{&quot;x&quot;:28.715525288267486,&quot;y&quot;:-168.3407703671512},{&quot;x&quot;:44.33526212272119,&quot;y&quot;:-158.81658203145784},{&quot;x&quot;:54.935953265994215,&quot;y&quot;:-135.79148492246026}],&quot;closed&quot;:false,&quot;selectedObjectIds&quot;:[&quot;69922a4c-8668-4e32-9dc7-a4d983b2e733&quot;]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82468011-4845-45d2-ae7e-533a19310ec4&quot;,&quot;order&quot;:&quot;999999999998&quot;},&quot;connectorInfo&quot;:{&quot;connectedObjects&quot;:[],&quot;type&quot;:&quot;CUBIC&quot;,&quot;offset&quot;:{&quot;x&quot;:0,&quot;y&quot;:0},&quot;bending&quot;:-0.1,&quot;firstElementIsHead&quot;:true,&quot;customized&quot;:true},&quot;pathSmoothing&quot;:{&quot;type&quot;:&quot;CATMULL_SMOOTHING&quot;,&quot;smoothing&quot;:0.2},&quot;name&quot;:&quot;Curving arrow (editable) 4&quot;,&quot;displayName&quot;:&quot;Curving arrow (editable) 4&quot;,&quot;source&quot;:{&quot;id&quot;:&quot;62698ecb4e765946d04af2fb&quot;,&quot;type&quot;:&quot;ASSETS&quot;},&quot;isPremium&quot;:false},&quot;82468011-4845-45d2-ae7e-533a19310ec4&quot;:{&quot;id&quot;:&quot;82468011-4845-45d2-ae7e-533a19310ec4&quot;,&quot;type&quot;:&quot;FIGURE_OBJECT&quot;,&quot;document&quot;:{&quot;type&quot;:&quot;FIGURE&quot;,&quot;canvasType&quot;:&quot;FIGURE&quot;,&quot;units&quot;:&quot;in&quot;},&quot;parent&quot;:{&quot;parentId&quot;:&quot;37e2aa28-cd10-4bfd-92df-0a3c31376c99&quot;,&quot;type&quot;:&quot;DOCUMENT&quot;,&quot;order&quot;:&quot;5&quot;}},&quot;37e2aa28-cd10-4bfd-92df-0a3c31376c99&quot;:{&quot;id&quot;:&quot;37e2aa28-cd10-4bfd-92df-0a3c31376c99&quot;,&quot;type&quot;:&quot;FIGURE_OBJECT&quot;,&quot;document&quot;:{&quot;type&quot;:&quot;DOCUMENT_GROUP&quot;,&quot;canvasType&quot;:&quot;FIGURE&quot;,&quot;units&quot;:&quot;in&quot;}}}}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9695d10ed4b5880ee2c709d"/>
  <p:tag name="FIGURESLIDEID" val="82468011-4845-45d2-ae7e-533a19310ec4"/>
  <p:tag name="SELECTIONIDS" val="a61dfb4d-a13e-4ccf-970a-fe50614c6c74"/>
  <p:tag name="TRANSPARENTBACKGROUND" val="true"/>
  <p:tag name="VERSION" val="1770643664268"/>
  <p:tag name="TITLE" val="Broth Dilution"/>
  <p:tag name="CREATORNAME" val="Woubit Abebe"/>
  <p:tag name="DATEINSERTED" val="1770643663814"/>
  <p:tag name="DPI" val="300"/>
  <p:tag name="BIOJSON" val="{&quot;id&quot;:&quot;37e2aa28-cd10-4bfd-92df-0a3c31376c99&quot;,&quot;objects&quot;:{&quot;a61dfb4d-a13e-4ccf-970a-fe50614c6c74&quot;:{&quot;relativeTransform&quot;:{&quot;translate&quot;:{&quot;x&quot;:316.25778981880126,&quot;y&quot;:38.44238263931483},&quot;rotate&quot;:0,&quot;skewX&quot;:0,&quot;scale&quot;:{&quot;x&quot;:1,&quot;y&quot;:1}},&quot;type&quot;:&quot;FIGURE_OBJECT&quot;,&quot;id&quot;:&quot;a61dfb4d-a13e-4ccf-970a-fe50614c6c74&quot;,&quot;opacity&quot;:1,&quot;path&quot;:{&quot;type&quot;:&quot;POLY_LINE&quot;,&quot;points&quot;:[{&quot;x&quot;:4.974641926767617,&quot;y&quot;:-137.02271231082307},{&quot;x&quot;:13.185661039235299,&quot;y&quot;:-158.41658203145784},{&quot;x&quot;:28.715525288267486,&quot;y&quot;:-168.3407703671512},{&quot;x&quot;:44.33526212272119,&quot;y&quot;:-158.81658203145784},{&quot;x&quot;:54.935953265994215,&quot;y&quot;:-135.79148492246026}],&quot;closed&quot;:false,&quot;selectedObjectIds&quot;:[&quot;69922a4c-8668-4e32-9dc7-a4d983b2e733&quot;]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82468011-4845-45d2-ae7e-533a19310ec4&quot;,&quot;order&quot;:&quot;999999999999&quot;},&quot;connectorInfo&quot;:{&quot;connectedObjects&quot;:[],&quot;type&quot;:&quot;CUBIC&quot;,&quot;offset&quot;:{&quot;x&quot;:0,&quot;y&quot;:0},&quot;bending&quot;:-0.1,&quot;firstElementIsHead&quot;:true,&quot;customized&quot;:true},&quot;pathSmoothing&quot;:{&quot;type&quot;:&quot;CATMULL_SMOOTHING&quot;,&quot;smoothing&quot;:0.2},&quot;name&quot;:&quot;Curving arrow (editable) 4&quot;,&quot;displayName&quot;:&quot;Curving arrow (editable) 4&quot;,&quot;source&quot;:{&quot;id&quot;:&quot;62698ecb4e765946d04af2fb&quot;,&quot;type&quot;:&quot;ASSETS&quot;},&quot;isPremium&quot;:false},&quot;82468011-4845-45d2-ae7e-533a19310ec4&quot;:{&quot;id&quot;:&quot;82468011-4845-45d2-ae7e-533a19310ec4&quot;,&quot;type&quot;:&quot;FIGURE_OBJECT&quot;,&quot;document&quot;:{&quot;type&quot;:&quot;FIGURE&quot;,&quot;canvasType&quot;:&quot;FIGURE&quot;,&quot;units&quot;:&quot;in&quot;},&quot;parent&quot;:{&quot;parentId&quot;:&quot;37e2aa28-cd10-4bfd-92df-0a3c31376c99&quot;,&quot;type&quot;:&quot;DOCUMENT&quot;,&quot;order&quot;:&quot;5&quot;}},&quot;37e2aa28-cd10-4bfd-92df-0a3c31376c99&quot;:{&quot;id&quot;:&quot;37e2aa28-cd10-4bfd-92df-0a3c31376c99&quot;,&quot;type&quot;:&quot;FIGURE_OBJECT&quot;,&quot;document&quot;:{&quot;type&quot;:&quot;DOCUMENT_GROUP&quot;,&quot;canvasType&quot;:&quot;FIGURE&quot;,&quot;units&quot;:&quot;in&quot;}}}}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9695d10ed4b5880ee2c709d"/>
  <p:tag name="FIGURESLIDEID" val="82468011-4845-45d2-ae7e-533a19310ec4"/>
  <p:tag name="SELECTIONIDS" val="216b342f-c87a-4156-907a-a081aab63bb6"/>
  <p:tag name="TRANSPARENTBACKGROUND" val="true"/>
  <p:tag name="VERSION" val="1770643664268"/>
  <p:tag name="TITLE" val="Broth Dilution"/>
  <p:tag name="CREATORNAME" val="Woubit Abebe"/>
  <p:tag name="DATEINSERTED" val="1770643663814"/>
  <p:tag name="DPI" val="300"/>
  <p:tag name="BIOJSON" val="{&quot;id&quot;:&quot;37e2aa28-cd10-4bfd-92df-0a3c31376c99&quot;,&quot;objects&quot;:{&quot;216b342f-c87a-4156-907a-a081aab63bb6&quot;:{&quot;relativeTransform&quot;:{&quot;translate&quot;:{&quot;x&quot;:375.29187983021177,&quot;y&quot;:38.44251920929163},&quot;rotate&quot;:0,&quot;skewX&quot;:0,&quot;scale&quot;:{&quot;x&quot;:1,&quot;y&quot;:1}},&quot;type&quot;:&quot;FIGURE_OBJECT&quot;,&quot;id&quot;:&quot;216b342f-c87a-4156-907a-a081aab63bb6&quot;,&quot;opacity&quot;:1,&quot;path&quot;:{&quot;type&quot;:&quot;POLY_LINE&quot;,&quot;points&quot;:[{&quot;x&quot;:4.974641926767617,&quot;y&quot;:-137.02271231082307},{&quot;x&quot;:13.185661039235299,&quot;y&quot;:-158.41658203145784},{&quot;x&quot;:28.715525288267486,&quot;y&quot;:-168.3407703671512},{&quot;x&quot;:44.33526212272119,&quot;y&quot;:-158.81658203145784},{&quot;x&quot;:54.935953265994215,&quot;y&quot;:-135.79148492246026}],&quot;closed&quot;:false,&quot;selectedObjectIds&quot;:[&quot;69922a4c-8668-4e32-9dc7-a4d983b2e733&quot;]},&quot;pathStyles&quot;:[{&quot;type&quot;:&quot;FILL&quot;,&quot;fillStyle&quot;:&quot;rgba(0,0,0,0)&quot;},{&quot;type&quot;:&quot;STROKE&quot;,&quot;strokeStyle&quot;:&quot;#232323&quot;,&quot;lineWidth&quot;:2,&quot;lineJoin&quot;:&quot;round&quot;}],&quot;pathMarkers&quot;:{&quot;markerEnd&quot;:{&quot;type&quot;:&quot;PATH&quot;,&quot;units&quot;:{&quot;type&quot;:&quot;STROKE_WIDTH&quot;,&quot;scale&quot;:1},&quot;orient&quot;:{&quot;type&quot;:&quot;CLIPPED_CHORD&quot;},&quot;clipDistance&quot;:4,&quot;name&quot;:&quot;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5,&quot;y&quot;:-2.5,&quot;isEndPoint&quot;:true},{&quot;x&quot;:-5,&quot;y&quot;:2.5,&quot;isEndPoint&quot;:true}],&quot;closed&quot;:true}},&quot;pathStyles&quot;:[{&quot;type&quot;:&quot;FILL&quot;,&quot;fillStyle&quot;:&quot;context-stroke-flat&quot;}]}},&quot;isLocked&quot;:false,&quot;parent&quot;:{&quot;type&quot;:&quot;CHILD&quot;,&quot;parentId&quot;:&quot;82468011-4845-45d2-ae7e-533a19310ec4&quot;,&quot;order&quot;:&quot;9999999999995&quot;},&quot;connectorInfo&quot;:{&quot;connectedObjects&quot;:[],&quot;type&quot;:&quot;CUBIC&quot;,&quot;offset&quot;:{&quot;x&quot;:0,&quot;y&quot;:0},&quot;bending&quot;:-0.1,&quot;firstElementIsHead&quot;:true,&quot;customized&quot;:true},&quot;pathSmoothing&quot;:{&quot;type&quot;:&quot;CATMULL_SMOOTHING&quot;,&quot;smoothing&quot;:0.2},&quot;name&quot;:&quot;Curving arrow (editable) 4&quot;,&quot;displayName&quot;:&quot;Curving arrow (editable) 4&quot;,&quot;source&quot;:{&quot;id&quot;:&quot;62698ecb4e765946d04af2fb&quot;,&quot;type&quot;:&quot;ASSETS&quot;},&quot;isPremium&quot;:false},&quot;82468011-4845-45d2-ae7e-533a19310ec4&quot;:{&quot;id&quot;:&quot;82468011-4845-45d2-ae7e-533a19310ec4&quot;,&quot;type&quot;:&quot;FIGURE_OBJECT&quot;,&quot;document&quot;:{&quot;type&quot;:&quot;FIGURE&quot;,&quot;canvasType&quot;:&quot;FIGURE&quot;,&quot;units&quot;:&quot;in&quot;},&quot;parent&quot;:{&quot;parentId&quot;:&quot;37e2aa28-cd10-4bfd-92df-0a3c31376c99&quot;,&quot;type&quot;:&quot;DOCUMENT&quot;,&quot;order&quot;:&quot;5&quot;}},&quot;37e2aa28-cd10-4bfd-92df-0a3c31376c99&quot;:{&quot;id&quot;:&quot;37e2aa28-cd10-4bfd-92df-0a3c31376c99&quot;,&quot;type&quot;:&quot;FIGURE_OBJECT&quot;,&quot;document&quot;:{&quot;type&quot;:&quot;DOCUMENT_GROUP&quot;,&quot;canvasType&quot;:&quot;FIGURE&quot;,&quot;units&quot;:&quot;in&quot;}}}}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9695d10ed4b5880ee2c709d"/>
  <p:tag name="FIGURESLIDEID" val="82468011-4845-45d2-ae7e-533a19310ec4"/>
  <p:tag name="SELECTIONIDS" val="5ea89c95-945f-4fb3-b68c-c6c311cf1c3c"/>
  <p:tag name="TRANSPARENTBACKGROUND" val="true"/>
  <p:tag name="VERSION" val="1770643664268"/>
  <p:tag name="TITLE" val="Broth Dilution"/>
  <p:tag name="CREATORNAME" val="Woubit Abebe"/>
  <p:tag name="DATEINSERTED" val="1770643663814"/>
  <p:tag name="DPI" val="300"/>
  <p:tag name="BIOJSON" val="{&quot;id&quot;:&quot;37e2aa28-cd10-4bfd-92df-0a3c31376c99&quot;,&quot;objects&quot;:{&quot;5ea89c95-945f-4fb3-b68c-c6c311cf1c3c&quot;:{&quot;relativeTransform&quot;:{&quot;translate&quot;:{&quot;x&quot;:-29.880295383379007,&quot;y&quot;:-177.86439488250943},&quot;rotate&quot;:3.141592653589793,&quot;skewX&quot;:0,&quot;scale&quot;:{&quot;x&quot;:0.9999999999999998,&quot;y&quot;:0.9999999999999998}},&quot;type&quot;:&quot;FIGURE_OBJECT&quot;,&quot;id&quot;:&quot;5ea89c95-945f-4fb3-b68c-c6c311cf1c3c&quot;,&quot;opacity&quot;:1,&quot;path&quot;:{&quot;type&quot;:&quot;POLY_LINE&quot;,&quot;points&quot;:[{&quot;x&quot;:0,&quot;y&quot;:29.91988592127491},{&quot;x&quot;:0,&quot;y&quot;:-29.91988592127491}],&quot;closed&quot;:false},&quot;pathStyles&quot;:[{&quot;type&quot;:&quot;FILL&quot;,&quot;fillStyle&quot;:&quot;rgba(0,0,0,0)&quot;},{&quot;type&quot;:&quot;STROKE&quot;,&quot;strokeStyle&quot;:&quot;#232323&quot;,&quot;lineWidth&quot;:9.634241258256798,&quot;lineJoin&quot;:&quot;round&quot;}],&quot;isLocked&quot;:false,&quot;parent&quot;:{&quot;type&quot;:&quot;CHILD&quot;,&quot;parentId&quot;:&quot;82468011-4845-45d2-ae7e-533a19310ec4&quot;,&quot;order&quot;:&quot;9999999999997&quot;},&quot;connectorInfo&quot;:{&quot;connectedObjects&quot;:[],&quot;type&quot;:&quot;LINE&quot;,&quot;offset&quot;:{&quot;x&quot;:0,&quot;y&quot;:0},&quot;bending&quot;:0.1,&quot;firstElementIsHead&quot;:true,&quot;customized&quot;:false},&quot;pathMarkers&quot;:{&quot;markerEnd&quot;:{&quot;type&quot;:&quot;PATH&quot;,&quot;units&quot;:{&quot;type&quot;:&quot;STROKE_WIDTH&quot;,&quot;scale&quot;:0.5},&quot;orient&quot;:{&quot;type&quot;:&quot;CLIPPED_CHORD&quot;},&quot;clipDistance&quot;:2,&quot;name&quot;:&quot;short-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2.5,&quot;y&quot;:-2.5,&quot;isEndPoint&quot;:true},{&quot;x&quot;:-2.5,&quot;y&quot;:2.5,&quot;isEndPoint&quot;:true}],&quot;closed&quot;:true}},&quot;pathStyles&quot;:[{&quot;type&quot;:&quot;FILL&quot;,&quot;fillStyle&quot;:&quot;context-stroke-flat&quot;}]}},&quot;name&quot;:&quot;Straight arrow (thick, large arrowhead, editable)&quot;,&quot;displayName&quot;:&quot;Straight arrow (thick, large arrowhead, editable)&quot;,&quot;source&quot;:{&quot;id&quot;:&quot;648741de5ca6211d7d057176&quot;,&quot;type&quot;:&quot;ASSETS&quot;},&quot;isPremium&quot;:false},&quot;82468011-4845-45d2-ae7e-533a19310ec4&quot;:{&quot;id&quot;:&quot;82468011-4845-45d2-ae7e-533a19310ec4&quot;,&quot;type&quot;:&quot;FIGURE_OBJECT&quot;,&quot;document&quot;:{&quot;type&quot;:&quot;FIGURE&quot;,&quot;canvasType&quot;:&quot;FIGURE&quot;,&quot;units&quot;:&quot;in&quot;},&quot;parent&quot;:{&quot;parentId&quot;:&quot;37e2aa28-cd10-4bfd-92df-0a3c31376c99&quot;,&quot;type&quot;:&quot;DOCUMENT&quot;,&quot;order&quot;:&quot;5&quot;}},&quot;37e2aa28-cd10-4bfd-92df-0a3c31376c99&quot;:{&quot;id&quot;:&quot;37e2aa28-cd10-4bfd-92df-0a3c31376c99&quot;,&quot;type&quot;:&quot;FIGURE_OBJECT&quot;,&quot;document&quot;:{&quot;type&quot;:&quot;DOCUMENT_GROUP&quot;,&quot;canvasType&quot;:&quot;FIGURE&quot;,&quot;units&quot;:&quot;in&quot;}}}}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9695d10ed4b5880ee2c709d"/>
  <p:tag name="FIGURESLIDEID" val="82468011-4845-45d2-ae7e-533a19310ec4"/>
  <p:tag name="SELECTIONIDS" val="7d00253c-afbb-4c9e-bb74-214a016034ee"/>
  <p:tag name="TRANSPARENTBACKGROUND" val="true"/>
  <p:tag name="VERSION" val="1770643664268"/>
  <p:tag name="TITLE" val="Broth Dilution"/>
  <p:tag name="CREATORNAME" val="Woubit Abebe"/>
  <p:tag name="DATEINSERTED" val="1770643663814"/>
  <p:tag name="DPI" val="300"/>
  <p:tag name="BIOJSON" val="{&quot;id&quot;:&quot;37e2aa28-cd10-4bfd-92df-0a3c31376c99&quot;,&quot;objects&quot;:{&quot;7d00253c-afbb-4c9e-bb74-214a016034ee&quot;:{&quot;relativeTransform&quot;:{&quot;translate&quot;:{&quot;x&quot;:84.85440231742463,&quot;y&quot;:-177.86445457918379},&quot;rotate&quot;:3.141592653589793,&quot;skewX&quot;:0,&quot;scale&quot;:{&quot;x&quot;:0.9999999999999998,&quot;y&quot;:0.9999999999999998}},&quot;type&quot;:&quot;FIGURE_OBJECT&quot;,&quot;id&quot;:&quot;7d00253c-afbb-4c9e-bb74-214a016034ee&quot;,&quot;opacity&quot;:1,&quot;path&quot;:{&quot;type&quot;:&quot;POLY_LINE&quot;,&quot;points&quot;:[{&quot;x&quot;:0,&quot;y&quot;:29.91988592127491},{&quot;x&quot;:0,&quot;y&quot;:-29.91988592127491}],&quot;closed&quot;:false},&quot;pathStyles&quot;:[{&quot;type&quot;:&quot;FILL&quot;,&quot;fillStyle&quot;:&quot;rgba(0,0,0,0)&quot;},{&quot;type&quot;:&quot;STROKE&quot;,&quot;strokeStyle&quot;:&quot;#232323&quot;,&quot;lineWidth&quot;:9.634241258256798,&quot;lineJoin&quot;:&quot;round&quot;}],&quot;isLocked&quot;:false,&quot;parent&quot;:{&quot;type&quot;:&quot;CHILD&quot;,&quot;parentId&quot;:&quot;82468011-4845-45d2-ae7e-533a19310ec4&quot;,&quot;order&quot;:&quot;9999999999998&quot;},&quot;connectorInfo&quot;:{&quot;connectedObjects&quot;:[],&quot;type&quot;:&quot;LINE&quot;,&quot;offset&quot;:{&quot;x&quot;:0,&quot;y&quot;:0},&quot;bending&quot;:0.1,&quot;firstElementIsHead&quot;:true,&quot;customized&quot;:false},&quot;pathMarkers&quot;:{&quot;markerEnd&quot;:{&quot;type&quot;:&quot;PATH&quot;,&quot;units&quot;:{&quot;type&quot;:&quot;STROKE_WIDTH&quot;,&quot;scale&quot;:0.5},&quot;orient&quot;:{&quot;type&quot;:&quot;CLIPPED_CHORD&quot;},&quot;clipDistance&quot;:2,&quot;name&quot;:&quot;short-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2.5,&quot;y&quot;:-2.5,&quot;isEndPoint&quot;:true},{&quot;x&quot;:-2.5,&quot;y&quot;:2.5,&quot;isEndPoint&quot;:true}],&quot;closed&quot;:true}},&quot;pathStyles&quot;:[{&quot;type&quot;:&quot;FILL&quot;,&quot;fillStyle&quot;:&quot;context-stroke-flat&quot;}]}},&quot;name&quot;:&quot;Straight arrow (thick, large arrowhead, editable)&quot;,&quot;displayName&quot;:&quot;Straight arrow (thick, large arrowhead, editable)&quot;,&quot;source&quot;:{&quot;id&quot;:&quot;648741de5ca6211d7d057176&quot;,&quot;type&quot;:&quot;ASSETS&quot;},&quot;isPremium&quot;:false},&quot;82468011-4845-45d2-ae7e-533a19310ec4&quot;:{&quot;id&quot;:&quot;82468011-4845-45d2-ae7e-533a19310ec4&quot;,&quot;type&quot;:&quot;FIGURE_OBJECT&quot;,&quot;document&quot;:{&quot;type&quot;:&quot;FIGURE&quot;,&quot;canvasType&quot;:&quot;FIGURE&quot;,&quot;units&quot;:&quot;in&quot;},&quot;parent&quot;:{&quot;parentId&quot;:&quot;37e2aa28-cd10-4bfd-92df-0a3c31376c99&quot;,&quot;type&quot;:&quot;DOCUMENT&quot;,&quot;order&quot;:&quot;5&quot;}},&quot;37e2aa28-cd10-4bfd-92df-0a3c31376c99&quot;:{&quot;id&quot;:&quot;37e2aa28-cd10-4bfd-92df-0a3c31376c99&quot;,&quot;type&quot;:&quot;FIGURE_OBJECT&quot;,&quot;document&quot;:{&quot;type&quot;:&quot;DOCUMENT_GROUP&quot;,&quot;canvasType&quot;:&quot;FIGURE&quot;,&quot;units&quot;:&quot;in&quot;}}}}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9695d10ed4b5880ee2c709d"/>
  <p:tag name="FIGURESLIDEID" val="82468011-4845-45d2-ae7e-533a19310ec4"/>
  <p:tag name="SELECTIONIDS" val="b7396c60-43ee-421e-9e57-131b23603bdb"/>
  <p:tag name="TRANSPARENTBACKGROUND" val="true"/>
  <p:tag name="VERSION" val="1770643664268"/>
  <p:tag name="TITLE" val="Broth Dilution"/>
  <p:tag name="CREATORNAME" val="Woubit Abebe"/>
  <p:tag name="DATEINSERTED" val="1770643663814"/>
  <p:tag name="DPI" val="300"/>
  <p:tag name="BIOJSON" val="{&quot;id&quot;:&quot;37e2aa28-cd10-4bfd-92df-0a3c31376c99&quot;,&quot;objects&quot;:{&quot;b7396c60-43ee-421e-9e57-131b23603bdb&quot;:{&quot;relativeTransform&quot;:{&quot;translate&quot;:{&quot;x&quot;:313.1645406273183,&quot;y&quot;:-177.0348845785116},&quot;rotate&quot;:3.141592653589793,&quot;skewX&quot;:0,&quot;scale&quot;:{&quot;x&quot;:0.9999999999999998,&quot;y&quot;:0.9999999999999998}},&quot;type&quot;:&quot;FIGURE_OBJECT&quot;,&quot;id&quot;:&quot;b7396c60-43ee-421e-9e57-131b23603bdb&quot;,&quot;opacity&quot;:1,&quot;path&quot;:{&quot;type&quot;:&quot;POLY_LINE&quot;,&quot;points&quot;:[{&quot;x&quot;:0,&quot;y&quot;:29.91988592127491},{&quot;x&quot;:0,&quot;y&quot;:-29.91988592127491}],&quot;closed&quot;:false},&quot;pathStyles&quot;:[{&quot;type&quot;:&quot;FILL&quot;,&quot;fillStyle&quot;:&quot;rgba(0,0,0,0)&quot;},{&quot;type&quot;:&quot;STROKE&quot;,&quot;strokeStyle&quot;:&quot;#232323&quot;,&quot;lineWidth&quot;:9.634241258256798,&quot;lineJoin&quot;:&quot;round&quot;}],&quot;isLocked&quot;:false,&quot;parent&quot;:{&quot;type&quot;:&quot;CHILD&quot;,&quot;parentId&quot;:&quot;82468011-4845-45d2-ae7e-533a19310ec4&quot;,&quot;order&quot;:&quot;9999999999999&quot;},&quot;connectorInfo&quot;:{&quot;connectedObjects&quot;:[],&quot;type&quot;:&quot;LINE&quot;,&quot;offset&quot;:{&quot;x&quot;:0,&quot;y&quot;:0},&quot;bending&quot;:0.1,&quot;firstElementIsHead&quot;:true,&quot;customized&quot;:false},&quot;pathMarkers&quot;:{&quot;markerEnd&quot;:{&quot;type&quot;:&quot;PATH&quot;,&quot;units&quot;:{&quot;type&quot;:&quot;STROKE_WIDTH&quot;,&quot;scale&quot;:0.5},&quot;orient&quot;:{&quot;type&quot;:&quot;CLIPPED_CHORD&quot;},&quot;clipDistance&quot;:2,&quot;name&quot;:&quot;short-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2.5,&quot;y&quot;:-2.5,&quot;isEndPoint&quot;:true},{&quot;x&quot;:-2.5,&quot;y&quot;:2.5,&quot;isEndPoint&quot;:true}],&quot;closed&quot;:true}},&quot;pathStyles&quot;:[{&quot;type&quot;:&quot;FILL&quot;,&quot;fillStyle&quot;:&quot;context-stroke-flat&quot;}]}},&quot;name&quot;:&quot;Straight arrow (thick, large arrowhead, editable)&quot;,&quot;displayName&quot;:&quot;Straight arrow (thick, large arrowhead, editable)&quot;,&quot;source&quot;:{&quot;id&quot;:&quot;648741de5ca6211d7d057176&quot;,&quot;type&quot;:&quot;ASSETS&quot;},&quot;isPremium&quot;:false},&quot;82468011-4845-45d2-ae7e-533a19310ec4&quot;:{&quot;id&quot;:&quot;82468011-4845-45d2-ae7e-533a19310ec4&quot;,&quot;type&quot;:&quot;FIGURE_OBJECT&quot;,&quot;document&quot;:{&quot;type&quot;:&quot;FIGURE&quot;,&quot;canvasType&quot;:&quot;FIGURE&quot;,&quot;units&quot;:&quot;in&quot;},&quot;parent&quot;:{&quot;parentId&quot;:&quot;37e2aa28-cd10-4bfd-92df-0a3c31376c99&quot;,&quot;type&quot;:&quot;DOCUMENT&quot;,&quot;order&quot;:&quot;5&quot;}},&quot;37e2aa28-cd10-4bfd-92df-0a3c31376c99&quot;:{&quot;id&quot;:&quot;37e2aa28-cd10-4bfd-92df-0a3c31376c99&quot;,&quot;type&quot;:&quot;FIGURE_OBJECT&quot;,&quot;document&quot;:{&quot;type&quot;:&quot;DOCUMENT_GROUP&quot;,&quot;canvasType&quot;:&quot;FIGURE&quot;,&quot;units&quot;:&quot;in&quot;}}}}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9695d10ed4b5880ee2c709d"/>
  <p:tag name="FIGURESLIDEID" val="82468011-4845-45d2-ae7e-533a19310ec4"/>
  <p:tag name="SELECTIONIDS" val="ec685a19-6c4a-4288-885a-01c108417700"/>
  <p:tag name="TRANSPARENTBACKGROUND" val="true"/>
  <p:tag name="VERSION" val="1770643664268"/>
  <p:tag name="TITLE" val="Broth Dilution"/>
  <p:tag name="CREATORNAME" val="Woubit Abebe"/>
  <p:tag name="DATEINSERTED" val="1770643663814"/>
  <p:tag name="DPI" val="300"/>
  <p:tag name="BIOJSON" val="{&quot;id&quot;:&quot;37e2aa28-cd10-4bfd-92df-0a3c31376c99&quot;,&quot;objects&quot;:{&quot;ec685a19-6c4a-4288-885a-01c108417700&quot;:{&quot;relativeTransform&quot;:{&quot;translate&quot;:{&quot;x&quot;:436.04497906783257,&quot;y&quot;:-180.34773639579578},&quot;rotate&quot;:3.141592653589793,&quot;skewX&quot;:0,&quot;scale&quot;:{&quot;x&quot;:0.9999999999999998,&quot;y&quot;:0.9999999999999998}},&quot;type&quot;:&quot;FIGURE_OBJECT&quot;,&quot;id&quot;:&quot;ec685a19-6c4a-4288-885a-01c108417700&quot;,&quot;opacity&quot;:1,&quot;path&quot;:{&quot;type&quot;:&quot;POLY_LINE&quot;,&quot;points&quot;:[{&quot;x&quot;:0,&quot;y&quot;:29.91988592127491},{&quot;x&quot;:0,&quot;y&quot;:-29.91988592127491}],&quot;closed&quot;:false},&quot;pathStyles&quot;:[{&quot;type&quot;:&quot;FILL&quot;,&quot;fillStyle&quot;:&quot;rgba(0,0,0,0)&quot;},{&quot;type&quot;:&quot;STROKE&quot;,&quot;strokeStyle&quot;:&quot;#232323&quot;,&quot;lineWidth&quot;:9.634241258256798,&quot;lineJoin&quot;:&quot;round&quot;}],&quot;isLocked&quot;:false,&quot;parent&quot;:{&quot;type&quot;:&quot;CHILD&quot;,&quot;parentId&quot;:&quot;82468011-4845-45d2-ae7e-533a19310ec4&quot;,&quot;order&quot;:&quot;99999999999995&quot;},&quot;connectorInfo&quot;:{&quot;connectedObjects&quot;:[],&quot;type&quot;:&quot;LINE&quot;,&quot;offset&quot;:{&quot;x&quot;:0,&quot;y&quot;:0},&quot;bending&quot;:0.1,&quot;firstElementIsHead&quot;:true,&quot;customized&quot;:false},&quot;pathMarkers&quot;:{&quot;markerEnd&quot;:{&quot;type&quot;:&quot;PATH&quot;,&quot;units&quot;:{&quot;type&quot;:&quot;STROKE_WIDTH&quot;,&quot;scale&quot;:0.5},&quot;orient&quot;:{&quot;type&quot;:&quot;CLIPPED_CHORD&quot;},&quot;clipDistance&quot;:2,&quot;name&quot;:&quot;short-arrow&quot;,&quot;relativeTransform&quot;:{&quot;translate&quot;:{&quot;x&quot;:0,&quot;y&quot;:0},&quot;rotate&quot;:0,&quot;skewX&quot;:0,&quot;scale&quot;:{&quot;x&quot;:1,&quot;y&quot;:1}},&quot;path&quot;:{&quot;type&quot;:&quot;SPLINE&quot;,&quot;spline&quot;:{&quot;points&quot;:[{&quot;x&quot;:0,&quot;y&quot;:0,&quot;isEndPoint&quot;:true},{&quot;x&quot;:-2.5,&quot;y&quot;:-2.5,&quot;isEndPoint&quot;:true},{&quot;x&quot;:-2.5,&quot;y&quot;:2.5,&quot;isEndPoint&quot;:true}],&quot;closed&quot;:true}},&quot;pathStyles&quot;:[{&quot;type&quot;:&quot;FILL&quot;,&quot;fillStyle&quot;:&quot;context-stroke-flat&quot;}]}},&quot;name&quot;:&quot;Straight arrow (thick, large arrowhead, editable)&quot;,&quot;displayName&quot;:&quot;Straight arrow (thick, large arrowhead, editable)&quot;,&quot;source&quot;:{&quot;id&quot;:&quot;648741de5ca6211d7d057176&quot;,&quot;type&quot;:&quot;ASSETS&quot;},&quot;isPremium&quot;:false},&quot;82468011-4845-45d2-ae7e-533a19310ec4&quot;:{&quot;id&quot;:&quot;82468011-4845-45d2-ae7e-533a19310ec4&quot;,&quot;type&quot;:&quot;FIGURE_OBJECT&quot;,&quot;document&quot;:{&quot;type&quot;:&quot;FIGURE&quot;,&quot;canvasType&quot;:&quot;FIGURE&quot;,&quot;units&quot;:&quot;in&quot;},&quot;parent&quot;:{&quot;parentId&quot;:&quot;37e2aa28-cd10-4bfd-92df-0a3c31376c99&quot;,&quot;type&quot;:&quot;DOCUMENT&quot;,&quot;order&quot;:&quot;5&quot;}},&quot;37e2aa28-cd10-4bfd-92df-0a3c31376c99&quot;:{&quot;id&quot;:&quot;37e2aa28-cd10-4bfd-92df-0a3c31376c99&quot;,&quot;type&quot;:&quot;FIGURE_OBJECT&quot;,&quot;document&quot;:{&quot;type&quot;:&quot;DOCUMENT_GROUP&quot;,&quot;canvasType&quot;:&quot;FIGURE&quot;,&quot;units&quot;:&quot;in&quot;}}}}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9695d10ed4b5880ee2c709d"/>
  <p:tag name="FIGURESLIDEID" val="82468011-4845-45d2-ae7e-533a19310ec4"/>
  <p:tag name="SELECTIONIDS" val="6a9335cd-e90e-4d88-922c-1cdf951865e1"/>
  <p:tag name="TRANSPARENTBACKGROUND" val="true"/>
  <p:tag name="VERSION" val="1770643664268"/>
  <p:tag name="TITLE" val="Broth Dilution"/>
  <p:tag name="CREATORNAME" val="Woubit Abebe"/>
  <p:tag name="DATEINSERTED" val="1770643663814"/>
  <p:tag name="DPI" val="300"/>
  <p:tag name="BIOJSON" val="{&quot;id&quot;:&quot;37e2aa28-cd10-4bfd-92df-0a3c31376c99&quot;,&quot;objects&quot;:{&quot;6a9335cd-e90e-4d88-922c-1cdf951865e1&quot;:{&quot;id&quot;:&quot;6a9335cd-e90e-4d88-922c-1cdf951865e1&quot;,&quot;name&quot;:&quot;Test tube (15 mL, 1/2 liquid)&quot;,&quot;displayName&quot;:&quot;&quot;,&quot;type&quot;:&quot;FIGURE_OBJECT&quot;,&quot;relativeTransform&quot;:{&quot;translate&quot;:{&quot;x&quot;:-318.5024406854547,&quot;y&quot;:-5.116172516627941},&quot;rotate&quot;:0,&quot;skewX&quot;:0,&quot;scale&quot;:{&quot;x&quot;:0.7117130970948358,&quot;y&quot;:0.7117130970948358}},&quot;image&quot;:{&quot;url&quot;:&quot;https://icons.cdn.biorender.com/biorender/5e56940cc45c7c0028ca1e8e/20200226201646/image/5e56940cc45c7c0028ca1e8e.png&quot;,&quot;isPremium&quot;:true,&quot;isOrgIcon&quot;:false,&quot;size&quot;:{&quot;x&quot;:50,&quot;y&quot;:222.80701754385964}},&quot;source&quot;:{&quot;id&quot;:&quot;5e56940cc45c7c0028ca1e8e&quot;,&quot;version&quot;:&quot;20200226201646&quot;,&quot;type&quot;:&quot;ASSETS&quot;},&quot;isPremium&quot;:true,&quot;parent&quot;:{&quot;type&quot;:&quot;CHILD&quot;,&quot;parentId&quot;:&quot;82468011-4845-45d2-ae7e-533a19310ec4&quot;,&quot;order&quot;:&quot;8&quot;}},&quot;82468011-4845-45d2-ae7e-533a19310ec4&quot;:{&quot;id&quot;:&quot;82468011-4845-45d2-ae7e-533a19310ec4&quot;,&quot;type&quot;:&quot;FIGURE_OBJECT&quot;,&quot;document&quot;:{&quot;type&quot;:&quot;FIGURE&quot;,&quot;canvasType&quot;:&quot;FIGURE&quot;,&quot;units&quot;:&quot;in&quot;},&quot;parent&quot;:{&quot;parentId&quot;:&quot;37e2aa28-cd10-4bfd-92df-0a3c31376c99&quot;,&quot;type&quot;:&quot;DOCUMENT&quot;,&quot;order&quot;:&quot;5&quot;}},&quot;37e2aa28-cd10-4bfd-92df-0a3c31376c99&quot;:{&quot;id&quot;:&quot;37e2aa28-cd10-4bfd-92df-0a3c31376c99&quot;,&quot;type&quot;:&quot;FIGURE_OBJECT&quot;,&quot;document&quot;:{&quot;type&quot;:&quot;DOCUMENT_GROUP&quot;,&quot;canvasType&quot;:&quot;FIGURE&quot;,&quot;units&quot;:&quot;in&quot;}}}}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9695d10ed4b5880ee2c709d"/>
  <p:tag name="FIGURESLIDEID" val="82468011-4845-45d2-ae7e-533a19310ec4"/>
  <p:tag name="SELECTIONIDS" val="0b37dd97-e04e-4356-aa32-b239824caa69"/>
  <p:tag name="TRANSPARENTBACKGROUND" val="true"/>
  <p:tag name="VERSION" val="1770643664268"/>
  <p:tag name="TITLE" val="Broth Dilution"/>
  <p:tag name="CREATORNAME" val="Woubit Abebe"/>
  <p:tag name="DATEINSERTED" val="1770643663814"/>
  <p:tag name="DPI" val="300"/>
  <p:tag name="BIOJSON" val="{&quot;id&quot;:&quot;37e2aa28-cd10-4bfd-92df-0a3c31376c99&quot;,&quot;objects&quot;:{&quot;0b37dd97-e04e-4356-aa32-b239824caa69&quot;:{&quot;id&quot;:&quot;0b37dd97-e04e-4356-aa32-b239824caa69&quot;,&quot;name&quot;:&quot;Test tube (15 mL, 1/2 liquid)&quot;,&quot;displayName&quot;:&quot;&quot;,&quot;type&quot;:&quot;FIGURE_OBJECT&quot;,&quot;relativeTransform&quot;:{&quot;translate&quot;:{&quot;x&quot;:-260.73758155074046,&quot;y&quot;:-5.116172516627941},&quot;rotate&quot;:0,&quot;skewX&quot;:0,&quot;scale&quot;:{&quot;x&quot;:0.7117130970948358,&quot;y&quot;:0.7117130970948358}},&quot;image&quot;:{&quot;url&quot;:&quot;https://icons.cdn.biorender.com/biorender/5e56940cc45c7c0028ca1e8e/20200226201646/image/5e56940cc45c7c0028ca1e8e.png&quot;,&quot;isPremium&quot;:true,&quot;isOrgIcon&quot;:false,&quot;size&quot;:{&quot;x&quot;:50,&quot;y&quot;:222.80701754385964}},&quot;source&quot;:{&quot;id&quot;:&quot;5e56940cc45c7c0028ca1e8e&quot;,&quot;version&quot;:&quot;20200226201646&quot;,&quot;type&quot;:&quot;ASSETS&quot;},&quot;isPremium&quot;:true,&quot;parent&quot;:{&quot;type&quot;:&quot;CHILD&quot;,&quot;parentId&quot;:&quot;82468011-4845-45d2-ae7e-533a19310ec4&quot;,&quot;order&quot;:&quot;9&quot;}},&quot;82468011-4845-45d2-ae7e-533a19310ec4&quot;:{&quot;id&quot;:&quot;82468011-4845-45d2-ae7e-533a19310ec4&quot;,&quot;type&quot;:&quot;FIGURE_OBJECT&quot;,&quot;document&quot;:{&quot;type&quot;:&quot;FIGURE&quot;,&quot;canvasType&quot;:&quot;FIGURE&quot;,&quot;units&quot;:&quot;in&quot;},&quot;parent&quot;:{&quot;parentId&quot;:&quot;37e2aa28-cd10-4bfd-92df-0a3c31376c99&quot;,&quot;type&quot;:&quot;DOCUMENT&quot;,&quot;order&quot;:&quot;5&quot;}},&quot;37e2aa28-cd10-4bfd-92df-0a3c31376c99&quot;:{&quot;id&quot;:&quot;37e2aa28-cd10-4bfd-92df-0a3c31376c99&quot;,&quot;type&quot;:&quot;FIGURE_OBJECT&quot;,&quot;document&quot;:{&quot;type&quot;:&quot;DOCUMENT_GROUP&quot;,&quot;canvasType&quot;:&quot;FIGURE&quot;,&quot;units&quot;:&quot;in&quot;}}}}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9695d10ed4b5880ee2c709d"/>
  <p:tag name="FIGURESLIDEID" val="82468011-4845-45d2-ae7e-533a19310ec4"/>
  <p:tag name="SELECTIONIDS" val="67b17e74-ab3d-4e8b-a984-fd36db41f6f8"/>
  <p:tag name="TRANSPARENTBACKGROUND" val="true"/>
  <p:tag name="VERSION" val="1770643664268"/>
  <p:tag name="TITLE" val="Broth Dilution"/>
  <p:tag name="CREATORNAME" val="Woubit Abebe"/>
  <p:tag name="DATEINSERTED" val="1770643663814"/>
  <p:tag name="DPI" val="300"/>
  <p:tag name="BIOJSON" val="{&quot;id&quot;:&quot;37e2aa28-cd10-4bfd-92df-0a3c31376c99&quot;,&quot;objects&quot;:{&quot;67b17e74-ab3d-4e8b-a984-fd36db41f6f8&quot;:{&quot;id&quot;:&quot;67b17e74-ab3d-4e8b-a984-fd36db41f6f8&quot;,&quot;name&quot;:&quot;Test tube (15 mL, 1/2 liquid)&quot;,&quot;displayName&quot;:&quot;&quot;,&quot;type&quot;:&quot;FIGURE_OBJECT&quot;,&quot;relativeTransform&quot;:{&quot;translate&quot;:{&quot;x&quot;:-202.97272241602622,&quot;y&quot;:-5.116172516627941},&quot;rotate&quot;:0,&quot;skewX&quot;:0,&quot;scale&quot;:{&quot;x&quot;:0.7117130970948358,&quot;y&quot;:0.7117130970948358}},&quot;image&quot;:{&quot;url&quot;:&quot;https://icons.cdn.biorender.com/biorender/5e56940cc45c7c0028ca1e8e/20200226201646/image/5e56940cc45c7c0028ca1e8e.png&quot;,&quot;isPremium&quot;:true,&quot;isOrgIcon&quot;:false,&quot;size&quot;:{&quot;x&quot;:50,&quot;y&quot;:222.80701754385964}},&quot;source&quot;:{&quot;id&quot;:&quot;5e56940cc45c7c0028ca1e8e&quot;,&quot;version&quot;:&quot;20200226201646&quot;,&quot;type&quot;:&quot;ASSETS&quot;},&quot;isPremium&quot;:true,&quot;parent&quot;:{&quot;type&quot;:&quot;CHILD&quot;,&quot;parentId&quot;:&quot;82468011-4845-45d2-ae7e-533a19310ec4&quot;,&quot;order&quot;:&quot;95&quot;}},&quot;82468011-4845-45d2-ae7e-533a19310ec4&quot;:{&quot;id&quot;:&quot;82468011-4845-45d2-ae7e-533a19310ec4&quot;,&quot;type&quot;:&quot;FIGURE_OBJECT&quot;,&quot;document&quot;:{&quot;type&quot;:&quot;FIGURE&quot;,&quot;canvasType&quot;:&quot;FIGURE&quot;,&quot;units&quot;:&quot;in&quot;},&quot;parent&quot;:{&quot;parentId&quot;:&quot;37e2aa28-cd10-4bfd-92df-0a3c31376c99&quot;,&quot;type&quot;:&quot;DOCUMENT&quot;,&quot;order&quot;:&quot;5&quot;}},&quot;37e2aa28-cd10-4bfd-92df-0a3c31376c99&quot;:{&quot;id&quot;:&quot;37e2aa28-cd10-4bfd-92df-0a3c31376c99&quot;,&quot;type&quot;:&quot;FIGURE_OBJECT&quot;,&quot;document&quot;:{&quot;type&quot;:&quot;DOCUMENT_GROUP&quot;,&quot;canvasType&quot;:&quot;FIGURE&quot;,&quot;units&quot;:&quot;in&quot;}}}}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9695d10ed4b5880ee2c709d"/>
  <p:tag name="FIGURESLIDEID" val="82468011-4845-45d2-ae7e-533a19310ec4"/>
  <p:tag name="SELECTIONIDS" val="39852c83-a520-4f03-9f46-4023d9eec63d"/>
  <p:tag name="TRANSPARENTBACKGROUND" val="true"/>
  <p:tag name="VERSION" val="1770643664268"/>
  <p:tag name="TITLE" val="Broth Dilution"/>
  <p:tag name="CREATORNAME" val="Woubit Abebe"/>
  <p:tag name="DATEINSERTED" val="1770643663814"/>
  <p:tag name="DPI" val="300"/>
  <p:tag name="BIOJSON" val="{&quot;id&quot;:&quot;37e2aa28-cd10-4bfd-92df-0a3c31376c99&quot;,&quot;objects&quot;:{&quot;39852c83-a520-4f03-9f46-4023d9eec63d&quot;:{&quot;id&quot;:&quot;39852c83-a520-4f03-9f46-4023d9eec63d&quot;,&quot;name&quot;:&quot;Test tube (15 mL, 1/2 liquid)&quot;,&quot;displayName&quot;:&quot;&quot;,&quot;type&quot;:&quot;FIGURE_OBJECT&quot;,&quot;relativeTransform&quot;:{&quot;translate&quot;:{&quot;x&quot;:-145.20786328131192,&quot;y&quot;:-5.116172516627941},&quot;rotate&quot;:0,&quot;skewX&quot;:0,&quot;scale&quot;:{&quot;x&quot;:0.7117130970948358,&quot;y&quot;:0.7117130970948358}},&quot;image&quot;:{&quot;url&quot;:&quot;https://icons.cdn.biorender.com/biorender/5e56940cc45c7c0028ca1e8e/20200226201646/image/5e56940cc45c7c0028ca1e8e.png&quot;,&quot;isPremium&quot;:true,&quot;isOrgIcon&quot;:false,&quot;size&quot;:{&quot;x&quot;:50,&quot;y&quot;:222.80701754385964}},&quot;source&quot;:{&quot;id&quot;:&quot;5e56940cc45c7c0028ca1e8e&quot;,&quot;version&quot;:&quot;20200226201646&quot;,&quot;type&quot;:&quot;ASSETS&quot;},&quot;isPremium&quot;:true,&quot;parent&quot;:{&quot;type&quot;:&quot;CHILD&quot;,&quot;parentId&quot;:&quot;82468011-4845-45d2-ae7e-533a19310ec4&quot;,&quot;order&quot;:&quot;97&quot;}},&quot;82468011-4845-45d2-ae7e-533a19310ec4&quot;:{&quot;id&quot;:&quot;82468011-4845-45d2-ae7e-533a19310ec4&quot;,&quot;type&quot;:&quot;FIGURE_OBJECT&quot;,&quot;document&quot;:{&quot;type&quot;:&quot;FIGURE&quot;,&quot;canvasType&quot;:&quot;FIGURE&quot;,&quot;units&quot;:&quot;in&quot;},&quot;parent&quot;:{&quot;parentId&quot;:&quot;37e2aa28-cd10-4bfd-92df-0a3c31376c99&quot;,&quot;type&quot;:&quot;DOCUMENT&quot;,&quot;order&quot;:&quot;5&quot;}},&quot;37e2aa28-cd10-4bfd-92df-0a3c31376c99&quot;:{&quot;id&quot;:&quot;37e2aa28-cd10-4bfd-92df-0a3c31376c99&quot;,&quot;type&quot;:&quot;FIGURE_OBJECT&quot;,&quot;document&quot;:{&quot;type&quot;:&quot;DOCUMENT_GROUP&quot;,&quot;canvasType&quot;:&quot;FIGURE&quot;,&quot;units&quot;:&quot;in&quot;}}}}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9695d10ed4b5880ee2c709d"/>
  <p:tag name="FIGURESLIDEID" val="82468011-4845-45d2-ae7e-533a19310ec4"/>
  <p:tag name="SELECTIONIDS" val="095d73bd-c1af-47a2-998d-d0076639d65e"/>
  <p:tag name="TRANSPARENTBACKGROUND" val="true"/>
  <p:tag name="VERSION" val="1770643664268"/>
  <p:tag name="TITLE" val="Broth Dilution"/>
  <p:tag name="CREATORNAME" val="Woubit Abebe"/>
  <p:tag name="DATEINSERTED" val="1770643663814"/>
  <p:tag name="DPI" val="300"/>
  <p:tag name="BIOJSON" val="{&quot;id&quot;:&quot;37e2aa28-cd10-4bfd-92df-0a3c31376c99&quot;,&quot;objects&quot;:{&quot;095d73bd-c1af-47a2-998d-d0076639d65e&quot;:{&quot;id&quot;:&quot;095d73bd-c1af-47a2-998d-d0076639d65e&quot;,&quot;name&quot;:&quot;Test tube (15 mL, 1/2 liquid)&quot;,&quot;displayName&quot;:&quot;&quot;,&quot;type&quot;:&quot;FIGURE_OBJECT&quot;,&quot;relativeTransform&quot;:{&quot;translate&quot;:{&quot;x&quot;:-87.44300414659763,&quot;y&quot;:-5.116172516627941},&quot;rotate&quot;:0,&quot;skewX&quot;:0,&quot;scale&quot;:{&quot;x&quot;:0.7117130970948358,&quot;y&quot;:0.7117130970948358}},&quot;image&quot;:{&quot;url&quot;:&quot;https://icons.cdn.biorender.com/biorender/5e56940cc45c7c0028ca1e8e/20200226201646/image/5e56940cc45c7c0028ca1e8e.png&quot;,&quot;isPremium&quot;:true,&quot;isOrgIcon&quot;:false,&quot;size&quot;:{&quot;x&quot;:50,&quot;y&quot;:222.80701754385964}},&quot;source&quot;:{&quot;id&quot;:&quot;5e56940cc45c7c0028ca1e8e&quot;,&quot;version&quot;:&quot;20200226201646&quot;,&quot;type&quot;:&quot;ASSETS&quot;},&quot;isPremium&quot;:true,&quot;parent&quot;:{&quot;type&quot;:&quot;CHILD&quot;,&quot;parentId&quot;:&quot;82468011-4845-45d2-ae7e-533a19310ec4&quot;,&quot;order&quot;:&quot;98&quot;}},&quot;82468011-4845-45d2-ae7e-533a19310ec4&quot;:{&quot;id&quot;:&quot;82468011-4845-45d2-ae7e-533a19310ec4&quot;,&quot;type&quot;:&quot;FIGURE_OBJECT&quot;,&quot;document&quot;:{&quot;type&quot;:&quot;FIGURE&quot;,&quot;canvasType&quot;:&quot;FIGURE&quot;,&quot;units&quot;:&quot;in&quot;},&quot;parent&quot;:{&quot;parentId&quot;:&quot;37e2aa28-cd10-4bfd-92df-0a3c31376c99&quot;,&quot;type&quot;:&quot;DOCUMENT&quot;,&quot;order&quot;:&quot;5&quot;}},&quot;37e2aa28-cd10-4bfd-92df-0a3c31376c99&quot;:{&quot;id&quot;:&quot;37e2aa28-cd10-4bfd-92df-0a3c31376c99&quot;,&quot;type&quot;:&quot;FIGURE_OBJECT&quot;,&quot;document&quot;:{&quot;type&quot;:&quot;DOCUMENT_GROUP&quot;,&quot;canvasType&quot;:&quot;FIGURE&quot;,&quot;units&quot;:&quot;in&quot;}}}}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ID" val="69695d10ed4b5880ee2c709d"/>
  <p:tag name="FIGURESLIDEID" val="82468011-4845-45d2-ae7e-533a19310ec4"/>
  <p:tag name="SELECTIONIDS" val="ee0e74b2-7555-4a69-8667-0159acef5664"/>
  <p:tag name="TRANSPARENTBACKGROUND" val="true"/>
  <p:tag name="VERSION" val="1770643664268"/>
  <p:tag name="TITLE" val="Broth Dilution"/>
  <p:tag name="CREATORNAME" val="Woubit Abebe"/>
  <p:tag name="DATEINSERTED" val="1770643663814"/>
  <p:tag name="DPI" val="300"/>
  <p:tag name="BIOJSON" val="{&quot;id&quot;:&quot;37e2aa28-cd10-4bfd-92df-0a3c31376c99&quot;,&quot;objects&quot;:{&quot;ee0e74b2-7555-4a69-8667-0159acef5664&quot;:{&quot;id&quot;:&quot;ee0e74b2-7555-4a69-8667-0159acef5664&quot;,&quot;name&quot;:&quot;Test tube (15 mL, 1/2 liquid)&quot;,&quot;displayName&quot;:&quot;&quot;,&quot;type&quot;:&quot;FIGURE_OBJECT&quot;,&quot;relativeTransform&quot;:{&quot;translate&quot;:{&quot;x&quot;:-29.6781450118834,&quot;y&quot;:-5.116172516627941},&quot;rotate&quot;:0,&quot;skewX&quot;:0,&quot;scale&quot;:{&quot;x&quot;:0.7117130970948358,&quot;y&quot;:0.7117130970948358}},&quot;image&quot;:{&quot;url&quot;:&quot;https://icons.cdn.biorender.com/biorender/5e56940cc45c7c0028ca1e8e/20200226201646/image/5e56940cc45c7c0028ca1e8e.png&quot;,&quot;isPremium&quot;:true,&quot;isOrgIcon&quot;:false,&quot;size&quot;:{&quot;x&quot;:50,&quot;y&quot;:222.80701754385964}},&quot;source&quot;:{&quot;id&quot;:&quot;5e56940cc45c7c0028ca1e8e&quot;,&quot;version&quot;:&quot;20200226201646&quot;,&quot;type&quot;:&quot;ASSETS&quot;},&quot;isPremium&quot;:true,&quot;parent&quot;:{&quot;type&quot;:&quot;CHILD&quot;,&quot;parentId&quot;:&quot;82468011-4845-45d2-ae7e-533a19310ec4&quot;,&quot;order&quot;:&quot;99&quot;}},&quot;82468011-4845-45d2-ae7e-533a19310ec4&quot;:{&quot;id&quot;:&quot;82468011-4845-45d2-ae7e-533a19310ec4&quot;,&quot;type&quot;:&quot;FIGURE_OBJECT&quot;,&quot;document&quot;:{&quot;type&quot;:&quot;FIGURE&quot;,&quot;canvasType&quot;:&quot;FIGURE&quot;,&quot;units&quot;:&quot;in&quot;},&quot;parent&quot;:{&quot;parentId&quot;:&quot;37e2aa28-cd10-4bfd-92df-0a3c31376c99&quot;,&quot;type&quot;:&quot;DOCUMENT&quot;,&quot;order&quot;:&quot;5&quot;}},&quot;37e2aa28-cd10-4bfd-92df-0a3c31376c99&quot;:{&quot;id&quot;:&quot;37e2aa28-cd10-4bfd-92df-0a3c31376c99&quot;,&quot;type&quot;:&quot;FIGURE_OBJECT&quot;,&quot;document&quot;:{&quot;type&quot;:&quot;DOCUMENT_GROUP&quot;,&quot;canvasType&quot;:&quot;FIGURE&quot;,&quot;units&quot;:&quot;in&quot;}}}}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7</TotalTime>
  <Words>71</Words>
  <Application>Microsoft Office PowerPoint</Application>
  <PresentationFormat>Custom</PresentationFormat>
  <Paragraphs>2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Roboto</vt:lpstr>
      <vt:lpstr>Office Theme</vt:lpstr>
      <vt:lpstr>PowerPoint Presentation</vt:lpstr>
    </vt:vector>
  </TitlesOfParts>
  <Company>PptxGenJ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ptxGenJS Presentation</dc:title>
  <dc:subject>PptxGenJS Presentation</dc:subject>
  <dc:creator>PptxGenJS</dc:creator>
  <cp:lastModifiedBy>Kingsley Bentum</cp:lastModifiedBy>
  <cp:revision>2</cp:revision>
  <dcterms:created xsi:type="dcterms:W3CDTF">2026-02-09T13:27:44Z</dcterms:created>
  <dcterms:modified xsi:type="dcterms:W3CDTF">2026-02-10T03:44:04Z</dcterms:modified>
</cp:coreProperties>
</file>